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9" r:id="rId2"/>
  </p:sldIdLst>
  <p:sldSz cx="9144000" cy="6858000" type="screen4x3"/>
  <p:notesSz cx="6858000" cy="9144000"/>
  <p:defaultTextStyle>
    <a:defPPr>
      <a:defRPr lang="ja-JP"/>
    </a:defPPr>
    <a:lvl1pPr marL="0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48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295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443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592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739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2887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034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182" algn="l" defTabSz="914295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822" autoAdjust="0"/>
    <p:restoredTop sz="95244" autoAdjust="0"/>
  </p:normalViewPr>
  <p:slideViewPr>
    <p:cSldViewPr>
      <p:cViewPr varScale="1">
        <p:scale>
          <a:sx n="114" d="100"/>
          <a:sy n="114" d="100"/>
        </p:scale>
        <p:origin x="1860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yato kawachi" userId="3d62671f137ab6e0" providerId="LiveId" clId="{D849859E-B8E4-4363-B2F2-456ADF6D35E3}"/>
    <pc:docChg chg="delSld modSld">
      <pc:chgData name="hayato kawachi" userId="3d62671f137ab6e0" providerId="LiveId" clId="{D849859E-B8E4-4363-B2F2-456ADF6D35E3}" dt="2022-01-06T09:24:35.704" v="21" actId="47"/>
      <pc:docMkLst>
        <pc:docMk/>
      </pc:docMkLst>
      <pc:sldChg chg="modSp mod">
        <pc:chgData name="hayato kawachi" userId="3d62671f137ab6e0" providerId="LiveId" clId="{D849859E-B8E4-4363-B2F2-456ADF6D35E3}" dt="2022-01-06T09:24:08.819" v="16" actId="20577"/>
        <pc:sldMkLst>
          <pc:docMk/>
          <pc:sldMk cId="1507186253" sldId="315"/>
        </pc:sldMkLst>
        <pc:spChg chg="mod">
          <ac:chgData name="hayato kawachi" userId="3d62671f137ab6e0" providerId="LiveId" clId="{D849859E-B8E4-4363-B2F2-456ADF6D35E3}" dt="2022-01-06T09:24:08.819" v="16" actId="20577"/>
          <ac:spMkLst>
            <pc:docMk/>
            <pc:sldMk cId="1507186253" sldId="315"/>
            <ac:spMk id="2" creationId="{00000000-0000-0000-0000-000000000000}"/>
          </ac:spMkLst>
        </pc:spChg>
      </pc:sldChg>
      <pc:sldChg chg="modSp mod">
        <pc:chgData name="hayato kawachi" userId="3d62671f137ab6e0" providerId="LiveId" clId="{D849859E-B8E4-4363-B2F2-456ADF6D35E3}" dt="2022-01-06T09:24:12.009" v="18" actId="20577"/>
        <pc:sldMkLst>
          <pc:docMk/>
          <pc:sldMk cId="3840021381" sldId="317"/>
        </pc:sldMkLst>
        <pc:spChg chg="mod">
          <ac:chgData name="hayato kawachi" userId="3d62671f137ab6e0" providerId="LiveId" clId="{D849859E-B8E4-4363-B2F2-456ADF6D35E3}" dt="2022-01-06T09:24:12.009" v="18" actId="20577"/>
          <ac:spMkLst>
            <pc:docMk/>
            <pc:sldMk cId="3840021381" sldId="317"/>
            <ac:spMk id="2" creationId="{00000000-0000-0000-0000-000000000000}"/>
          </ac:spMkLst>
        </pc:spChg>
      </pc:sldChg>
      <pc:sldChg chg="del">
        <pc:chgData name="hayato kawachi" userId="3d62671f137ab6e0" providerId="LiveId" clId="{D849859E-B8E4-4363-B2F2-456ADF6D35E3}" dt="2022-01-06T09:24:35.704" v="21" actId="47"/>
        <pc:sldMkLst>
          <pc:docMk/>
          <pc:sldMk cId="163190479" sldId="318"/>
        </pc:sldMkLst>
      </pc:sldChg>
      <pc:sldChg chg="del">
        <pc:chgData name="hayato kawachi" userId="3d62671f137ab6e0" providerId="LiveId" clId="{D849859E-B8E4-4363-B2F2-456ADF6D35E3}" dt="2022-01-06T09:24:34.902" v="20" actId="47"/>
        <pc:sldMkLst>
          <pc:docMk/>
          <pc:sldMk cId="1418843655" sldId="328"/>
        </pc:sldMkLst>
      </pc:sldChg>
      <pc:sldChg chg="del">
        <pc:chgData name="hayato kawachi" userId="3d62671f137ab6e0" providerId="LiveId" clId="{D849859E-B8E4-4363-B2F2-456ADF6D35E3}" dt="2022-01-06T09:23:53.564" v="12" actId="47"/>
        <pc:sldMkLst>
          <pc:docMk/>
          <pc:sldMk cId="2478891739" sldId="329"/>
        </pc:sldMkLst>
      </pc:sldChg>
      <pc:sldChg chg="del">
        <pc:chgData name="hayato kawachi" userId="3d62671f137ab6e0" providerId="LiveId" clId="{D849859E-B8E4-4363-B2F2-456ADF6D35E3}" dt="2022-01-06T09:23:18.534" v="0" actId="47"/>
        <pc:sldMkLst>
          <pc:docMk/>
          <pc:sldMk cId="1423261008" sldId="330"/>
        </pc:sldMkLst>
      </pc:sldChg>
      <pc:sldChg chg="del">
        <pc:chgData name="hayato kawachi" userId="3d62671f137ab6e0" providerId="LiveId" clId="{D849859E-B8E4-4363-B2F2-456ADF6D35E3}" dt="2022-01-06T09:23:32.705" v="3" actId="47"/>
        <pc:sldMkLst>
          <pc:docMk/>
          <pc:sldMk cId="607319722" sldId="331"/>
        </pc:sldMkLst>
      </pc:sldChg>
      <pc:sldChg chg="del">
        <pc:chgData name="hayato kawachi" userId="3d62671f137ab6e0" providerId="LiveId" clId="{D849859E-B8E4-4363-B2F2-456ADF6D35E3}" dt="2022-01-06T09:23:39.467" v="6" actId="47"/>
        <pc:sldMkLst>
          <pc:docMk/>
          <pc:sldMk cId="1699429612" sldId="332"/>
        </pc:sldMkLst>
      </pc:sldChg>
      <pc:sldChg chg="del">
        <pc:chgData name="hayato kawachi" userId="3d62671f137ab6e0" providerId="LiveId" clId="{D849859E-B8E4-4363-B2F2-456ADF6D35E3}" dt="2022-01-06T09:23:52.024" v="11" actId="47"/>
        <pc:sldMkLst>
          <pc:docMk/>
          <pc:sldMk cId="560247447" sldId="333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701393163" sldId="334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1275856381" sldId="336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345601559" sldId="337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1034753792" sldId="338"/>
        </pc:sldMkLst>
      </pc:sldChg>
      <pc:sldChg chg="del">
        <pc:chgData name="hayato kawachi" userId="3d62671f137ab6e0" providerId="LiveId" clId="{D849859E-B8E4-4363-B2F2-456ADF6D35E3}" dt="2022-01-06T09:23:29.311" v="2" actId="47"/>
        <pc:sldMkLst>
          <pc:docMk/>
          <pc:sldMk cId="4133687114" sldId="339"/>
        </pc:sldMkLst>
      </pc:sldChg>
      <pc:sldChg chg="del">
        <pc:chgData name="hayato kawachi" userId="3d62671f137ab6e0" providerId="LiveId" clId="{D849859E-B8E4-4363-B2F2-456ADF6D35E3}" dt="2022-01-06T09:23:25.720" v="1" actId="47"/>
        <pc:sldMkLst>
          <pc:docMk/>
          <pc:sldMk cId="3607678172" sldId="340"/>
        </pc:sldMkLst>
      </pc:sldChg>
      <pc:sldChg chg="del">
        <pc:chgData name="hayato kawachi" userId="3d62671f137ab6e0" providerId="LiveId" clId="{D849859E-B8E4-4363-B2F2-456ADF6D35E3}" dt="2022-01-06T09:23:45.647" v="9" actId="47"/>
        <pc:sldMkLst>
          <pc:docMk/>
          <pc:sldMk cId="2250381105" sldId="341"/>
        </pc:sldMkLst>
      </pc:sldChg>
      <pc:sldChg chg="del">
        <pc:chgData name="hayato kawachi" userId="3d62671f137ab6e0" providerId="LiveId" clId="{D849859E-B8E4-4363-B2F2-456ADF6D35E3}" dt="2022-01-06T09:23:46.348" v="10" actId="47"/>
        <pc:sldMkLst>
          <pc:docMk/>
          <pc:sldMk cId="3299340242" sldId="342"/>
        </pc:sldMkLst>
      </pc:sldChg>
      <pc:sldChg chg="del">
        <pc:chgData name="hayato kawachi" userId="3d62671f137ab6e0" providerId="LiveId" clId="{D849859E-B8E4-4363-B2F2-456ADF6D35E3}" dt="2022-01-06T09:23:59.866" v="14" actId="47"/>
        <pc:sldMkLst>
          <pc:docMk/>
          <pc:sldMk cId="443460557" sldId="343"/>
        </pc:sldMkLst>
      </pc:sldChg>
      <pc:sldChg chg="del">
        <pc:chgData name="hayato kawachi" userId="3d62671f137ab6e0" providerId="LiveId" clId="{D849859E-B8E4-4363-B2F2-456ADF6D35E3}" dt="2022-01-06T09:23:35.891" v="4" actId="47"/>
        <pc:sldMkLst>
          <pc:docMk/>
          <pc:sldMk cId="3856532166" sldId="344"/>
        </pc:sldMkLst>
      </pc:sldChg>
      <pc:sldChg chg="del">
        <pc:chgData name="hayato kawachi" userId="3d62671f137ab6e0" providerId="LiveId" clId="{D849859E-B8E4-4363-B2F2-456ADF6D35E3}" dt="2022-01-06T09:23:36.545" v="5" actId="47"/>
        <pc:sldMkLst>
          <pc:docMk/>
          <pc:sldMk cId="1102546100" sldId="345"/>
        </pc:sldMkLst>
      </pc:sldChg>
      <pc:sldChg chg="del">
        <pc:chgData name="hayato kawachi" userId="3d62671f137ab6e0" providerId="LiveId" clId="{D849859E-B8E4-4363-B2F2-456ADF6D35E3}" dt="2022-01-06T09:23:40.739" v="7" actId="47"/>
        <pc:sldMkLst>
          <pc:docMk/>
          <pc:sldMk cId="2593710206" sldId="346"/>
        </pc:sldMkLst>
      </pc:sldChg>
      <pc:sldChg chg="del">
        <pc:chgData name="hayato kawachi" userId="3d62671f137ab6e0" providerId="LiveId" clId="{D849859E-B8E4-4363-B2F2-456ADF6D35E3}" dt="2022-01-06T09:23:42.689" v="8" actId="47"/>
        <pc:sldMkLst>
          <pc:docMk/>
          <pc:sldMk cId="2662816316" sldId="349"/>
        </pc:sldMkLst>
      </pc:sldChg>
      <pc:sldChg chg="del">
        <pc:chgData name="hayato kawachi" userId="3d62671f137ab6e0" providerId="LiveId" clId="{D849859E-B8E4-4363-B2F2-456ADF6D35E3}" dt="2022-01-06T09:23:58.141" v="13" actId="47"/>
        <pc:sldMkLst>
          <pc:docMk/>
          <pc:sldMk cId="2156233869" sldId="350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172265969" sldId="351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1499476744" sldId="352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1026820759" sldId="353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1332074407" sldId="354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2896192238" sldId="355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210894258" sldId="356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3831984843" sldId="357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25205361" sldId="358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389173886" sldId="359"/>
        </pc:sldMkLst>
      </pc:sldChg>
      <pc:sldChg chg="del">
        <pc:chgData name="hayato kawachi" userId="3d62671f137ab6e0" providerId="LiveId" clId="{D849859E-B8E4-4363-B2F2-456ADF6D35E3}" dt="2022-01-06T09:24:24.457" v="19" actId="47"/>
        <pc:sldMkLst>
          <pc:docMk/>
          <pc:sldMk cId="3929515670" sldId="360"/>
        </pc:sldMkLst>
      </pc:sldChg>
    </pc:docChg>
  </pc:docChgLst>
  <pc:docChgLst>
    <pc:chgData name="hayato kawachi" userId="3d62671f137ab6e0" providerId="LiveId" clId="{07F4A9C5-F05B-43E2-B5BD-8B5AE6756DBE}"/>
    <pc:docChg chg="undo custSel modSld">
      <pc:chgData name="hayato kawachi" userId="3d62671f137ab6e0" providerId="LiveId" clId="{07F4A9C5-F05B-43E2-B5BD-8B5AE6756DBE}" dt="2022-05-30T13:11:05.258" v="82" actId="20577"/>
      <pc:docMkLst>
        <pc:docMk/>
      </pc:docMkLst>
      <pc:sldChg chg="delSp modSp mod">
        <pc:chgData name="hayato kawachi" userId="3d62671f137ab6e0" providerId="LiveId" clId="{07F4A9C5-F05B-43E2-B5BD-8B5AE6756DBE}" dt="2022-05-30T13:11:05.258" v="82" actId="20577"/>
        <pc:sldMkLst>
          <pc:docMk/>
          <pc:sldMk cId="3974256553" sldId="309"/>
        </pc:sldMkLst>
        <pc:spChg chg="mod">
          <ac:chgData name="hayato kawachi" userId="3d62671f137ab6e0" providerId="LiveId" clId="{07F4A9C5-F05B-43E2-B5BD-8B5AE6756DBE}" dt="2022-05-30T13:11:01.255" v="75" actId="20577"/>
          <ac:spMkLst>
            <pc:docMk/>
            <pc:sldMk cId="3974256553" sldId="309"/>
            <ac:spMk id="33" creationId="{29F2463A-75AA-48A3-A5BF-2C3594115A43}"/>
          </ac:spMkLst>
        </pc:spChg>
        <pc:spChg chg="del">
          <ac:chgData name="hayato kawachi" userId="3d62671f137ab6e0" providerId="LiveId" clId="{07F4A9C5-F05B-43E2-B5BD-8B5AE6756DBE}" dt="2022-05-30T11:58:42.352" v="67" actId="478"/>
          <ac:spMkLst>
            <pc:docMk/>
            <pc:sldMk cId="3974256553" sldId="309"/>
            <ac:spMk id="37" creationId="{3ED8FDAB-36D8-45DE-89D0-5DAAD4A3261D}"/>
          </ac:spMkLst>
        </pc:spChg>
        <pc:spChg chg="del">
          <ac:chgData name="hayato kawachi" userId="3d62671f137ab6e0" providerId="LiveId" clId="{07F4A9C5-F05B-43E2-B5BD-8B5AE6756DBE}" dt="2022-05-30T11:58:45.440" v="68" actId="478"/>
          <ac:spMkLst>
            <pc:docMk/>
            <pc:sldMk cId="3974256553" sldId="309"/>
            <ac:spMk id="38" creationId="{3FB751A9-8633-43EC-82C5-807F8581EEFA}"/>
          </ac:spMkLst>
        </pc:spChg>
        <pc:spChg chg="mod">
          <ac:chgData name="hayato kawachi" userId="3d62671f137ab6e0" providerId="LiveId" clId="{07F4A9C5-F05B-43E2-B5BD-8B5AE6756DBE}" dt="2022-05-30T13:11:05.258" v="82" actId="20577"/>
          <ac:spMkLst>
            <pc:docMk/>
            <pc:sldMk cId="3974256553" sldId="309"/>
            <ac:spMk id="53" creationId="{1FB50F88-B6D0-4B32-83D0-D60F6E12E6F7}"/>
          </ac:spMkLst>
        </pc:spChg>
        <pc:grpChg chg="mod">
          <ac:chgData name="hayato kawachi" userId="3d62671f137ab6e0" providerId="LiveId" clId="{07F4A9C5-F05B-43E2-B5BD-8B5AE6756DBE}" dt="2022-05-30T11:58:39.401" v="66" actId="1035"/>
          <ac:grpSpMkLst>
            <pc:docMk/>
            <pc:sldMk cId="3974256553" sldId="309"/>
            <ac:grpSpMk id="32" creationId="{EAF5553A-ED76-47DE-B321-5506EC8AE13B}"/>
          </ac:grpSpMkLst>
        </pc:grpChg>
      </pc:sldChg>
    </pc:docChg>
  </pc:docChgLst>
  <pc:docChgLst>
    <pc:chgData name="hayato kawachi" userId="3d62671f137ab6e0" providerId="LiveId" clId="{9ACEAE6A-6E50-4DAA-894C-41376CB299AA}"/>
    <pc:docChg chg="undo custSel addSld delSld modSld sldOrd">
      <pc:chgData name="hayato kawachi" userId="3d62671f137ab6e0" providerId="LiveId" clId="{9ACEAE6A-6E50-4DAA-894C-41376CB299AA}" dt="2021-10-05T11:53:21.020" v="887" actId="20577"/>
      <pc:docMkLst>
        <pc:docMk/>
      </pc:docMkLst>
      <pc:sldChg chg="addSp delSp modSp mod">
        <pc:chgData name="hayato kawachi" userId="3d62671f137ab6e0" providerId="LiveId" clId="{9ACEAE6A-6E50-4DAA-894C-41376CB299AA}" dt="2021-10-05T08:46:20.948" v="303" actId="20577"/>
        <pc:sldMkLst>
          <pc:docMk/>
          <pc:sldMk cId="3974256553" sldId="309"/>
        </pc:sldMkLst>
        <pc:spChg chg="mod">
          <ac:chgData name="hayato kawachi" userId="3d62671f137ab6e0" providerId="LiveId" clId="{9ACEAE6A-6E50-4DAA-894C-41376CB299AA}" dt="2021-10-05T08:45:11.321" v="294" actId="20577"/>
          <ac:spMkLst>
            <pc:docMk/>
            <pc:sldMk cId="3974256553" sldId="309"/>
            <ac:spMk id="37" creationId="{3ED8FDAB-36D8-45DE-89D0-5DAAD4A3261D}"/>
          </ac:spMkLst>
        </pc:spChg>
        <pc:spChg chg="mod">
          <ac:chgData name="hayato kawachi" userId="3d62671f137ab6e0" providerId="LiveId" clId="{9ACEAE6A-6E50-4DAA-894C-41376CB299AA}" dt="2021-10-05T08:45:33.726" v="298" actId="20577"/>
          <ac:spMkLst>
            <pc:docMk/>
            <pc:sldMk cId="3974256553" sldId="309"/>
            <ac:spMk id="38" creationId="{3FB751A9-8633-43EC-82C5-807F8581EEFA}"/>
          </ac:spMkLst>
        </pc:spChg>
        <pc:spChg chg="mod">
          <ac:chgData name="hayato kawachi" userId="3d62671f137ab6e0" providerId="LiveId" clId="{9ACEAE6A-6E50-4DAA-894C-41376CB299AA}" dt="2021-10-05T05:30:21.074" v="231" actId="20577"/>
          <ac:spMkLst>
            <pc:docMk/>
            <pc:sldMk cId="3974256553" sldId="309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08:46:13.034" v="301" actId="20577"/>
          <ac:spMkLst>
            <pc:docMk/>
            <pc:sldMk cId="3974256553" sldId="309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08:46:20.948" v="303" actId="20577"/>
          <ac:spMkLst>
            <pc:docMk/>
            <pc:sldMk cId="3974256553" sldId="309"/>
            <ac:spMk id="61" creationId="{00000000-0000-0000-0000-000000000000}"/>
          </ac:spMkLst>
        </pc:spChg>
        <pc:picChg chg="add del mod">
          <ac:chgData name="hayato kawachi" userId="3d62671f137ab6e0" providerId="LiveId" clId="{9ACEAE6A-6E50-4DAA-894C-41376CB299AA}" dt="2021-10-05T08:43:23.502" v="266" actId="478"/>
          <ac:picMkLst>
            <pc:docMk/>
            <pc:sldMk cId="3974256553" sldId="309"/>
            <ac:picMk id="40" creationId="{E05CD332-A78B-4A7F-9B36-DA689A353EA3}"/>
          </ac:picMkLst>
        </pc:picChg>
        <pc:picChg chg="add mod ord">
          <ac:chgData name="hayato kawachi" userId="3d62671f137ab6e0" providerId="LiveId" clId="{9ACEAE6A-6E50-4DAA-894C-41376CB299AA}" dt="2021-10-05T08:44:31.280" v="288" actId="1037"/>
          <ac:picMkLst>
            <pc:docMk/>
            <pc:sldMk cId="3974256553" sldId="309"/>
            <ac:picMk id="41" creationId="{1411E4AC-4033-46F2-A6BE-E895E5B70B9C}"/>
          </ac:picMkLst>
        </pc:picChg>
        <pc:picChg chg="del">
          <ac:chgData name="hayato kawachi" userId="3d62671f137ab6e0" providerId="LiveId" clId="{9ACEAE6A-6E50-4DAA-894C-41376CB299AA}" dt="2021-10-05T08:43:58.762" v="270" actId="478"/>
          <ac:picMkLst>
            <pc:docMk/>
            <pc:sldMk cId="3974256553" sldId="309"/>
            <ac:picMk id="44" creationId="{E78D6FC5-27FD-4487-A459-E52B71991236}"/>
          </ac:picMkLst>
        </pc:picChg>
      </pc:sldChg>
      <pc:sldChg chg="addSp delSp modSp mod">
        <pc:chgData name="hayato kawachi" userId="3d62671f137ab6e0" providerId="LiveId" clId="{9ACEAE6A-6E50-4DAA-894C-41376CB299AA}" dt="2021-10-05T11:44:31.803" v="814" actId="478"/>
        <pc:sldMkLst>
          <pc:docMk/>
          <pc:sldMk cId="1780759030" sldId="310"/>
        </pc:sldMkLst>
        <pc:spChg chg="mod">
          <ac:chgData name="hayato kawachi" userId="3d62671f137ab6e0" providerId="LiveId" clId="{9ACEAE6A-6E50-4DAA-894C-41376CB299AA}" dt="2021-10-05T09:38:59.541" v="329" actId="20577"/>
          <ac:spMkLst>
            <pc:docMk/>
            <pc:sldMk cId="1780759030" sldId="310"/>
            <ac:spMk id="37" creationId="{3ED8FDAB-36D8-45DE-89D0-5DAAD4A3261D}"/>
          </ac:spMkLst>
        </pc:spChg>
        <pc:spChg chg="mod">
          <ac:chgData name="hayato kawachi" userId="3d62671f137ab6e0" providerId="LiveId" clId="{9ACEAE6A-6E50-4DAA-894C-41376CB299AA}" dt="2021-10-05T09:39:21.389" v="334" actId="20577"/>
          <ac:spMkLst>
            <pc:docMk/>
            <pc:sldMk cId="1780759030" sldId="310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09:39:56.526" v="338" actId="20577"/>
          <ac:spMkLst>
            <pc:docMk/>
            <pc:sldMk cId="1780759030" sldId="310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09:39:59.432" v="340" actId="20577"/>
          <ac:spMkLst>
            <pc:docMk/>
            <pc:sldMk cId="1780759030" sldId="310"/>
            <ac:spMk id="61" creationId="{00000000-0000-0000-0000-000000000000}"/>
          </ac:spMkLst>
        </pc:spChg>
        <pc:picChg chg="add del mod ord">
          <ac:chgData name="hayato kawachi" userId="3d62671f137ab6e0" providerId="LiveId" clId="{9ACEAE6A-6E50-4DAA-894C-41376CB299AA}" dt="2021-10-05T11:44:27.553" v="810" actId="478"/>
          <ac:picMkLst>
            <pc:docMk/>
            <pc:sldMk cId="1780759030" sldId="310"/>
            <ac:picMk id="40" creationId="{C365DB42-9F74-45AB-8043-7C0064D5CA78}"/>
          </ac:picMkLst>
        </pc:picChg>
        <pc:picChg chg="del">
          <ac:chgData name="hayato kawachi" userId="3d62671f137ab6e0" providerId="LiveId" clId="{9ACEAE6A-6E50-4DAA-894C-41376CB299AA}" dt="2021-10-05T09:37:51.281" v="308" actId="478"/>
          <ac:picMkLst>
            <pc:docMk/>
            <pc:sldMk cId="1780759030" sldId="310"/>
            <ac:picMk id="41" creationId="{BC244221-4133-4E4E-8D91-44830B1282D7}"/>
          </ac:picMkLst>
        </pc:picChg>
        <pc:picChg chg="add del mod ord">
          <ac:chgData name="hayato kawachi" userId="3d62671f137ab6e0" providerId="LiveId" clId="{9ACEAE6A-6E50-4DAA-894C-41376CB299AA}" dt="2021-10-05T11:44:31.803" v="814" actId="478"/>
          <ac:picMkLst>
            <pc:docMk/>
            <pc:sldMk cId="1780759030" sldId="310"/>
            <ac:picMk id="42" creationId="{ADA81EA4-B0B2-4621-ADAF-2975DC9D3CCA}"/>
          </ac:picMkLst>
        </pc:picChg>
      </pc:sldChg>
      <pc:sldChg chg="addSp delSp modSp mod">
        <pc:chgData name="hayato kawachi" userId="3d62671f137ab6e0" providerId="LiveId" clId="{9ACEAE6A-6E50-4DAA-894C-41376CB299AA}" dt="2021-10-05T09:46:55.386" v="370" actId="20577"/>
        <pc:sldMkLst>
          <pc:docMk/>
          <pc:sldMk cId="1571256114" sldId="311"/>
        </pc:sldMkLst>
        <pc:spChg chg="mod">
          <ac:chgData name="hayato kawachi" userId="3d62671f137ab6e0" providerId="LiveId" clId="{9ACEAE6A-6E50-4DAA-894C-41376CB299AA}" dt="2021-10-05T09:41:40.264" v="344" actId="20577"/>
          <ac:spMkLst>
            <pc:docMk/>
            <pc:sldMk cId="1571256114" sldId="311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09:46:44.759" v="366" actId="20577"/>
          <ac:spMkLst>
            <pc:docMk/>
            <pc:sldMk cId="1571256114" sldId="311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09:46:55.386" v="370" actId="20577"/>
          <ac:spMkLst>
            <pc:docMk/>
            <pc:sldMk cId="1571256114" sldId="311"/>
            <ac:spMk id="61" creationId="{00000000-0000-0000-0000-000000000000}"/>
          </ac:spMkLst>
        </pc:spChg>
        <pc:picChg chg="del">
          <ac:chgData name="hayato kawachi" userId="3d62671f137ab6e0" providerId="LiveId" clId="{9ACEAE6A-6E50-4DAA-894C-41376CB299AA}" dt="2021-10-05T09:45:29.313" v="349" actId="478"/>
          <ac:picMkLst>
            <pc:docMk/>
            <pc:sldMk cId="1571256114" sldId="311"/>
            <ac:picMk id="40" creationId="{34F4C851-910D-40C4-93D8-B17C1D987799}"/>
          </ac:picMkLst>
        </pc:picChg>
        <pc:picChg chg="add mod ord">
          <ac:chgData name="hayato kawachi" userId="3d62671f137ab6e0" providerId="LiveId" clId="{9ACEAE6A-6E50-4DAA-894C-41376CB299AA}" dt="2021-10-05T09:45:36.583" v="361" actId="1035"/>
          <ac:picMkLst>
            <pc:docMk/>
            <pc:sldMk cId="1571256114" sldId="311"/>
            <ac:picMk id="41" creationId="{3FFC67E1-CAA9-41DB-AC96-14E9602E4657}"/>
          </ac:picMkLst>
        </pc:picChg>
      </pc:sldChg>
      <pc:sldChg chg="addSp delSp modSp mod">
        <pc:chgData name="hayato kawachi" userId="3d62671f137ab6e0" providerId="LiveId" clId="{9ACEAE6A-6E50-4DAA-894C-41376CB299AA}" dt="2021-10-05T11:40:12.711" v="776" actId="20577"/>
        <pc:sldMkLst>
          <pc:docMk/>
          <pc:sldMk cId="3852358235" sldId="312"/>
        </pc:sldMkLst>
        <pc:spChg chg="mod">
          <ac:chgData name="hayato kawachi" userId="3d62671f137ab6e0" providerId="LiveId" clId="{9ACEAE6A-6E50-4DAA-894C-41376CB299AA}" dt="2021-10-05T11:38:57.100" v="768" actId="20577"/>
          <ac:spMkLst>
            <pc:docMk/>
            <pc:sldMk cId="3852358235" sldId="312"/>
            <ac:spMk id="37" creationId="{3ED8FDAB-36D8-45DE-89D0-5DAAD4A3261D}"/>
          </ac:spMkLst>
        </pc:spChg>
        <pc:spChg chg="mod">
          <ac:chgData name="hayato kawachi" userId="3d62671f137ab6e0" providerId="LiveId" clId="{9ACEAE6A-6E50-4DAA-894C-41376CB299AA}" dt="2021-10-05T11:38:20.900" v="742" actId="1076"/>
          <ac:spMkLst>
            <pc:docMk/>
            <pc:sldMk cId="3852358235" sldId="312"/>
            <ac:spMk id="38" creationId="{3FB751A9-8633-43EC-82C5-807F8581EEFA}"/>
          </ac:spMkLst>
        </pc:spChg>
        <pc:spChg chg="mod">
          <ac:chgData name="hayato kawachi" userId="3d62671f137ab6e0" providerId="LiveId" clId="{9ACEAE6A-6E50-4DAA-894C-41376CB299AA}" dt="2021-10-05T11:38:24.392" v="746" actId="20577"/>
          <ac:spMkLst>
            <pc:docMk/>
            <pc:sldMk cId="3852358235" sldId="312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11:39:53.837" v="772" actId="20577"/>
          <ac:spMkLst>
            <pc:docMk/>
            <pc:sldMk cId="3852358235" sldId="312"/>
            <ac:spMk id="50" creationId="{E10074C8-9A6C-44D2-B375-7758BE6319F6}"/>
          </ac:spMkLst>
        </pc:spChg>
        <pc:spChg chg="mod">
          <ac:chgData name="hayato kawachi" userId="3d62671f137ab6e0" providerId="LiveId" clId="{9ACEAE6A-6E50-4DAA-894C-41376CB299AA}" dt="2021-10-05T11:40:05.806" v="774" actId="20577"/>
          <ac:spMkLst>
            <pc:docMk/>
            <pc:sldMk cId="3852358235" sldId="312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40:12.711" v="776" actId="20577"/>
          <ac:spMkLst>
            <pc:docMk/>
            <pc:sldMk cId="3852358235" sldId="312"/>
            <ac:spMk id="61" creationId="{00000000-0000-0000-0000-000000000000}"/>
          </ac:spMkLst>
        </pc:spChg>
        <pc:picChg chg="del">
          <ac:chgData name="hayato kawachi" userId="3d62671f137ab6e0" providerId="LiveId" clId="{9ACEAE6A-6E50-4DAA-894C-41376CB299AA}" dt="2021-10-05T11:37:37.864" v="707" actId="478"/>
          <ac:picMkLst>
            <pc:docMk/>
            <pc:sldMk cId="3852358235" sldId="312"/>
            <ac:picMk id="40" creationId="{C918FA2B-FA0D-45C0-AF2D-2D44FE08DAAD}"/>
          </ac:picMkLst>
        </pc:picChg>
        <pc:picChg chg="add mod ord">
          <ac:chgData name="hayato kawachi" userId="3d62671f137ab6e0" providerId="LiveId" clId="{9ACEAE6A-6E50-4DAA-894C-41376CB299AA}" dt="2021-10-05T11:38:17.897" v="741" actId="1076"/>
          <ac:picMkLst>
            <pc:docMk/>
            <pc:sldMk cId="3852358235" sldId="312"/>
            <ac:picMk id="41" creationId="{CD9507FB-382C-469D-B157-B6C4F7FF3995}"/>
          </ac:picMkLst>
        </pc:picChg>
      </pc:sldChg>
      <pc:sldChg chg="addSp delSp modSp mod">
        <pc:chgData name="hayato kawachi" userId="3d62671f137ab6e0" providerId="LiveId" clId="{9ACEAE6A-6E50-4DAA-894C-41376CB299AA}" dt="2021-10-05T11:47:12.191" v="860" actId="20577"/>
        <pc:sldMkLst>
          <pc:docMk/>
          <pc:sldMk cId="4047624437" sldId="313"/>
        </pc:sldMkLst>
        <pc:spChg chg="mod">
          <ac:chgData name="hayato kawachi" userId="3d62671f137ab6e0" providerId="LiveId" clId="{9ACEAE6A-6E50-4DAA-894C-41376CB299AA}" dt="2021-10-05T11:47:04.770" v="856" actId="20577"/>
          <ac:spMkLst>
            <pc:docMk/>
            <pc:sldMk cId="4047624437" sldId="313"/>
            <ac:spMk id="35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46:40.320" v="852" actId="20577"/>
          <ac:spMkLst>
            <pc:docMk/>
            <pc:sldMk cId="4047624437" sldId="313"/>
            <ac:spMk id="39" creationId="{1B721CC6-56D4-4BD4-9D1B-18C0972D8A62}"/>
          </ac:spMkLst>
        </pc:spChg>
        <pc:spChg chg="add">
          <ac:chgData name="hayato kawachi" userId="3d62671f137ab6e0" providerId="LiveId" clId="{9ACEAE6A-6E50-4DAA-894C-41376CB299AA}" dt="2021-10-05T11:46:32.565" v="846"/>
          <ac:spMkLst>
            <pc:docMk/>
            <pc:sldMk cId="4047624437" sldId="313"/>
            <ac:spMk id="41" creationId="{DBC2C262-1024-4EF1-8364-5D8BC4E65818}"/>
          </ac:spMkLst>
        </pc:spChg>
        <pc:spChg chg="del mod">
          <ac:chgData name="hayato kawachi" userId="3d62671f137ab6e0" providerId="LiveId" clId="{9ACEAE6A-6E50-4DAA-894C-41376CB299AA}" dt="2021-10-05T11:46:32.358" v="845" actId="478"/>
          <ac:spMkLst>
            <pc:docMk/>
            <pc:sldMk cId="4047624437" sldId="313"/>
            <ac:spMk id="42" creationId="{F75DC5EC-D2F0-4422-8099-5D55FD97A5A5}"/>
          </ac:spMkLst>
        </pc:spChg>
        <pc:spChg chg="mod">
          <ac:chgData name="hayato kawachi" userId="3d62671f137ab6e0" providerId="LiveId" clId="{9ACEAE6A-6E50-4DAA-894C-41376CB299AA}" dt="2021-10-05T11:47:09.646" v="858" actId="20577"/>
          <ac:spMkLst>
            <pc:docMk/>
            <pc:sldMk cId="4047624437" sldId="313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47:12.191" v="860" actId="20577"/>
          <ac:spMkLst>
            <pc:docMk/>
            <pc:sldMk cId="4047624437" sldId="313"/>
            <ac:spMk id="61" creationId="{00000000-0000-0000-0000-000000000000}"/>
          </ac:spMkLst>
        </pc:spChg>
        <pc:picChg chg="add mod ord">
          <ac:chgData name="hayato kawachi" userId="3d62671f137ab6e0" providerId="LiveId" clId="{9ACEAE6A-6E50-4DAA-894C-41376CB299AA}" dt="2021-10-05T11:45:54.771" v="843" actId="1038"/>
          <ac:picMkLst>
            <pc:docMk/>
            <pc:sldMk cId="4047624437" sldId="313"/>
            <ac:picMk id="37" creationId="{6F46AED4-39EC-4487-B9ED-D96F25BDF2A2}"/>
          </ac:picMkLst>
        </pc:picChg>
        <pc:picChg chg="del">
          <ac:chgData name="hayato kawachi" userId="3d62671f137ab6e0" providerId="LiveId" clId="{9ACEAE6A-6E50-4DAA-894C-41376CB299AA}" dt="2021-10-05T11:45:42.235" v="823" actId="478"/>
          <ac:picMkLst>
            <pc:docMk/>
            <pc:sldMk cId="4047624437" sldId="313"/>
            <ac:picMk id="40" creationId="{7D8B4567-C070-4703-A8B4-FF7FC7CC6CCD}"/>
          </ac:picMkLst>
        </pc:picChg>
      </pc:sldChg>
      <pc:sldChg chg="addSp delSp modSp mod">
        <pc:chgData name="hayato kawachi" userId="3d62671f137ab6e0" providerId="LiveId" clId="{9ACEAE6A-6E50-4DAA-894C-41376CB299AA}" dt="2021-10-05T11:53:21.020" v="887" actId="20577"/>
        <pc:sldMkLst>
          <pc:docMk/>
          <pc:sldMk cId="761655977" sldId="314"/>
        </pc:sldMkLst>
        <pc:spChg chg="mod">
          <ac:chgData name="hayato kawachi" userId="3d62671f137ab6e0" providerId="LiveId" clId="{9ACEAE6A-6E50-4DAA-894C-41376CB299AA}" dt="2021-10-05T11:50:42.877" v="862" actId="20577"/>
          <ac:spMkLst>
            <pc:docMk/>
            <pc:sldMk cId="761655977" sldId="314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11:53:13.970" v="885" actId="20577"/>
          <ac:spMkLst>
            <pc:docMk/>
            <pc:sldMk cId="761655977" sldId="314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53:21.020" v="887" actId="20577"/>
          <ac:spMkLst>
            <pc:docMk/>
            <pc:sldMk cId="761655977" sldId="314"/>
            <ac:spMk id="61" creationId="{00000000-0000-0000-0000-000000000000}"/>
          </ac:spMkLst>
        </pc:spChg>
        <pc:picChg chg="add del mod">
          <ac:chgData name="hayato kawachi" userId="3d62671f137ab6e0" providerId="LiveId" clId="{9ACEAE6A-6E50-4DAA-894C-41376CB299AA}" dt="2021-10-05T11:45:30.993" v="821" actId="478"/>
          <ac:picMkLst>
            <pc:docMk/>
            <pc:sldMk cId="761655977" sldId="314"/>
            <ac:picMk id="40" creationId="{581D16D7-29C0-4998-84FF-ED8D9CF4FDED}"/>
          </ac:picMkLst>
        </pc:picChg>
        <pc:picChg chg="del">
          <ac:chgData name="hayato kawachi" userId="3d62671f137ab6e0" providerId="LiveId" clId="{9ACEAE6A-6E50-4DAA-894C-41376CB299AA}" dt="2021-10-05T11:51:13.738" v="868" actId="478"/>
          <ac:picMkLst>
            <pc:docMk/>
            <pc:sldMk cId="761655977" sldId="314"/>
            <ac:picMk id="41" creationId="{29E92C11-B680-48D0-A299-D2EC1E0B38F9}"/>
          </ac:picMkLst>
        </pc:picChg>
        <pc:picChg chg="add mod ord">
          <ac:chgData name="hayato kawachi" userId="3d62671f137ab6e0" providerId="LiveId" clId="{9ACEAE6A-6E50-4DAA-894C-41376CB299AA}" dt="2021-10-05T11:51:36.842" v="883" actId="1038"/>
          <ac:picMkLst>
            <pc:docMk/>
            <pc:sldMk cId="761655977" sldId="314"/>
            <ac:picMk id="46" creationId="{E12E8CEE-BF89-4EFB-A14C-5C84332A76E8}"/>
          </ac:picMkLst>
        </pc:picChg>
      </pc:sldChg>
      <pc:sldChg chg="addSp delSp modSp mod">
        <pc:chgData name="hayato kawachi" userId="3d62671f137ab6e0" providerId="LiveId" clId="{9ACEAE6A-6E50-4DAA-894C-41376CB299AA}" dt="2021-10-05T10:22:20.042" v="431" actId="1076"/>
        <pc:sldMkLst>
          <pc:docMk/>
          <pc:sldMk cId="1507186253" sldId="315"/>
        </pc:sldMkLst>
        <pc:spChg chg="mod">
          <ac:chgData name="hayato kawachi" userId="3d62671f137ab6e0" providerId="LiveId" clId="{9ACEAE6A-6E50-4DAA-894C-41376CB299AA}" dt="2021-10-05T10:22:20.042" v="431" actId="1076"/>
          <ac:spMkLst>
            <pc:docMk/>
            <pc:sldMk cId="1507186253" sldId="315"/>
            <ac:spMk id="18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0:13:05.878" v="405" actId="20577"/>
          <ac:spMkLst>
            <pc:docMk/>
            <pc:sldMk cId="1507186253" sldId="315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10:22:20.042" v="431" actId="1076"/>
          <ac:spMkLst>
            <pc:docMk/>
            <pc:sldMk cId="1507186253" sldId="315"/>
            <ac:spMk id="61" creationId="{00000000-0000-0000-0000-000000000000}"/>
          </ac:spMkLst>
        </pc:spChg>
        <pc:picChg chg="add del mod ord">
          <ac:chgData name="hayato kawachi" userId="3d62671f137ab6e0" providerId="LiveId" clId="{9ACEAE6A-6E50-4DAA-894C-41376CB299AA}" dt="2021-10-05T10:21:18.759" v="410" actId="478"/>
          <ac:picMkLst>
            <pc:docMk/>
            <pc:sldMk cId="1507186253" sldId="315"/>
            <ac:picMk id="40" creationId="{B4615D46-3F9F-46C8-8621-40E1BEA43205}"/>
          </ac:picMkLst>
        </pc:picChg>
        <pc:picChg chg="del">
          <ac:chgData name="hayato kawachi" userId="3d62671f137ab6e0" providerId="LiveId" clId="{9ACEAE6A-6E50-4DAA-894C-41376CB299AA}" dt="2021-10-05T10:02:59.637" v="381" actId="478"/>
          <ac:picMkLst>
            <pc:docMk/>
            <pc:sldMk cId="1507186253" sldId="315"/>
            <ac:picMk id="41" creationId="{7D2D16FF-BE50-4665-80D4-9065F96C0A8D}"/>
          </ac:picMkLst>
        </pc:picChg>
        <pc:picChg chg="add mod ord">
          <ac:chgData name="hayato kawachi" userId="3d62671f137ab6e0" providerId="LiveId" clId="{9ACEAE6A-6E50-4DAA-894C-41376CB299AA}" dt="2021-10-05T10:21:45.922" v="430" actId="1038"/>
          <ac:picMkLst>
            <pc:docMk/>
            <pc:sldMk cId="1507186253" sldId="315"/>
            <ac:picMk id="46" creationId="{4666B752-A8CB-4FEF-86DC-F3629D28C7FB}"/>
          </ac:picMkLst>
        </pc:picChg>
      </pc:sldChg>
      <pc:sldChg chg="addSp delSp modSp add mod ord">
        <pc:chgData name="hayato kawachi" userId="3d62671f137ab6e0" providerId="LiveId" clId="{9ACEAE6A-6E50-4DAA-894C-41376CB299AA}" dt="2021-10-05T11:30:44.126" v="697" actId="207"/>
        <pc:sldMkLst>
          <pc:docMk/>
          <pc:sldMk cId="322658806" sldId="316"/>
        </pc:sldMkLst>
        <pc:spChg chg="mod">
          <ac:chgData name="hayato kawachi" userId="3d62671f137ab6e0" providerId="LiveId" clId="{9ACEAE6A-6E50-4DAA-894C-41376CB299AA}" dt="2021-10-05T11:30:44.126" v="697" actId="207"/>
          <ac:spMkLst>
            <pc:docMk/>
            <pc:sldMk cId="322658806" sldId="316"/>
            <ac:spMk id="2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29:24.439" v="690" actId="20577"/>
          <ac:spMkLst>
            <pc:docMk/>
            <pc:sldMk cId="322658806" sldId="316"/>
            <ac:spMk id="35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30:40.290" v="696" actId="1076"/>
          <ac:spMkLst>
            <pc:docMk/>
            <pc:sldMk cId="322658806" sldId="316"/>
            <ac:spMk id="37" creationId="{3ED8FDAB-36D8-45DE-89D0-5DAAD4A3261D}"/>
          </ac:spMkLst>
        </pc:spChg>
        <pc:spChg chg="mod">
          <ac:chgData name="hayato kawachi" userId="3d62671f137ab6e0" providerId="LiveId" clId="{9ACEAE6A-6E50-4DAA-894C-41376CB299AA}" dt="2021-10-05T11:28:45.723" v="685" actId="20577"/>
          <ac:spMkLst>
            <pc:docMk/>
            <pc:sldMk cId="322658806" sldId="316"/>
            <ac:spMk id="38" creationId="{3FB751A9-8633-43EC-82C5-807F8581EEFA}"/>
          </ac:spMkLst>
        </pc:spChg>
        <pc:spChg chg="mod">
          <ac:chgData name="hayato kawachi" userId="3d62671f137ab6e0" providerId="LiveId" clId="{9ACEAE6A-6E50-4DAA-894C-41376CB299AA}" dt="2021-10-05T11:18:52.693" v="604" actId="20577"/>
          <ac:spMkLst>
            <pc:docMk/>
            <pc:sldMk cId="322658806" sldId="316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11:29:44.160" v="692" actId="20577"/>
          <ac:spMkLst>
            <pc:docMk/>
            <pc:sldMk cId="322658806" sldId="316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1:29:52.897" v="694" actId="20577"/>
          <ac:spMkLst>
            <pc:docMk/>
            <pc:sldMk cId="322658806" sldId="316"/>
            <ac:spMk id="61" creationId="{00000000-0000-0000-0000-000000000000}"/>
          </ac:spMkLst>
        </pc:spChg>
        <pc:grpChg chg="mod">
          <ac:chgData name="hayato kawachi" userId="3d62671f137ab6e0" providerId="LiveId" clId="{9ACEAE6A-6E50-4DAA-894C-41376CB299AA}" dt="2021-10-05T11:24:57.443" v="627" actId="1076"/>
          <ac:grpSpMkLst>
            <pc:docMk/>
            <pc:sldMk cId="322658806" sldId="316"/>
            <ac:grpSpMk id="32" creationId="{EAF5553A-ED76-47DE-B321-5506EC8AE13B}"/>
          </ac:grpSpMkLst>
        </pc:grpChg>
        <pc:picChg chg="mod ord">
          <ac:chgData name="hayato kawachi" userId="3d62671f137ab6e0" providerId="LiveId" clId="{9ACEAE6A-6E50-4DAA-894C-41376CB299AA}" dt="2021-10-05T11:28:03.042" v="667" actId="1037"/>
          <ac:picMkLst>
            <pc:docMk/>
            <pc:sldMk cId="322658806" sldId="316"/>
            <ac:picMk id="4" creationId="{64E1501D-25F3-4A68-968A-A495078EF778}"/>
          </ac:picMkLst>
        </pc:picChg>
        <pc:picChg chg="add del mod ord">
          <ac:chgData name="hayato kawachi" userId="3d62671f137ab6e0" providerId="LiveId" clId="{9ACEAE6A-6E50-4DAA-894C-41376CB299AA}" dt="2021-10-05T11:27:43.316" v="647" actId="478"/>
          <ac:picMkLst>
            <pc:docMk/>
            <pc:sldMk cId="322658806" sldId="316"/>
            <ac:picMk id="40" creationId="{F0E8D19C-ADF7-4674-BBB2-C3122D8D17E4}"/>
          </ac:picMkLst>
        </pc:picChg>
        <pc:picChg chg="del">
          <ac:chgData name="hayato kawachi" userId="3d62671f137ab6e0" providerId="LiveId" clId="{9ACEAE6A-6E50-4DAA-894C-41376CB299AA}" dt="2021-10-05T11:24:36.711" v="610" actId="478"/>
          <ac:picMkLst>
            <pc:docMk/>
            <pc:sldMk cId="322658806" sldId="316"/>
            <ac:picMk id="44" creationId="{E78D6FC5-27FD-4487-A459-E52B71991236}"/>
          </ac:picMkLst>
        </pc:picChg>
      </pc:sldChg>
      <pc:sldChg chg="modSp add del mod">
        <pc:chgData name="hayato kawachi" userId="3d62671f137ab6e0" providerId="LiveId" clId="{9ACEAE6A-6E50-4DAA-894C-41376CB299AA}" dt="2021-10-05T05:25:12.518" v="5" actId="47"/>
        <pc:sldMkLst>
          <pc:docMk/>
          <pc:sldMk cId="2012170540" sldId="316"/>
        </pc:sldMkLst>
        <pc:spChg chg="mod">
          <ac:chgData name="hayato kawachi" userId="3d62671f137ab6e0" providerId="LiveId" clId="{9ACEAE6A-6E50-4DAA-894C-41376CB299AA}" dt="2021-10-05T05:25:05.945" v="4" actId="20577"/>
          <ac:spMkLst>
            <pc:docMk/>
            <pc:sldMk cId="2012170540" sldId="316"/>
            <ac:spMk id="2" creationId="{00000000-0000-0000-0000-000000000000}"/>
          </ac:spMkLst>
        </pc:spChg>
      </pc:sldChg>
      <pc:sldChg chg="addSp delSp modSp add mod ord">
        <pc:chgData name="hayato kawachi" userId="3d62671f137ab6e0" providerId="LiveId" clId="{9ACEAE6A-6E50-4DAA-894C-41376CB299AA}" dt="2021-10-05T11:30:48.263" v="698" actId="207"/>
        <pc:sldMkLst>
          <pc:docMk/>
          <pc:sldMk cId="3840021381" sldId="317"/>
        </pc:sldMkLst>
        <pc:spChg chg="mod">
          <ac:chgData name="hayato kawachi" userId="3d62671f137ab6e0" providerId="LiveId" clId="{9ACEAE6A-6E50-4DAA-894C-41376CB299AA}" dt="2021-10-05T11:30:48.263" v="698" actId="207"/>
          <ac:spMkLst>
            <pc:docMk/>
            <pc:sldMk cId="3840021381" sldId="317"/>
            <ac:spMk id="2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0:40:35.214" v="598" actId="6549"/>
          <ac:spMkLst>
            <pc:docMk/>
            <pc:sldMk cId="3840021381" sldId="317"/>
            <ac:spMk id="3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0:28:48.502" v="432" actId="1076"/>
          <ac:spMkLst>
            <pc:docMk/>
            <pc:sldMk cId="3840021381" sldId="317"/>
            <ac:spMk id="18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0:37:50.224" v="582" actId="20577"/>
          <ac:spMkLst>
            <pc:docMk/>
            <pc:sldMk cId="3840021381" sldId="317"/>
            <ac:spMk id="37" creationId="{3ED8FDAB-36D8-45DE-89D0-5DAAD4A3261D}"/>
          </ac:spMkLst>
        </pc:spChg>
        <pc:spChg chg="mod">
          <ac:chgData name="hayato kawachi" userId="3d62671f137ab6e0" providerId="LiveId" clId="{9ACEAE6A-6E50-4DAA-894C-41376CB299AA}" dt="2021-10-05T10:37:27.897" v="567" actId="20577"/>
          <ac:spMkLst>
            <pc:docMk/>
            <pc:sldMk cId="3840021381" sldId="317"/>
            <ac:spMk id="38" creationId="{3FB751A9-8633-43EC-82C5-807F8581EEFA}"/>
          </ac:spMkLst>
        </pc:spChg>
        <pc:spChg chg="mod">
          <ac:chgData name="hayato kawachi" userId="3d62671f137ab6e0" providerId="LiveId" clId="{9ACEAE6A-6E50-4DAA-894C-41376CB299AA}" dt="2021-10-05T10:33:19.538" v="444" actId="20577"/>
          <ac:spMkLst>
            <pc:docMk/>
            <pc:sldMk cId="3840021381" sldId="317"/>
            <ac:spMk id="39" creationId="{1B721CC6-56D4-4BD4-9D1B-18C0972D8A62}"/>
          </ac:spMkLst>
        </pc:spChg>
        <pc:spChg chg="mod">
          <ac:chgData name="hayato kawachi" userId="3d62671f137ab6e0" providerId="LiveId" clId="{9ACEAE6A-6E50-4DAA-894C-41376CB299AA}" dt="2021-10-05T10:38:24.533" v="584" actId="20577"/>
          <ac:spMkLst>
            <pc:docMk/>
            <pc:sldMk cId="3840021381" sldId="317"/>
            <ac:spMk id="57" creationId="{00000000-0000-0000-0000-000000000000}"/>
          </ac:spMkLst>
        </pc:spChg>
        <pc:spChg chg="mod">
          <ac:chgData name="hayato kawachi" userId="3d62671f137ab6e0" providerId="LiveId" clId="{9ACEAE6A-6E50-4DAA-894C-41376CB299AA}" dt="2021-10-05T10:38:34.442" v="588" actId="20577"/>
          <ac:spMkLst>
            <pc:docMk/>
            <pc:sldMk cId="3840021381" sldId="317"/>
            <ac:spMk id="61" creationId="{00000000-0000-0000-0000-000000000000}"/>
          </ac:spMkLst>
        </pc:spChg>
        <pc:grpChg chg="mod">
          <ac:chgData name="hayato kawachi" userId="3d62671f137ab6e0" providerId="LiveId" clId="{9ACEAE6A-6E50-4DAA-894C-41376CB299AA}" dt="2021-10-05T10:35:57.570" v="541" actId="1036"/>
          <ac:grpSpMkLst>
            <pc:docMk/>
            <pc:sldMk cId="3840021381" sldId="317"/>
            <ac:grpSpMk id="32" creationId="{EAF5553A-ED76-47DE-B321-5506EC8AE13B}"/>
          </ac:grpSpMkLst>
        </pc:grpChg>
        <pc:picChg chg="add mod ord">
          <ac:chgData name="hayato kawachi" userId="3d62671f137ab6e0" providerId="LiveId" clId="{9ACEAE6A-6E50-4DAA-894C-41376CB299AA}" dt="2021-10-05T10:36:05.002" v="543" actId="1076"/>
          <ac:picMkLst>
            <pc:docMk/>
            <pc:sldMk cId="3840021381" sldId="317"/>
            <ac:picMk id="40" creationId="{9E4E7BE0-43E1-4FB6-A208-2E04C2C844BD}"/>
          </ac:picMkLst>
        </pc:picChg>
        <pc:picChg chg="del mod">
          <ac:chgData name="hayato kawachi" userId="3d62671f137ab6e0" providerId="LiveId" clId="{9ACEAE6A-6E50-4DAA-894C-41376CB299AA}" dt="2021-10-05T10:34:53.918" v="452" actId="478"/>
          <ac:picMkLst>
            <pc:docMk/>
            <pc:sldMk cId="3840021381" sldId="317"/>
            <ac:picMk id="41" creationId="{7D2D16FF-BE50-4665-80D4-9065F96C0A8D}"/>
          </ac:picMkLst>
        </pc:picChg>
      </pc:sldChg>
      <pc:sldChg chg="new del">
        <pc:chgData name="hayato kawachi" userId="3d62671f137ab6e0" providerId="LiveId" clId="{9ACEAE6A-6E50-4DAA-894C-41376CB299AA}" dt="2021-10-05T11:40:18.138" v="777" actId="47"/>
        <pc:sldMkLst>
          <pc:docMk/>
          <pc:sldMk cId="574957144" sldId="318"/>
        </pc:sldMkLst>
      </pc:sldChg>
      <pc:sldChg chg="delSp new del mod">
        <pc:chgData name="hayato kawachi" userId="3d62671f137ab6e0" providerId="LiveId" clId="{9ACEAE6A-6E50-4DAA-894C-41376CB299AA}" dt="2021-10-05T11:50:50.478" v="864" actId="47"/>
        <pc:sldMkLst>
          <pc:docMk/>
          <pc:sldMk cId="1540671938" sldId="318"/>
        </pc:sldMkLst>
        <pc:picChg chg="del">
          <ac:chgData name="hayato kawachi" userId="3d62671f137ab6e0" providerId="LiveId" clId="{9ACEAE6A-6E50-4DAA-894C-41376CB299AA}" dt="2021-10-05T11:45:34.537" v="822" actId="478"/>
          <ac:picMkLst>
            <pc:docMk/>
            <pc:sldMk cId="1540671938" sldId="318"/>
            <ac:picMk id="2" creationId="{04CDBC00-1A53-4FC9-854C-82F86909377A}"/>
          </ac:picMkLst>
        </pc:picChg>
      </pc:sldChg>
      <pc:sldChg chg="modSp add del mod">
        <pc:chgData name="hayato kawachi" userId="3d62671f137ab6e0" providerId="LiveId" clId="{9ACEAE6A-6E50-4DAA-894C-41376CB299AA}" dt="2021-10-05T11:31:21.422" v="701" actId="47"/>
        <pc:sldMkLst>
          <pc:docMk/>
          <pc:sldMk cId="1632746004" sldId="318"/>
        </pc:sldMkLst>
        <pc:spChg chg="mod">
          <ac:chgData name="hayato kawachi" userId="3d62671f137ab6e0" providerId="LiveId" clId="{9ACEAE6A-6E50-4DAA-894C-41376CB299AA}" dt="2021-10-05T11:31:09.966" v="700" actId="20577"/>
          <ac:spMkLst>
            <pc:docMk/>
            <pc:sldMk cId="1632746004" sldId="318"/>
            <ac:spMk id="2" creationId="{00000000-0000-0000-0000-000000000000}"/>
          </ac:spMkLst>
        </pc:spChg>
      </pc:sldChg>
      <pc:sldChg chg="new del">
        <pc:chgData name="hayato kawachi" userId="3d62671f137ab6e0" providerId="LiveId" clId="{9ACEAE6A-6E50-4DAA-894C-41376CB299AA}" dt="2021-10-05T11:44:33.844" v="815" actId="47"/>
        <pc:sldMkLst>
          <pc:docMk/>
          <pc:sldMk cId="4025836782" sldId="318"/>
        </pc:sldMkLst>
      </pc:sldChg>
      <pc:sldChg chg="new del">
        <pc:chgData name="hayato kawachi" userId="3d62671f137ab6e0" providerId="LiveId" clId="{9ACEAE6A-6E50-4DAA-894C-41376CB299AA}" dt="2021-10-05T10:03:13.638" v="398" actId="47"/>
        <pc:sldMkLst>
          <pc:docMk/>
          <pc:sldMk cId="1247386128" sldId="319"/>
        </pc:sldMkLst>
      </pc:sldChg>
      <pc:sldChg chg="new del">
        <pc:chgData name="hayato kawachi" userId="3d62671f137ab6e0" providerId="LiveId" clId="{9ACEAE6A-6E50-4DAA-894C-41376CB299AA}" dt="2021-10-05T11:27:51.328" v="662" actId="47"/>
        <pc:sldMkLst>
          <pc:docMk/>
          <pc:sldMk cId="1554265399" sldId="319"/>
        </pc:sldMkLst>
      </pc:sldChg>
      <pc:sldChg chg="delSp new del mod">
        <pc:chgData name="hayato kawachi" userId="3d62671f137ab6e0" providerId="LiveId" clId="{9ACEAE6A-6E50-4DAA-894C-41376CB299AA}" dt="2021-10-05T08:44:20.207" v="287" actId="47"/>
        <pc:sldMkLst>
          <pc:docMk/>
          <pc:sldMk cId="1620710924" sldId="319"/>
        </pc:sldMkLst>
        <pc:picChg chg="del">
          <ac:chgData name="hayato kawachi" userId="3d62671f137ab6e0" providerId="LiveId" clId="{9ACEAE6A-6E50-4DAA-894C-41376CB299AA}" dt="2021-10-05T08:41:18.403" v="243" actId="478"/>
          <ac:picMkLst>
            <pc:docMk/>
            <pc:sldMk cId="1620710924" sldId="319"/>
            <ac:picMk id="2" creationId="{23D4B215-1D00-4ADB-AB8B-7D2D76AE205A}"/>
          </ac:picMkLst>
        </pc:picChg>
      </pc:sldChg>
      <pc:sldChg chg="new del">
        <pc:chgData name="hayato kawachi" userId="3d62671f137ab6e0" providerId="LiveId" clId="{9ACEAE6A-6E50-4DAA-894C-41376CB299AA}" dt="2021-10-05T11:51:22.806" v="882" actId="47"/>
        <pc:sldMkLst>
          <pc:docMk/>
          <pc:sldMk cId="1769835553" sldId="319"/>
        </pc:sldMkLst>
      </pc:sldChg>
      <pc:sldChg chg="new del">
        <pc:chgData name="hayato kawachi" userId="3d62671f137ab6e0" providerId="LiveId" clId="{9ACEAE6A-6E50-4DAA-894C-41376CB299AA}" dt="2021-10-05T11:24:44.856" v="625" actId="47"/>
        <pc:sldMkLst>
          <pc:docMk/>
          <pc:sldMk cId="2113535021" sldId="319"/>
        </pc:sldMkLst>
      </pc:sldChg>
      <pc:sldChg chg="new del">
        <pc:chgData name="hayato kawachi" userId="3d62671f137ab6e0" providerId="LiveId" clId="{9ACEAE6A-6E50-4DAA-894C-41376CB299AA}" dt="2021-10-05T09:45:39.113" v="362" actId="47"/>
        <pc:sldMkLst>
          <pc:docMk/>
          <pc:sldMk cId="2509651621" sldId="319"/>
        </pc:sldMkLst>
      </pc:sldChg>
      <pc:sldChg chg="new del">
        <pc:chgData name="hayato kawachi" userId="3d62671f137ab6e0" providerId="LiveId" clId="{9ACEAE6A-6E50-4DAA-894C-41376CB299AA}" dt="2021-10-05T10:35:06.982" v="469" actId="47"/>
        <pc:sldMkLst>
          <pc:docMk/>
          <pc:sldMk cId="2674612502" sldId="319"/>
        </pc:sldMkLst>
      </pc:sldChg>
      <pc:sldChg chg="new del">
        <pc:chgData name="hayato kawachi" userId="3d62671f137ab6e0" providerId="LiveId" clId="{9ACEAE6A-6E50-4DAA-894C-41376CB299AA}" dt="2021-10-05T10:21:30.035" v="427" actId="47"/>
        <pc:sldMkLst>
          <pc:docMk/>
          <pc:sldMk cId="2970294208" sldId="319"/>
        </pc:sldMkLst>
      </pc:sldChg>
      <pc:sldChg chg="new del">
        <pc:chgData name="hayato kawachi" userId="3d62671f137ab6e0" providerId="LiveId" clId="{9ACEAE6A-6E50-4DAA-894C-41376CB299AA}" dt="2021-10-05T09:38:25.416" v="323" actId="47"/>
        <pc:sldMkLst>
          <pc:docMk/>
          <pc:sldMk cId="3130980160" sldId="319"/>
        </pc:sldMkLst>
      </pc:sldChg>
      <pc:sldChg chg="delSp modSp new del mod">
        <pc:chgData name="hayato kawachi" userId="3d62671f137ab6e0" providerId="LiveId" clId="{9ACEAE6A-6E50-4DAA-894C-41376CB299AA}" dt="2021-10-05T05:31:23.993" v="237" actId="47"/>
        <pc:sldMkLst>
          <pc:docMk/>
          <pc:sldMk cId="3456555739" sldId="319"/>
        </pc:sldMkLst>
        <pc:picChg chg="del mod">
          <ac:chgData name="hayato kawachi" userId="3d62671f137ab6e0" providerId="LiveId" clId="{9ACEAE6A-6E50-4DAA-894C-41376CB299AA}" dt="2021-10-05T05:31:21.011" v="236" actId="478"/>
          <ac:picMkLst>
            <pc:docMk/>
            <pc:sldMk cId="3456555739" sldId="319"/>
            <ac:picMk id="2" creationId="{5CFEF43A-AE27-4180-8A00-A979F7CCB067}"/>
          </ac:picMkLst>
        </pc:picChg>
      </pc:sldChg>
    </pc:docChg>
  </pc:docChgLst>
  <pc:docChgLst>
    <pc:chgData name="hayato kawachi" userId="3d62671f137ab6e0" providerId="LiveId" clId="{5CF36E05-258C-4848-8869-4B99D6BFFBDB}"/>
    <pc:docChg chg="undo redo custSel addSld delSld modSld">
      <pc:chgData name="hayato kawachi" userId="3d62671f137ab6e0" providerId="LiveId" clId="{5CF36E05-258C-4848-8869-4B99D6BFFBDB}" dt="2021-12-26T07:36:40.253" v="2650" actId="47"/>
      <pc:docMkLst>
        <pc:docMk/>
      </pc:docMkLst>
      <pc:sldChg chg="addSp delSp modSp mod">
        <pc:chgData name="hayato kawachi" userId="3d62671f137ab6e0" providerId="LiveId" clId="{5CF36E05-258C-4848-8869-4B99D6BFFBDB}" dt="2021-12-22T15:54:10.640" v="1120" actId="478"/>
        <pc:sldMkLst>
          <pc:docMk/>
          <pc:sldMk cId="216619969" sldId="283"/>
        </pc:sldMkLst>
        <pc:spChg chg="mod">
          <ac:chgData name="hayato kawachi" userId="3d62671f137ab6e0" providerId="LiveId" clId="{5CF36E05-258C-4848-8869-4B99D6BFFBDB}" dt="2021-12-22T14:58:40.960" v="551" actId="20577"/>
          <ac:spMkLst>
            <pc:docMk/>
            <pc:sldMk cId="216619969" sldId="283"/>
            <ac:spMk id="38" creationId="{39FD2A55-0842-4C19-86F3-F8F07272273A}"/>
          </ac:spMkLst>
        </pc:spChg>
        <pc:spChg chg="add del">
          <ac:chgData name="hayato kawachi" userId="3d62671f137ab6e0" providerId="LiveId" clId="{5CF36E05-258C-4848-8869-4B99D6BFFBDB}" dt="2021-12-22T15:54:10.640" v="1120" actId="478"/>
          <ac:spMkLst>
            <pc:docMk/>
            <pc:sldMk cId="216619969" sldId="283"/>
            <ac:spMk id="43" creationId="{929F15B9-502E-4938-A774-1F6D383B671D}"/>
          </ac:spMkLst>
        </pc:spChg>
        <pc:spChg chg="mod">
          <ac:chgData name="hayato kawachi" userId="3d62671f137ab6e0" providerId="LiveId" clId="{5CF36E05-258C-4848-8869-4B99D6BFFBDB}" dt="2021-12-14T10:20:12.475" v="110" actId="20577"/>
          <ac:spMkLst>
            <pc:docMk/>
            <pc:sldMk cId="216619969" sldId="283"/>
            <ac:spMk id="56" creationId="{00000000-0000-0000-0000-000000000000}"/>
          </ac:spMkLst>
        </pc:spChg>
      </pc:sldChg>
      <pc:sldChg chg="modSp mod">
        <pc:chgData name="hayato kawachi" userId="3d62671f137ab6e0" providerId="LiveId" clId="{5CF36E05-258C-4848-8869-4B99D6BFFBDB}" dt="2021-12-22T14:59:26.139" v="580" actId="20577"/>
        <pc:sldMkLst>
          <pc:docMk/>
          <pc:sldMk cId="3974256553" sldId="309"/>
        </pc:sldMkLst>
        <pc:spChg chg="mod">
          <ac:chgData name="hayato kawachi" userId="3d62671f137ab6e0" providerId="LiveId" clId="{5CF36E05-258C-4848-8869-4B99D6BFFBDB}" dt="2021-12-22T14:59:17.030" v="570" actId="20577"/>
          <ac:spMkLst>
            <pc:docMk/>
            <pc:sldMk cId="3974256553" sldId="309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4:59:26.139" v="580" actId="20577"/>
          <ac:spMkLst>
            <pc:docMk/>
            <pc:sldMk cId="3974256553" sldId="309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2T14:59:54.333" v="601" actId="20577"/>
        <pc:sldMkLst>
          <pc:docMk/>
          <pc:sldMk cId="1571256114" sldId="311"/>
        </pc:sldMkLst>
        <pc:spChg chg="mod">
          <ac:chgData name="hayato kawachi" userId="3d62671f137ab6e0" providerId="LiveId" clId="{5CF36E05-258C-4848-8869-4B99D6BFFBDB}" dt="2021-12-22T14:43:53.577" v="477" actId="20577"/>
          <ac:spMkLst>
            <pc:docMk/>
            <pc:sldMk cId="1571256114" sldId="311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59:41.247" v="590" actId="20577"/>
          <ac:spMkLst>
            <pc:docMk/>
            <pc:sldMk cId="1571256114" sldId="311"/>
            <ac:spMk id="47" creationId="{8B72101C-BE11-4C80-8D28-74E638A82CF8}"/>
          </ac:spMkLst>
        </pc:spChg>
        <pc:spChg chg="mod">
          <ac:chgData name="hayato kawachi" userId="3d62671f137ab6e0" providerId="LiveId" clId="{5CF36E05-258C-4848-8869-4B99D6BFFBDB}" dt="2021-12-22T14:59:54.333" v="601" actId="20577"/>
          <ac:spMkLst>
            <pc:docMk/>
            <pc:sldMk cId="1571256114" sldId="311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47.354" v="2568" actId="20577"/>
        <pc:sldMkLst>
          <pc:docMk/>
          <pc:sldMk cId="1507186253" sldId="315"/>
        </pc:sldMkLst>
        <pc:spChg chg="mod">
          <ac:chgData name="hayato kawachi" userId="3d62671f137ab6e0" providerId="LiveId" clId="{5CF36E05-258C-4848-8869-4B99D6BFFBDB}" dt="2021-12-26T03:15:47.354" v="2568" actId="20577"/>
          <ac:spMkLst>
            <pc:docMk/>
            <pc:sldMk cId="1507186253" sldId="315"/>
            <ac:spMk id="2" creationId="{00000000-0000-0000-0000-000000000000}"/>
          </ac:spMkLst>
        </pc:spChg>
      </pc:sldChg>
      <pc:sldChg chg="modSp mod">
        <pc:chgData name="hayato kawachi" userId="3d62671f137ab6e0" providerId="LiveId" clId="{5CF36E05-258C-4848-8869-4B99D6BFFBDB}" dt="2021-12-22T15:00:16.849" v="625" actId="6549"/>
        <pc:sldMkLst>
          <pc:docMk/>
          <pc:sldMk cId="322658806" sldId="316"/>
        </pc:sldMkLst>
        <pc:spChg chg="mod">
          <ac:chgData name="hayato kawachi" userId="3d62671f137ab6e0" providerId="LiveId" clId="{5CF36E05-258C-4848-8869-4B99D6BFFBDB}" dt="2021-12-22T14:43:58.514" v="481" actId="20577"/>
          <ac:spMkLst>
            <pc:docMk/>
            <pc:sldMk cId="322658806" sldId="316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13T10:30:00.138" v="14" actId="20577"/>
          <ac:spMkLst>
            <pc:docMk/>
            <pc:sldMk cId="322658806" sldId="316"/>
            <ac:spMk id="3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0:08.299" v="611" actId="20577"/>
          <ac:spMkLst>
            <pc:docMk/>
            <pc:sldMk cId="322658806" sldId="316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0:16.849" v="625" actId="6549"/>
          <ac:spMkLst>
            <pc:docMk/>
            <pc:sldMk cId="322658806" sldId="316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51.503" v="2572" actId="20577"/>
        <pc:sldMkLst>
          <pc:docMk/>
          <pc:sldMk cId="3840021381" sldId="317"/>
        </pc:sldMkLst>
        <pc:spChg chg="mod">
          <ac:chgData name="hayato kawachi" userId="3d62671f137ab6e0" providerId="LiveId" clId="{5CF36E05-258C-4848-8869-4B99D6BFFBDB}" dt="2021-12-26T03:15:51.503" v="2572" actId="20577"/>
          <ac:spMkLst>
            <pc:docMk/>
            <pc:sldMk cId="3840021381" sldId="317"/>
            <ac:spMk id="2" creationId="{00000000-0000-0000-0000-000000000000}"/>
          </ac:spMkLst>
        </pc:spChg>
      </pc:sldChg>
      <pc:sldChg chg="modSp mod">
        <pc:chgData name="hayato kawachi" userId="3d62671f137ab6e0" providerId="LiveId" clId="{5CF36E05-258C-4848-8869-4B99D6BFFBDB}" dt="2021-12-22T14:06:24.517" v="161" actId="20577"/>
        <pc:sldMkLst>
          <pc:docMk/>
          <pc:sldMk cId="163190479" sldId="318"/>
        </pc:sldMkLst>
        <pc:spChg chg="mod">
          <ac:chgData name="hayato kawachi" userId="3d62671f137ab6e0" providerId="LiveId" clId="{5CF36E05-258C-4848-8869-4B99D6BFFBDB}" dt="2021-12-22T14:06:24.517" v="161" actId="20577"/>
          <ac:spMkLst>
            <pc:docMk/>
            <pc:sldMk cId="163190479" sldId="318"/>
            <ac:spMk id="2" creationId="{FE0D19BB-235A-44AB-A32F-F610D8B3FF1B}"/>
          </ac:spMkLst>
        </pc:spChg>
      </pc:sldChg>
      <pc:sldChg chg="addSp delSp modSp mod">
        <pc:chgData name="hayato kawachi" userId="3d62671f137ab6e0" providerId="LiveId" clId="{5CF36E05-258C-4848-8869-4B99D6BFFBDB}" dt="2021-12-22T15:05:37.453" v="946" actId="20577"/>
        <pc:sldMkLst>
          <pc:docMk/>
          <pc:sldMk cId="2460127092" sldId="319"/>
        </pc:sldMkLst>
        <pc:spChg chg="mod">
          <ac:chgData name="hayato kawachi" userId="3d62671f137ab6e0" providerId="LiveId" clId="{5CF36E05-258C-4848-8869-4B99D6BFFBDB}" dt="2021-12-22T14:44:33.660" v="499" actId="20577"/>
          <ac:spMkLst>
            <pc:docMk/>
            <pc:sldMk cId="2460127092" sldId="319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5:29.558" v="935" actId="20577"/>
          <ac:spMkLst>
            <pc:docMk/>
            <pc:sldMk cId="2460127092" sldId="319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4:17:42.618" v="278" actId="20577"/>
          <ac:spMkLst>
            <pc:docMk/>
            <pc:sldMk cId="2460127092" sldId="319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15:08.082" v="253" actId="20577"/>
          <ac:spMkLst>
            <pc:docMk/>
            <pc:sldMk cId="2460127092" sldId="319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2T14:15:23.041" v="261" actId="20577"/>
          <ac:spMkLst>
            <pc:docMk/>
            <pc:sldMk cId="2460127092" sldId="319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2T14:13:00.726" v="244" actId="20577"/>
          <ac:spMkLst>
            <pc:docMk/>
            <pc:sldMk cId="2460127092" sldId="319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2T15:05:37.453" v="946" actId="20577"/>
          <ac:spMkLst>
            <pc:docMk/>
            <pc:sldMk cId="2460127092" sldId="319"/>
            <ac:spMk id="42" creationId="{0327A1DA-81BE-416E-9C5D-F34729FB5687}"/>
          </ac:spMkLst>
        </pc:spChg>
        <pc:spChg chg="mod">
          <ac:chgData name="hayato kawachi" userId="3d62671f137ab6e0" providerId="LiveId" clId="{5CF36E05-258C-4848-8869-4B99D6BFFBDB}" dt="2021-12-22T14:16:05.978" v="265" actId="20577"/>
          <ac:spMkLst>
            <pc:docMk/>
            <pc:sldMk cId="2460127092" sldId="319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2T14:17:49.735" v="281" actId="20577"/>
          <ac:spMkLst>
            <pc:docMk/>
            <pc:sldMk cId="2460127092" sldId="319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17:56.337" v="283" actId="20577"/>
          <ac:spMkLst>
            <pc:docMk/>
            <pc:sldMk cId="2460127092" sldId="319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16:42.158" v="274" actId="20577"/>
          <ac:spMkLst>
            <pc:docMk/>
            <pc:sldMk cId="2460127092" sldId="319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16:48.306" v="276" actId="20577"/>
          <ac:spMkLst>
            <pc:docMk/>
            <pc:sldMk cId="2460127092" sldId="319"/>
            <ac:spMk id="69" creationId="{00000000-0000-0000-0000-000000000000}"/>
          </ac:spMkLst>
        </pc:spChg>
        <pc:picChg chg="del">
          <ac:chgData name="hayato kawachi" userId="3d62671f137ab6e0" providerId="LiveId" clId="{5CF36E05-258C-4848-8869-4B99D6BFFBDB}" dt="2021-12-22T14:11:33.383" v="178" actId="478"/>
          <ac:picMkLst>
            <pc:docMk/>
            <pc:sldMk cId="2460127092" sldId="319"/>
            <ac:picMk id="40" creationId="{D4900121-FDE2-4AA1-BB2F-01D1F6648DBB}"/>
          </ac:picMkLst>
        </pc:picChg>
        <pc:picChg chg="add mod ord">
          <ac:chgData name="hayato kawachi" userId="3d62671f137ab6e0" providerId="LiveId" clId="{5CF36E05-258C-4848-8869-4B99D6BFFBDB}" dt="2021-12-22T14:12:01.474" v="194" actId="1035"/>
          <ac:picMkLst>
            <pc:docMk/>
            <pc:sldMk cId="2460127092" sldId="319"/>
            <ac:picMk id="41" creationId="{D4DBFA7E-2162-451D-9D34-F830850E72CA}"/>
          </ac:picMkLst>
        </pc:picChg>
      </pc:sldChg>
      <pc:sldChg chg="addSp delSp modSp mod">
        <pc:chgData name="hayato kawachi" userId="3d62671f137ab6e0" providerId="LiveId" clId="{5CF36E05-258C-4848-8869-4B99D6BFFBDB}" dt="2021-12-22T15:05:58.099" v="966" actId="20577"/>
        <pc:sldMkLst>
          <pc:docMk/>
          <pc:sldMk cId="3184214258" sldId="320"/>
        </pc:sldMkLst>
        <pc:spChg chg="mod">
          <ac:chgData name="hayato kawachi" userId="3d62671f137ab6e0" providerId="LiveId" clId="{5CF36E05-258C-4848-8869-4B99D6BFFBDB}" dt="2021-12-22T14:44:46.497" v="503" actId="20577"/>
          <ac:spMkLst>
            <pc:docMk/>
            <pc:sldMk cId="3184214258" sldId="320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29:20.482" v="366" actId="20577"/>
          <ac:spMkLst>
            <pc:docMk/>
            <pc:sldMk cId="3184214258" sldId="320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26:24.553" v="338" actId="20577"/>
          <ac:spMkLst>
            <pc:docMk/>
            <pc:sldMk cId="3184214258" sldId="320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2T14:25:59.714" v="336" actId="20577"/>
          <ac:spMkLst>
            <pc:docMk/>
            <pc:sldMk cId="3184214258" sldId="320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2T14:21:12.965" v="288" actId="20577"/>
          <ac:spMkLst>
            <pc:docMk/>
            <pc:sldMk cId="3184214258" sldId="320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2T14:28:45.451" v="362" actId="20577"/>
          <ac:spMkLst>
            <pc:docMk/>
            <pc:sldMk cId="3184214258" sldId="320"/>
            <ac:spMk id="45" creationId="{C8C3E270-B328-4ADA-BD8F-95EBE4EC2EDA}"/>
          </ac:spMkLst>
        </pc:spChg>
        <pc:spChg chg="mod">
          <ac:chgData name="hayato kawachi" userId="3d62671f137ab6e0" providerId="LiveId" clId="{5CF36E05-258C-4848-8869-4B99D6BFFBDB}" dt="2021-12-22T15:05:58.099" v="966" actId="20577"/>
          <ac:spMkLst>
            <pc:docMk/>
            <pc:sldMk cId="3184214258" sldId="320"/>
            <ac:spMk id="47" creationId="{8B72101C-BE11-4C80-8D28-74E638A82CF8}"/>
          </ac:spMkLst>
        </pc:spChg>
        <pc:spChg chg="mod">
          <ac:chgData name="hayato kawachi" userId="3d62671f137ab6e0" providerId="LiveId" clId="{5CF36E05-258C-4848-8869-4B99D6BFFBDB}" dt="2021-12-22T14:28:08.739" v="346" actId="20577"/>
          <ac:spMkLst>
            <pc:docMk/>
            <pc:sldMk cId="3184214258" sldId="320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2T15:05:46.338" v="956" actId="20577"/>
          <ac:spMkLst>
            <pc:docMk/>
            <pc:sldMk cId="3184214258" sldId="320"/>
            <ac:spMk id="54" creationId="{6B034BB4-87EC-4C4C-A9AF-B8FCEF11E244}"/>
          </ac:spMkLst>
        </pc:spChg>
        <pc:spChg chg="mod">
          <ac:chgData name="hayato kawachi" userId="3d62671f137ab6e0" providerId="LiveId" clId="{5CF36E05-258C-4848-8869-4B99D6BFFBDB}" dt="2021-12-22T14:29:26.056" v="370" actId="20577"/>
          <ac:spMkLst>
            <pc:docMk/>
            <pc:sldMk cId="3184214258" sldId="320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29:33.358" v="372" actId="20577"/>
          <ac:spMkLst>
            <pc:docMk/>
            <pc:sldMk cId="3184214258" sldId="320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28:32.443" v="356" actId="20577"/>
          <ac:spMkLst>
            <pc:docMk/>
            <pc:sldMk cId="3184214258" sldId="320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28:39.618" v="358" actId="20577"/>
          <ac:spMkLst>
            <pc:docMk/>
            <pc:sldMk cId="3184214258" sldId="320"/>
            <ac:spMk id="69" creationId="{00000000-0000-0000-0000-000000000000}"/>
          </ac:spMkLst>
        </pc:spChg>
        <pc:picChg chg="del">
          <ac:chgData name="hayato kawachi" userId="3d62671f137ab6e0" providerId="LiveId" clId="{5CF36E05-258C-4848-8869-4B99D6BFFBDB}" dt="2021-12-22T14:22:50.499" v="294" actId="478"/>
          <ac:picMkLst>
            <pc:docMk/>
            <pc:sldMk cId="3184214258" sldId="320"/>
            <ac:picMk id="40" creationId="{2B609B19-D643-495C-BF49-864F4783605B}"/>
          </ac:picMkLst>
        </pc:picChg>
        <pc:picChg chg="add mod ord">
          <ac:chgData name="hayato kawachi" userId="3d62671f137ab6e0" providerId="LiveId" clId="{5CF36E05-258C-4848-8869-4B99D6BFFBDB}" dt="2021-12-22T14:23:32.918" v="326" actId="1036"/>
          <ac:picMkLst>
            <pc:docMk/>
            <pc:sldMk cId="3184214258" sldId="320"/>
            <ac:picMk id="41" creationId="{E62EA1DD-BF54-4BC4-904D-6E3236AB2C07}"/>
          </ac:picMkLst>
        </pc:picChg>
      </pc:sldChg>
      <pc:sldChg chg="addSp delSp modSp mod">
        <pc:chgData name="hayato kawachi" userId="3d62671f137ab6e0" providerId="LiveId" clId="{5CF36E05-258C-4848-8869-4B99D6BFFBDB}" dt="2021-12-26T03:16:54.004" v="2618" actId="20577"/>
        <pc:sldMkLst>
          <pc:docMk/>
          <pc:sldMk cId="2663189720" sldId="321"/>
        </pc:sldMkLst>
        <pc:spChg chg="mod">
          <ac:chgData name="hayato kawachi" userId="3d62671f137ab6e0" providerId="LiveId" clId="{5CF36E05-258C-4848-8869-4B99D6BFFBDB}" dt="2021-12-26T03:16:54.004" v="2618" actId="20577"/>
          <ac:spMkLst>
            <pc:docMk/>
            <pc:sldMk cId="2663189720" sldId="321"/>
            <ac:spMk id="2" creationId="{00000000-0000-0000-0000-000000000000}"/>
          </ac:spMkLst>
        </pc:spChg>
        <pc:spChg chg="del">
          <ac:chgData name="hayato kawachi" userId="3d62671f137ab6e0" providerId="LiveId" clId="{5CF36E05-258C-4848-8869-4B99D6BFFBDB}" dt="2021-12-26T02:44:52.363" v="2161" actId="478"/>
          <ac:spMkLst>
            <pc:docMk/>
            <pc:sldMk cId="2663189720" sldId="321"/>
            <ac:spMk id="16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46:33.592" v="2199" actId="20577"/>
          <ac:spMkLst>
            <pc:docMk/>
            <pc:sldMk cId="2663189720" sldId="321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44:26.398" v="2156" actId="20577"/>
          <ac:spMkLst>
            <pc:docMk/>
            <pc:sldMk cId="2663189720" sldId="321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6T02:44:45.527" v="2160" actId="1076"/>
          <ac:spMkLst>
            <pc:docMk/>
            <pc:sldMk cId="2663189720" sldId="321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6T02:44:58.002" v="2173" actId="20577"/>
          <ac:spMkLst>
            <pc:docMk/>
            <pc:sldMk cId="2663189720" sldId="321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6T02:47:24.605" v="2222" actId="20577"/>
          <ac:spMkLst>
            <pc:docMk/>
            <pc:sldMk cId="2663189720" sldId="321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6T02:47:27.063" v="2224" actId="20577"/>
          <ac:spMkLst>
            <pc:docMk/>
            <pc:sldMk cId="2663189720" sldId="321"/>
            <ac:spMk id="45" creationId="{8EB91309-2FAF-43D9-ACD3-BA0E2BDE36D9}"/>
          </ac:spMkLst>
        </pc:spChg>
        <pc:spChg chg="add mod">
          <ac:chgData name="hayato kawachi" userId="3d62671f137ab6e0" providerId="LiveId" clId="{5CF36E05-258C-4848-8869-4B99D6BFFBDB}" dt="2021-12-26T02:45:29.762" v="2176"/>
          <ac:spMkLst>
            <pc:docMk/>
            <pc:sldMk cId="2663189720" sldId="321"/>
            <ac:spMk id="46" creationId="{AAC8808F-631B-4D27-989E-345673AA2305}"/>
          </ac:spMkLst>
        </pc:spChg>
        <pc:spChg chg="mod">
          <ac:chgData name="hayato kawachi" userId="3d62671f137ab6e0" providerId="LiveId" clId="{5CF36E05-258C-4848-8869-4B99D6BFFBDB}" dt="2021-12-26T02:47:05.110" v="2214" actId="20577"/>
          <ac:spMkLst>
            <pc:docMk/>
            <pc:sldMk cId="2663189720" sldId="321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47:10.579" v="2216" actId="20577"/>
          <ac:spMkLst>
            <pc:docMk/>
            <pc:sldMk cId="2663189720" sldId="321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47:17.682" v="2218" actId="20577"/>
          <ac:spMkLst>
            <pc:docMk/>
            <pc:sldMk cId="2663189720" sldId="321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47:19.906" v="2220" actId="20577"/>
          <ac:spMkLst>
            <pc:docMk/>
            <pc:sldMk cId="2663189720" sldId="321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47:30.153" v="2226" actId="20577"/>
          <ac:spMkLst>
            <pc:docMk/>
            <pc:sldMk cId="2663189720" sldId="321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6T02:41:42.809" v="2141" actId="1037"/>
          <ac:picMkLst>
            <pc:docMk/>
            <pc:sldMk cId="2663189720" sldId="321"/>
            <ac:picMk id="5" creationId="{664733D6-2195-4420-8D20-803B388D9E67}"/>
          </ac:picMkLst>
        </pc:picChg>
        <pc:picChg chg="del">
          <ac:chgData name="hayato kawachi" userId="3d62671f137ab6e0" providerId="LiveId" clId="{5CF36E05-258C-4848-8869-4B99D6BFFBDB}" dt="2021-12-26T02:41:19.559" v="2116" actId="478"/>
          <ac:picMkLst>
            <pc:docMk/>
            <pc:sldMk cId="2663189720" sldId="321"/>
            <ac:picMk id="40" creationId="{DB42677F-4A04-42E8-9B69-9D5175347B44}"/>
          </ac:picMkLst>
        </pc:picChg>
      </pc:sldChg>
      <pc:sldChg chg="addSp delSp modSp mod">
        <pc:chgData name="hayato kawachi" userId="3d62671f137ab6e0" providerId="LiveId" clId="{5CF36E05-258C-4848-8869-4B99D6BFFBDB}" dt="2021-12-22T15:06:17.245" v="986" actId="20577"/>
        <pc:sldMkLst>
          <pc:docMk/>
          <pc:sldMk cId="3120795257" sldId="322"/>
        </pc:sldMkLst>
        <pc:spChg chg="mod">
          <ac:chgData name="hayato kawachi" userId="3d62671f137ab6e0" providerId="LiveId" clId="{5CF36E05-258C-4848-8869-4B99D6BFFBDB}" dt="2021-12-22T14:44:55.334" v="507" actId="20577"/>
          <ac:spMkLst>
            <pc:docMk/>
            <pc:sldMk cId="3120795257" sldId="322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6:09.637" v="976" actId="20577"/>
          <ac:spMkLst>
            <pc:docMk/>
            <pc:sldMk cId="3120795257" sldId="322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4:42:01.544" v="464" actId="20577"/>
          <ac:spMkLst>
            <pc:docMk/>
            <pc:sldMk cId="3120795257" sldId="322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39:39.605" v="408" actId="1076"/>
          <ac:spMkLst>
            <pc:docMk/>
            <pc:sldMk cId="3120795257" sldId="322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2T14:39:45.036" v="409" actId="1076"/>
          <ac:spMkLst>
            <pc:docMk/>
            <pc:sldMk cId="3120795257" sldId="322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2T14:40:01.628" v="421" actId="20577"/>
          <ac:spMkLst>
            <pc:docMk/>
            <pc:sldMk cId="3120795257" sldId="322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2T14:40:53.476" v="431" actId="20577"/>
          <ac:spMkLst>
            <pc:docMk/>
            <pc:sldMk cId="3120795257" sldId="322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2T15:06:17.245" v="986" actId="20577"/>
          <ac:spMkLst>
            <pc:docMk/>
            <pc:sldMk cId="3120795257" sldId="322"/>
            <ac:spMk id="53" creationId="{1FB50F88-B6D0-4B32-83D0-D60F6E12E6F7}"/>
          </ac:spMkLst>
        </pc:spChg>
        <pc:spChg chg="mod">
          <ac:chgData name="hayato kawachi" userId="3d62671f137ab6e0" providerId="LiveId" clId="{5CF36E05-258C-4848-8869-4B99D6BFFBDB}" dt="2021-12-22T14:42:26.782" v="466" actId="20577"/>
          <ac:spMkLst>
            <pc:docMk/>
            <pc:sldMk cId="3120795257" sldId="322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42:32.523" v="468" actId="20577"/>
          <ac:spMkLst>
            <pc:docMk/>
            <pc:sldMk cId="3120795257" sldId="322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42:38.691" v="470" actId="20577"/>
          <ac:spMkLst>
            <pc:docMk/>
            <pc:sldMk cId="3120795257" sldId="322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42:41.456" v="472" actId="20577"/>
          <ac:spMkLst>
            <pc:docMk/>
            <pc:sldMk cId="3120795257" sldId="322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4:42:44.724" v="474" actId="20577"/>
          <ac:spMkLst>
            <pc:docMk/>
            <pc:sldMk cId="3120795257" sldId="322"/>
            <ac:spMk id="73" creationId="{00000000-0000-0000-0000-000000000000}"/>
          </ac:spMkLst>
        </pc:spChg>
        <pc:picChg chg="del">
          <ac:chgData name="hayato kawachi" userId="3d62671f137ab6e0" providerId="LiveId" clId="{5CF36E05-258C-4848-8869-4B99D6BFFBDB}" dt="2021-12-22T14:38:16.034" v="379" actId="478"/>
          <ac:picMkLst>
            <pc:docMk/>
            <pc:sldMk cId="3120795257" sldId="322"/>
            <ac:picMk id="6" creationId="{1D86EBC2-9120-4B1D-8F34-EC840D786D14}"/>
          </ac:picMkLst>
        </pc:picChg>
        <pc:picChg chg="add mod ord">
          <ac:chgData name="hayato kawachi" userId="3d62671f137ab6e0" providerId="LiveId" clId="{5CF36E05-258C-4848-8869-4B99D6BFFBDB}" dt="2021-12-22T14:39:51.698" v="413" actId="1076"/>
          <ac:picMkLst>
            <pc:docMk/>
            <pc:sldMk cId="3120795257" sldId="322"/>
            <ac:picMk id="40" creationId="{8C6AA4A8-88AB-4F11-94F7-86D66E969FBE}"/>
          </ac:picMkLst>
        </pc:picChg>
      </pc:sldChg>
      <pc:sldChg chg="addSp delSp modSp mod">
        <pc:chgData name="hayato kawachi" userId="3d62671f137ab6e0" providerId="LiveId" clId="{5CF36E05-258C-4848-8869-4B99D6BFFBDB}" dt="2021-12-26T03:17:11.943" v="2634" actId="20577"/>
        <pc:sldMkLst>
          <pc:docMk/>
          <pc:sldMk cId="228181719" sldId="323"/>
        </pc:sldMkLst>
        <pc:spChg chg="mod">
          <ac:chgData name="hayato kawachi" userId="3d62671f137ab6e0" providerId="LiveId" clId="{5CF36E05-258C-4848-8869-4B99D6BFFBDB}" dt="2021-12-26T03:17:11.943" v="2634" actId="20577"/>
          <ac:spMkLst>
            <pc:docMk/>
            <pc:sldMk cId="228181719" sldId="323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52:09.013" v="2305" actId="20577"/>
          <ac:spMkLst>
            <pc:docMk/>
            <pc:sldMk cId="228181719" sldId="323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51:45.935" v="2298" actId="1076"/>
          <ac:spMkLst>
            <pc:docMk/>
            <pc:sldMk cId="228181719" sldId="323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6T02:51:43.465" v="2297" actId="1076"/>
          <ac:spMkLst>
            <pc:docMk/>
            <pc:sldMk cId="228181719" sldId="323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6T02:51:51.410" v="2303" actId="20577"/>
          <ac:spMkLst>
            <pc:docMk/>
            <pc:sldMk cId="228181719" sldId="323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6T02:52:13.317" v="2308" actId="20577"/>
          <ac:spMkLst>
            <pc:docMk/>
            <pc:sldMk cId="228181719" sldId="323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52:17.809" v="2310" actId="20577"/>
          <ac:spMkLst>
            <pc:docMk/>
            <pc:sldMk cId="228181719" sldId="323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52:22.196" v="2312" actId="20577"/>
          <ac:spMkLst>
            <pc:docMk/>
            <pc:sldMk cId="228181719" sldId="323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2:52:25.527" v="2314" actId="20577"/>
          <ac:spMkLst>
            <pc:docMk/>
            <pc:sldMk cId="228181719" sldId="323"/>
            <ac:spMk id="69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6T02:50:48.670" v="2261" actId="1035"/>
          <ac:picMkLst>
            <pc:docMk/>
            <pc:sldMk cId="228181719" sldId="323"/>
            <ac:picMk id="5" creationId="{C53C06F8-490A-4EB2-BFE4-3F4F7F85829E}"/>
          </ac:picMkLst>
        </pc:picChg>
        <pc:picChg chg="del">
          <ac:chgData name="hayato kawachi" userId="3d62671f137ab6e0" providerId="LiveId" clId="{5CF36E05-258C-4848-8869-4B99D6BFFBDB}" dt="2021-12-26T02:50:30.329" v="2231" actId="478"/>
          <ac:picMkLst>
            <pc:docMk/>
            <pc:sldMk cId="228181719" sldId="323"/>
            <ac:picMk id="46" creationId="{115B4DA3-E2BA-45FE-BF2F-FF63BDC74196}"/>
          </ac:picMkLst>
        </pc:picChg>
      </pc:sldChg>
      <pc:sldChg chg="modSp mod">
        <pc:chgData name="hayato kawachi" userId="3d62671f137ab6e0" providerId="LiveId" clId="{5CF36E05-258C-4848-8869-4B99D6BFFBDB}" dt="2021-12-26T03:14:24.691" v="2532" actId="20577"/>
        <pc:sldMkLst>
          <pc:docMk/>
          <pc:sldMk cId="2070169754" sldId="327"/>
        </pc:sldMkLst>
        <pc:spChg chg="mod">
          <ac:chgData name="hayato kawachi" userId="3d62671f137ab6e0" providerId="LiveId" clId="{5CF36E05-258C-4848-8869-4B99D6BFFBDB}" dt="2021-12-26T03:14:24.691" v="2532" actId="20577"/>
          <ac:spMkLst>
            <pc:docMk/>
            <pc:sldMk cId="2070169754" sldId="327"/>
            <ac:spMk id="2" creationId="{FE0D19BB-235A-44AB-A32F-F610D8B3FF1B}"/>
          </ac:spMkLst>
        </pc:spChg>
      </pc:sldChg>
      <pc:sldChg chg="modSp mod">
        <pc:chgData name="hayato kawachi" userId="3d62671f137ab6e0" providerId="LiveId" clId="{5CF36E05-258C-4848-8869-4B99D6BFFBDB}" dt="2021-12-22T14:06:35.989" v="170"/>
        <pc:sldMkLst>
          <pc:docMk/>
          <pc:sldMk cId="1418843655" sldId="328"/>
        </pc:sldMkLst>
        <pc:spChg chg="mod">
          <ac:chgData name="hayato kawachi" userId="3d62671f137ab6e0" providerId="LiveId" clId="{5CF36E05-258C-4848-8869-4B99D6BFFBDB}" dt="2021-12-22T14:06:35.989" v="170"/>
          <ac:spMkLst>
            <pc:docMk/>
            <pc:sldMk cId="1418843655" sldId="328"/>
            <ac:spMk id="2" creationId="{FE0D19BB-235A-44AB-A32F-F610D8B3FF1B}"/>
          </ac:spMkLst>
        </pc:spChg>
      </pc:sldChg>
      <pc:sldChg chg="del">
        <pc:chgData name="hayato kawachi" userId="3d62671f137ab6e0" providerId="LiveId" clId="{5CF36E05-258C-4848-8869-4B99D6BFFBDB}" dt="2021-12-23T13:00:32.035" v="1182" actId="47"/>
        <pc:sldMkLst>
          <pc:docMk/>
          <pc:sldMk cId="4128821573" sldId="335"/>
        </pc:sldMkLst>
      </pc:sldChg>
      <pc:sldChg chg="modSp mod">
        <pc:chgData name="hayato kawachi" userId="3d62671f137ab6e0" providerId="LiveId" clId="{5CF36E05-258C-4848-8869-4B99D6BFFBDB}" dt="2021-12-26T03:14:59.591" v="2541" actId="20577"/>
        <pc:sldMkLst>
          <pc:docMk/>
          <pc:sldMk cId="4133687114" sldId="339"/>
        </pc:sldMkLst>
        <pc:spChg chg="mod">
          <ac:chgData name="hayato kawachi" userId="3d62671f137ab6e0" providerId="LiveId" clId="{5CF36E05-258C-4848-8869-4B99D6BFFBDB}" dt="2021-12-26T03:14:59.591" v="2541" actId="20577"/>
          <ac:spMkLst>
            <pc:docMk/>
            <pc:sldMk cId="4133687114" sldId="339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1:06.612" v="662" actId="20577"/>
          <ac:spMkLst>
            <pc:docMk/>
            <pc:sldMk cId="4133687114" sldId="339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1:16.335" v="673" actId="20577"/>
          <ac:spMkLst>
            <pc:docMk/>
            <pc:sldMk cId="4133687114" sldId="339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4:53.342" v="2537"/>
        <pc:sldMkLst>
          <pc:docMk/>
          <pc:sldMk cId="3607678172" sldId="340"/>
        </pc:sldMkLst>
        <pc:spChg chg="mod">
          <ac:chgData name="hayato kawachi" userId="3d62671f137ab6e0" providerId="LiveId" clId="{5CF36E05-258C-4848-8869-4B99D6BFFBDB}" dt="2021-12-26T03:14:53.342" v="2537"/>
          <ac:spMkLst>
            <pc:docMk/>
            <pc:sldMk cId="3607678172" sldId="340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0:43.017" v="642" actId="20577"/>
          <ac:spMkLst>
            <pc:docMk/>
            <pc:sldMk cId="3607678172" sldId="340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0:52.887" v="652" actId="20577"/>
          <ac:spMkLst>
            <pc:docMk/>
            <pc:sldMk cId="3607678172" sldId="340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04.070" v="2545" actId="6549"/>
        <pc:sldMkLst>
          <pc:docMk/>
          <pc:sldMk cId="2250381105" sldId="341"/>
        </pc:sldMkLst>
        <pc:spChg chg="mod">
          <ac:chgData name="hayato kawachi" userId="3d62671f137ab6e0" providerId="LiveId" clId="{5CF36E05-258C-4848-8869-4B99D6BFFBDB}" dt="2021-12-26T03:15:04.070" v="2545" actId="6549"/>
          <ac:spMkLst>
            <pc:docMk/>
            <pc:sldMk cId="2250381105" sldId="341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1:32.338" v="693" actId="20577"/>
          <ac:spMkLst>
            <pc:docMk/>
            <pc:sldMk cId="2250381105" sldId="341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1:54.374" v="705" actId="20577"/>
          <ac:spMkLst>
            <pc:docMk/>
            <pc:sldMk cId="2250381105" sldId="341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08.386" v="2549" actId="20577"/>
        <pc:sldMkLst>
          <pc:docMk/>
          <pc:sldMk cId="3299340242" sldId="342"/>
        </pc:sldMkLst>
        <pc:spChg chg="mod">
          <ac:chgData name="hayato kawachi" userId="3d62671f137ab6e0" providerId="LiveId" clId="{5CF36E05-258C-4848-8869-4B99D6BFFBDB}" dt="2021-12-26T03:15:08.386" v="2549" actId="20577"/>
          <ac:spMkLst>
            <pc:docMk/>
            <pc:sldMk cId="3299340242" sldId="342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2:11.093" v="733" actId="20577"/>
          <ac:spMkLst>
            <pc:docMk/>
            <pc:sldMk cId="3299340242" sldId="342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2:02.335" v="715" actId="20577"/>
          <ac:spMkLst>
            <pc:docMk/>
            <pc:sldMk cId="3299340242" sldId="342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17.692" v="2553" actId="20577"/>
        <pc:sldMkLst>
          <pc:docMk/>
          <pc:sldMk cId="443460557" sldId="343"/>
        </pc:sldMkLst>
        <pc:spChg chg="mod">
          <ac:chgData name="hayato kawachi" userId="3d62671f137ab6e0" providerId="LiveId" clId="{5CF36E05-258C-4848-8869-4B99D6BFFBDB}" dt="2021-12-26T03:15:17.692" v="2553" actId="20577"/>
          <ac:spMkLst>
            <pc:docMk/>
            <pc:sldMk cId="443460557" sldId="343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2:53.134" v="751" actId="20577"/>
          <ac:spMkLst>
            <pc:docMk/>
            <pc:sldMk cId="443460557" sldId="343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3:00.885" v="762" actId="20577"/>
          <ac:spMkLst>
            <pc:docMk/>
            <pc:sldMk cId="443460557" sldId="343"/>
            <ac:spMk id="53" creationId="{1FB50F88-B6D0-4B32-83D0-D60F6E12E6F7}"/>
          </ac:spMkLst>
        </pc:spChg>
      </pc:sldChg>
      <pc:sldChg chg="modSp mod modShow">
        <pc:chgData name="hayato kawachi" userId="3d62671f137ab6e0" providerId="LiveId" clId="{5CF36E05-258C-4848-8869-4B99D6BFFBDB}" dt="2021-12-22T15:03:38.683" v="811" actId="20577"/>
        <pc:sldMkLst>
          <pc:docMk/>
          <pc:sldMk cId="3856532166" sldId="344"/>
        </pc:sldMkLst>
        <pc:spChg chg="mod">
          <ac:chgData name="hayato kawachi" userId="3d62671f137ab6e0" providerId="LiveId" clId="{5CF36E05-258C-4848-8869-4B99D6BFFBDB}" dt="2021-12-22T15:03:30.559" v="801" actId="20577"/>
          <ac:spMkLst>
            <pc:docMk/>
            <pc:sldMk cId="3856532166" sldId="344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3:38.683" v="811" actId="20577"/>
          <ac:spMkLst>
            <pc:docMk/>
            <pc:sldMk cId="3856532166" sldId="344"/>
            <ac:spMk id="53" creationId="{1FB50F88-B6D0-4B32-83D0-D60F6E12E6F7}"/>
          </ac:spMkLst>
        </pc:spChg>
      </pc:sldChg>
      <pc:sldChg chg="modSp mod modShow">
        <pc:chgData name="hayato kawachi" userId="3d62671f137ab6e0" providerId="LiveId" clId="{5CF36E05-258C-4848-8869-4B99D6BFFBDB}" dt="2021-12-22T15:03:56.661" v="839" actId="20577"/>
        <pc:sldMkLst>
          <pc:docMk/>
          <pc:sldMk cId="1102546100" sldId="345"/>
        </pc:sldMkLst>
        <pc:spChg chg="mod">
          <ac:chgData name="hayato kawachi" userId="3d62671f137ab6e0" providerId="LiveId" clId="{5CF36E05-258C-4848-8869-4B99D6BFFBDB}" dt="2021-12-22T15:03:48.243" v="829" actId="20577"/>
          <ac:spMkLst>
            <pc:docMk/>
            <pc:sldMk cId="1102546100" sldId="345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3:56.661" v="839" actId="20577"/>
          <ac:spMkLst>
            <pc:docMk/>
            <pc:sldMk cId="1102546100" sldId="345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30.993" v="2561" actId="20577"/>
        <pc:sldMkLst>
          <pc:docMk/>
          <pc:sldMk cId="2593710206" sldId="346"/>
        </pc:sldMkLst>
        <pc:spChg chg="mod">
          <ac:chgData name="hayato kawachi" userId="3d62671f137ab6e0" providerId="LiveId" clId="{5CF36E05-258C-4848-8869-4B99D6BFFBDB}" dt="2021-12-26T03:15:30.993" v="2561" actId="20577"/>
          <ac:spMkLst>
            <pc:docMk/>
            <pc:sldMk cId="2593710206" sldId="346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4:06.449" v="849" actId="20577"/>
          <ac:spMkLst>
            <pc:docMk/>
            <pc:sldMk cId="2593710206" sldId="346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04:12.948" v="859" actId="20577"/>
          <ac:spMkLst>
            <pc:docMk/>
            <pc:sldMk cId="2593710206" sldId="346"/>
            <ac:spMk id="53" creationId="{1FB50F88-B6D0-4B32-83D0-D60F6E12E6F7}"/>
          </ac:spMkLst>
        </pc:spChg>
      </pc:sldChg>
      <pc:sldChg chg="modSp mod">
        <pc:chgData name="hayato kawachi" userId="3d62671f137ab6e0" providerId="LiveId" clId="{5CF36E05-258C-4848-8869-4B99D6BFFBDB}" dt="2021-12-26T03:15:35.629" v="2565" actId="20577"/>
        <pc:sldMkLst>
          <pc:docMk/>
          <pc:sldMk cId="2662816316" sldId="349"/>
        </pc:sldMkLst>
        <pc:spChg chg="mod">
          <ac:chgData name="hayato kawachi" userId="3d62671f137ab6e0" providerId="LiveId" clId="{5CF36E05-258C-4848-8869-4B99D6BFFBDB}" dt="2021-12-26T03:15:35.629" v="2565" actId="20577"/>
          <ac:spMkLst>
            <pc:docMk/>
            <pc:sldMk cId="2662816316" sldId="349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4:23.223" v="869" actId="20577"/>
          <ac:spMkLst>
            <pc:docMk/>
            <pc:sldMk cId="2662816316" sldId="349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4:49:55.053" v="512" actId="1076"/>
          <ac:spMkLst>
            <pc:docMk/>
            <pc:sldMk cId="2662816316" sldId="349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2T14:49:53.054" v="511" actId="1076"/>
          <ac:spMkLst>
            <pc:docMk/>
            <pc:sldMk cId="2662816316" sldId="349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2T15:04:31.943" v="885" actId="20577"/>
          <ac:spMkLst>
            <pc:docMk/>
            <pc:sldMk cId="2662816316" sldId="349"/>
            <ac:spMk id="53" creationId="{1FB50F88-B6D0-4B32-83D0-D60F6E12E6F7}"/>
          </ac:spMkLst>
        </pc:spChg>
      </pc:sldChg>
      <pc:sldChg chg="addSp delSp modSp add mod modShow">
        <pc:chgData name="hayato kawachi" userId="3d62671f137ab6e0" providerId="LiveId" clId="{5CF36E05-258C-4848-8869-4B99D6BFFBDB}" dt="2021-12-26T03:15:22.368" v="2557" actId="20577"/>
        <pc:sldMkLst>
          <pc:docMk/>
          <pc:sldMk cId="2156233869" sldId="350"/>
        </pc:sldMkLst>
        <pc:spChg chg="mod">
          <ac:chgData name="hayato kawachi" userId="3d62671f137ab6e0" providerId="LiveId" clId="{5CF36E05-258C-4848-8869-4B99D6BFFBDB}" dt="2021-12-26T03:15:22.368" v="2557" actId="20577"/>
          <ac:spMkLst>
            <pc:docMk/>
            <pc:sldMk cId="2156233869" sldId="350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08:59.257" v="1059" actId="20577"/>
          <ac:spMkLst>
            <pc:docMk/>
            <pc:sldMk cId="2156233869" sldId="350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2T15:12:08.056" v="1114" actId="20577"/>
          <ac:spMkLst>
            <pc:docMk/>
            <pc:sldMk cId="2156233869" sldId="350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10:25.618" v="1088" actId="1076"/>
          <ac:spMkLst>
            <pc:docMk/>
            <pc:sldMk cId="2156233869" sldId="350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2T15:09:55.687" v="1072" actId="20577"/>
          <ac:spMkLst>
            <pc:docMk/>
            <pc:sldMk cId="2156233869" sldId="350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2T15:10:02.061" v="1077" actId="20577"/>
          <ac:spMkLst>
            <pc:docMk/>
            <pc:sldMk cId="2156233869" sldId="350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2T15:12:01.659" v="1111" actId="20577"/>
          <ac:spMkLst>
            <pc:docMk/>
            <pc:sldMk cId="2156233869" sldId="350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2T15:03:19.725" v="783" actId="20577"/>
          <ac:spMkLst>
            <pc:docMk/>
            <pc:sldMk cId="2156233869" sldId="350"/>
            <ac:spMk id="53" creationId="{1FB50F88-B6D0-4B32-83D0-D60F6E12E6F7}"/>
          </ac:spMkLst>
        </pc:spChg>
        <pc:spChg chg="mod">
          <ac:chgData name="hayato kawachi" userId="3d62671f137ab6e0" providerId="LiveId" clId="{5CF36E05-258C-4848-8869-4B99D6BFFBDB}" dt="2021-12-22T15:12:13.161" v="1116" actId="20577"/>
          <ac:spMkLst>
            <pc:docMk/>
            <pc:sldMk cId="2156233869" sldId="350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12:18.987" v="1118" actId="20577"/>
          <ac:spMkLst>
            <pc:docMk/>
            <pc:sldMk cId="2156233869" sldId="350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11:43.534" v="1104" actId="20577"/>
          <ac:spMkLst>
            <pc:docMk/>
            <pc:sldMk cId="2156233869" sldId="350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11:48.169" v="1106" actId="20577"/>
          <ac:spMkLst>
            <pc:docMk/>
            <pc:sldMk cId="2156233869" sldId="350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2T15:11:53.923" v="1108" actId="20577"/>
          <ac:spMkLst>
            <pc:docMk/>
            <pc:sldMk cId="2156233869" sldId="350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2T15:10:39.969" v="1089" actId="1038"/>
          <ac:picMkLst>
            <pc:docMk/>
            <pc:sldMk cId="2156233869" sldId="350"/>
            <ac:picMk id="5" creationId="{6BB18009-FA95-4289-99B7-A1930EEA8B0E}"/>
          </ac:picMkLst>
        </pc:picChg>
        <pc:picChg chg="del">
          <ac:chgData name="hayato kawachi" userId="3d62671f137ab6e0" providerId="LiveId" clId="{5CF36E05-258C-4848-8869-4B99D6BFFBDB}" dt="2021-12-22T15:07:53.954" v="1011" actId="478"/>
          <ac:picMkLst>
            <pc:docMk/>
            <pc:sldMk cId="2156233869" sldId="350"/>
            <ac:picMk id="6" creationId="{C6E8E2CB-84A0-463B-B53B-FDB893147839}"/>
          </ac:picMkLst>
        </pc:picChg>
      </pc:sldChg>
      <pc:sldChg chg="addSp new del mod">
        <pc:chgData name="hayato kawachi" userId="3d62671f137ab6e0" providerId="LiveId" clId="{5CF36E05-258C-4848-8869-4B99D6BFFBDB}" dt="2021-12-22T14:11:41.666" v="193" actId="47"/>
        <pc:sldMkLst>
          <pc:docMk/>
          <pc:sldMk cId="2899817354" sldId="350"/>
        </pc:sldMkLst>
        <pc:picChg chg="add">
          <ac:chgData name="hayato kawachi" userId="3d62671f137ab6e0" providerId="LiveId" clId="{5CF36E05-258C-4848-8869-4B99D6BFFBDB}" dt="2021-12-22T14:11:10.007" v="172" actId="22"/>
          <ac:picMkLst>
            <pc:docMk/>
            <pc:sldMk cId="2899817354" sldId="350"/>
            <ac:picMk id="3" creationId="{67A44C20-FD0C-4165-A434-4E0ABF070985}"/>
          </ac:picMkLst>
        </pc:picChg>
      </pc:sldChg>
      <pc:sldChg chg="addSp new del mod">
        <pc:chgData name="hayato kawachi" userId="3d62671f137ab6e0" providerId="LiveId" clId="{5CF36E05-258C-4848-8869-4B99D6BFFBDB}" dt="2021-12-22T14:22:59.028" v="311" actId="47"/>
        <pc:sldMkLst>
          <pc:docMk/>
          <pc:sldMk cId="3029527373" sldId="350"/>
        </pc:sldMkLst>
        <pc:picChg chg="add">
          <ac:chgData name="hayato kawachi" userId="3d62671f137ab6e0" providerId="LiveId" clId="{5CF36E05-258C-4848-8869-4B99D6BFFBDB}" dt="2021-12-22T14:22:32.532" v="290" actId="22"/>
          <ac:picMkLst>
            <pc:docMk/>
            <pc:sldMk cId="3029527373" sldId="350"/>
            <ac:picMk id="3" creationId="{5BD4D37B-DF98-47C9-B7DD-DABA1C928C45}"/>
          </ac:picMkLst>
        </pc:picChg>
      </pc:sldChg>
      <pc:sldChg chg="addSp new del mod">
        <pc:chgData name="hayato kawachi" userId="3d62671f137ab6e0" providerId="LiveId" clId="{5CF36E05-258C-4848-8869-4B99D6BFFBDB}" dt="2021-12-22T14:42:52.238" v="475" actId="47"/>
        <pc:sldMkLst>
          <pc:docMk/>
          <pc:sldMk cId="3397096905" sldId="350"/>
        </pc:sldMkLst>
        <pc:picChg chg="add">
          <ac:chgData name="hayato kawachi" userId="3d62671f137ab6e0" providerId="LiveId" clId="{5CF36E05-258C-4848-8869-4B99D6BFFBDB}" dt="2021-12-22T14:37:53.412" v="374" actId="22"/>
          <ac:picMkLst>
            <pc:docMk/>
            <pc:sldMk cId="3397096905" sldId="350"/>
            <ac:picMk id="3" creationId="{57587C56-1E0F-431F-9715-E5BE96112324}"/>
          </ac:picMkLst>
        </pc:picChg>
      </pc:sldChg>
      <pc:sldChg chg="addSp delSp modSp add mod">
        <pc:chgData name="hayato kawachi" userId="3d62671f137ab6e0" providerId="LiveId" clId="{5CF36E05-258C-4848-8869-4B99D6BFFBDB}" dt="2021-12-26T03:15:57.292" v="2575" actId="20577"/>
        <pc:sldMkLst>
          <pc:docMk/>
          <pc:sldMk cId="172265969" sldId="351"/>
        </pc:sldMkLst>
        <pc:spChg chg="mod">
          <ac:chgData name="hayato kawachi" userId="3d62671f137ab6e0" providerId="LiveId" clId="{5CF36E05-258C-4848-8869-4B99D6BFFBDB}" dt="2021-12-26T03:15:57.292" v="2575" actId="20577"/>
          <ac:spMkLst>
            <pc:docMk/>
            <pc:sldMk cId="172265969" sldId="351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01:41.256" v="1222" actId="20577"/>
          <ac:spMkLst>
            <pc:docMk/>
            <pc:sldMk cId="172265969" sldId="351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3:04:21.137" v="1276" actId="20577"/>
          <ac:spMkLst>
            <pc:docMk/>
            <pc:sldMk cId="172265969" sldId="351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02:58.862" v="1253" actId="1076"/>
          <ac:spMkLst>
            <pc:docMk/>
            <pc:sldMk cId="172265969" sldId="351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3:02:32.279" v="1238" actId="20577"/>
          <ac:spMkLst>
            <pc:docMk/>
            <pc:sldMk cId="172265969" sldId="351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3:01:57.679" v="1229" actId="20577"/>
          <ac:spMkLst>
            <pc:docMk/>
            <pc:sldMk cId="172265969" sldId="351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3:03:59.926" v="1268" actId="20577"/>
          <ac:spMkLst>
            <pc:docMk/>
            <pc:sldMk cId="172265969" sldId="351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3:04:16.624" v="1272" actId="20577"/>
          <ac:spMkLst>
            <pc:docMk/>
            <pc:sldMk cId="172265969" sldId="351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3:04:25.447" v="1278" actId="20577"/>
          <ac:spMkLst>
            <pc:docMk/>
            <pc:sldMk cId="172265969" sldId="351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04:29.708" v="1280" actId="20577"/>
          <ac:spMkLst>
            <pc:docMk/>
            <pc:sldMk cId="172265969" sldId="351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04:34.052" v="1282" actId="20577"/>
          <ac:spMkLst>
            <pc:docMk/>
            <pc:sldMk cId="172265969" sldId="351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03:45.112" v="1266" actId="20577"/>
          <ac:spMkLst>
            <pc:docMk/>
            <pc:sldMk cId="172265969" sldId="351"/>
            <ac:spMk id="69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3T13:02:36.986" v="1240" actId="1076"/>
          <ac:picMkLst>
            <pc:docMk/>
            <pc:sldMk cId="172265969" sldId="351"/>
            <ac:picMk id="41" creationId="{8EBA1F41-EA5A-4DDE-972F-CCFDC8AE5282}"/>
          </ac:picMkLst>
        </pc:picChg>
        <pc:picChg chg="del">
          <ac:chgData name="hayato kawachi" userId="3d62671f137ab6e0" providerId="LiveId" clId="{5CF36E05-258C-4848-8869-4B99D6BFFBDB}" dt="2021-12-23T13:00:25.613" v="1158" actId="478"/>
          <ac:picMkLst>
            <pc:docMk/>
            <pc:sldMk cId="172265969" sldId="351"/>
            <ac:picMk id="46" creationId="{4666B752-A8CB-4FEF-86DC-F3629D28C7FB}"/>
          </ac:picMkLst>
        </pc:picChg>
      </pc:sldChg>
      <pc:sldChg chg="addSp new del mod">
        <pc:chgData name="hayato kawachi" userId="3d62671f137ab6e0" providerId="LiveId" clId="{5CF36E05-258C-4848-8869-4B99D6BFFBDB}" dt="2021-12-23T13:00:32.020" v="1181" actId="47"/>
        <pc:sldMkLst>
          <pc:docMk/>
          <pc:sldMk cId="1212028077" sldId="352"/>
        </pc:sldMkLst>
        <pc:picChg chg="add">
          <ac:chgData name="hayato kawachi" userId="3d62671f137ab6e0" providerId="LiveId" clId="{5CF36E05-258C-4848-8869-4B99D6BFFBDB}" dt="2021-12-23T13:00:03.591" v="1154" actId="22"/>
          <ac:picMkLst>
            <pc:docMk/>
            <pc:sldMk cId="1212028077" sldId="352"/>
            <ac:picMk id="3" creationId="{4DC85F3A-2C29-406F-A967-F1DB6C9298EB}"/>
          </ac:picMkLst>
        </pc:picChg>
      </pc:sldChg>
      <pc:sldChg chg="addSp delSp modSp add mod">
        <pc:chgData name="hayato kawachi" userId="3d62671f137ab6e0" providerId="LiveId" clId="{5CF36E05-258C-4848-8869-4B99D6BFFBDB}" dt="2021-12-26T03:16:01.947" v="2578" actId="20577"/>
        <pc:sldMkLst>
          <pc:docMk/>
          <pc:sldMk cId="1499476744" sldId="352"/>
        </pc:sldMkLst>
        <pc:spChg chg="mod">
          <ac:chgData name="hayato kawachi" userId="3d62671f137ab6e0" providerId="LiveId" clId="{5CF36E05-258C-4848-8869-4B99D6BFFBDB}" dt="2021-12-26T03:16:01.947" v="2578" actId="20577"/>
          <ac:spMkLst>
            <pc:docMk/>
            <pc:sldMk cId="1499476744" sldId="352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25:46.668" v="1365" actId="20577"/>
          <ac:spMkLst>
            <pc:docMk/>
            <pc:sldMk cId="1499476744" sldId="352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3:28:06.010" v="1433" actId="20577"/>
          <ac:spMkLst>
            <pc:docMk/>
            <pc:sldMk cId="1499476744" sldId="352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27:09.863" v="1403" actId="20577"/>
          <ac:spMkLst>
            <pc:docMk/>
            <pc:sldMk cId="1499476744" sldId="352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3:26:49.569" v="1392" actId="20577"/>
          <ac:spMkLst>
            <pc:docMk/>
            <pc:sldMk cId="1499476744" sldId="352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3:26:15.114" v="1379" actId="20577"/>
          <ac:spMkLst>
            <pc:docMk/>
            <pc:sldMk cId="1499476744" sldId="352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3:28:26.456" v="1449" actId="20577"/>
          <ac:spMkLst>
            <pc:docMk/>
            <pc:sldMk cId="1499476744" sldId="352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3:28:30.131" v="1451" actId="20577"/>
          <ac:spMkLst>
            <pc:docMk/>
            <pc:sldMk cId="1499476744" sldId="352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3T13:27:56.250" v="1429" actId="20577"/>
          <ac:spMkLst>
            <pc:docMk/>
            <pc:sldMk cId="1499476744" sldId="352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3:28:10.183" v="1435" actId="20577"/>
          <ac:spMkLst>
            <pc:docMk/>
            <pc:sldMk cId="1499476744" sldId="352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28:16.650" v="1443" actId="20577"/>
          <ac:spMkLst>
            <pc:docMk/>
            <pc:sldMk cId="1499476744" sldId="352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28:21.564" v="1445" actId="20577"/>
          <ac:spMkLst>
            <pc:docMk/>
            <pc:sldMk cId="1499476744" sldId="352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28:24.348" v="1447" actId="20577"/>
          <ac:spMkLst>
            <pc:docMk/>
            <pc:sldMk cId="1499476744" sldId="352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28:32.305" v="1453" actId="20577"/>
          <ac:spMkLst>
            <pc:docMk/>
            <pc:sldMk cId="1499476744" sldId="352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3T13:25:27.621" v="1354" actId="1036"/>
          <ac:picMkLst>
            <pc:docMk/>
            <pc:sldMk cId="1499476744" sldId="352"/>
            <ac:picMk id="5" creationId="{18EC68DF-9E99-4706-96CB-59B7F53972D9}"/>
          </ac:picMkLst>
        </pc:picChg>
        <pc:picChg chg="del">
          <ac:chgData name="hayato kawachi" userId="3d62671f137ab6e0" providerId="LiveId" clId="{5CF36E05-258C-4848-8869-4B99D6BFFBDB}" dt="2021-12-23T13:23:58.663" v="1306" actId="478"/>
          <ac:picMkLst>
            <pc:docMk/>
            <pc:sldMk cId="1499476744" sldId="352"/>
            <ac:picMk id="41" creationId="{8EBA1F41-EA5A-4DDE-972F-CCFDC8AE5282}"/>
          </ac:picMkLst>
        </pc:picChg>
        <pc:picChg chg="add del mod ord">
          <ac:chgData name="hayato kawachi" userId="3d62671f137ab6e0" providerId="LiveId" clId="{5CF36E05-258C-4848-8869-4B99D6BFFBDB}" dt="2021-12-23T13:25:12.867" v="1339" actId="478"/>
          <ac:picMkLst>
            <pc:docMk/>
            <pc:sldMk cId="1499476744" sldId="352"/>
            <ac:picMk id="46" creationId="{30E47C45-722C-4060-9511-769CA2A4CB5E}"/>
          </ac:picMkLst>
        </pc:picChg>
      </pc:sldChg>
      <pc:sldChg chg="add del">
        <pc:chgData name="hayato kawachi" userId="3d62671f137ab6e0" providerId="LiveId" clId="{5CF36E05-258C-4848-8869-4B99D6BFFBDB}" dt="2021-12-23T12:56:03.274" v="1150"/>
        <pc:sldMkLst>
          <pc:docMk/>
          <pc:sldMk cId="2094717849" sldId="352"/>
        </pc:sldMkLst>
      </pc:sldChg>
      <pc:sldChg chg="add del">
        <pc:chgData name="hayato kawachi" userId="3d62671f137ab6e0" providerId="LiveId" clId="{5CF36E05-258C-4848-8869-4B99D6BFFBDB}" dt="2021-12-23T13:01:27.455" v="1213" actId="47"/>
        <pc:sldMkLst>
          <pc:docMk/>
          <pc:sldMk cId="4126971887" sldId="352"/>
        </pc:sldMkLst>
      </pc:sldChg>
      <pc:sldChg chg="addSp delSp new del mod">
        <pc:chgData name="hayato kawachi" userId="3d62671f137ab6e0" providerId="LiveId" clId="{5CF36E05-258C-4848-8869-4B99D6BFFBDB}" dt="2021-12-23T13:28:52.268" v="1454" actId="47"/>
        <pc:sldMkLst>
          <pc:docMk/>
          <pc:sldMk cId="711481985" sldId="353"/>
        </pc:sldMkLst>
        <pc:picChg chg="add del">
          <ac:chgData name="hayato kawachi" userId="3d62671f137ab6e0" providerId="LiveId" clId="{5CF36E05-258C-4848-8869-4B99D6BFFBDB}" dt="2021-12-23T13:23:06.838" v="1301" actId="478"/>
          <ac:picMkLst>
            <pc:docMk/>
            <pc:sldMk cId="711481985" sldId="353"/>
            <ac:picMk id="3" creationId="{C5CEB7B8-97AC-4683-98FF-33C25B0D9ACF}"/>
          </ac:picMkLst>
        </pc:picChg>
        <pc:picChg chg="add">
          <ac:chgData name="hayato kawachi" userId="3d62671f137ab6e0" providerId="LiveId" clId="{5CF36E05-258C-4848-8869-4B99D6BFFBDB}" dt="2021-12-23T13:23:39.546" v="1302" actId="22"/>
          <ac:picMkLst>
            <pc:docMk/>
            <pc:sldMk cId="711481985" sldId="353"/>
            <ac:picMk id="5" creationId="{97680E46-BB1B-4400-87B5-8BC47EFA5C0F}"/>
          </ac:picMkLst>
        </pc:picChg>
      </pc:sldChg>
      <pc:sldChg chg="addSp delSp modSp add mod">
        <pc:chgData name="hayato kawachi" userId="3d62671f137ab6e0" providerId="LiveId" clId="{5CF36E05-258C-4848-8869-4B99D6BFFBDB}" dt="2021-12-26T03:16:18.079" v="2589" actId="20577"/>
        <pc:sldMkLst>
          <pc:docMk/>
          <pc:sldMk cId="1026820759" sldId="353"/>
        </pc:sldMkLst>
        <pc:spChg chg="mod">
          <ac:chgData name="hayato kawachi" userId="3d62671f137ab6e0" providerId="LiveId" clId="{5CF36E05-258C-4848-8869-4B99D6BFFBDB}" dt="2021-12-26T03:16:18.079" v="2589" actId="20577"/>
          <ac:spMkLst>
            <pc:docMk/>
            <pc:sldMk cId="1026820759" sldId="353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35:58.347" v="1577"/>
          <ac:spMkLst>
            <pc:docMk/>
            <pc:sldMk cId="1026820759" sldId="353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3:38:06.179" v="1625" actId="20577"/>
          <ac:spMkLst>
            <pc:docMk/>
            <pc:sldMk cId="1026820759" sldId="353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36:26.558" v="1584" actId="20577"/>
          <ac:spMkLst>
            <pc:docMk/>
            <pc:sldMk cId="1026820759" sldId="353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3:36:40.686" v="1598" actId="20577"/>
          <ac:spMkLst>
            <pc:docMk/>
            <pc:sldMk cId="1026820759" sldId="353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3:34:56.628" v="1514" actId="20577"/>
          <ac:spMkLst>
            <pc:docMk/>
            <pc:sldMk cId="1026820759" sldId="353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3:38:24.661" v="1635" actId="20577"/>
          <ac:spMkLst>
            <pc:docMk/>
            <pc:sldMk cId="1026820759" sldId="353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3:38:27.994" v="1639" actId="20577"/>
          <ac:spMkLst>
            <pc:docMk/>
            <pc:sldMk cId="1026820759" sldId="353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3T13:38:01.838" v="1622" actId="20577"/>
          <ac:spMkLst>
            <pc:docMk/>
            <pc:sldMk cId="1026820759" sldId="353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3:38:10.052" v="1627" actId="20577"/>
          <ac:spMkLst>
            <pc:docMk/>
            <pc:sldMk cId="1026820759" sldId="353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38:14.705" v="1629" actId="20577"/>
          <ac:spMkLst>
            <pc:docMk/>
            <pc:sldMk cId="1026820759" sldId="353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38:19.702" v="1631" actId="20577"/>
          <ac:spMkLst>
            <pc:docMk/>
            <pc:sldMk cId="1026820759" sldId="353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38:21.931" v="1633" actId="20577"/>
          <ac:spMkLst>
            <pc:docMk/>
            <pc:sldMk cId="1026820759" sldId="353"/>
            <ac:spMk id="69" creationId="{00000000-0000-0000-0000-000000000000}"/>
          </ac:spMkLst>
        </pc:spChg>
        <pc:picChg chg="add del">
          <ac:chgData name="hayato kawachi" userId="3d62671f137ab6e0" providerId="LiveId" clId="{5CF36E05-258C-4848-8869-4B99D6BFFBDB}" dt="2021-12-23T13:35:03.023" v="1516" actId="22"/>
          <ac:picMkLst>
            <pc:docMk/>
            <pc:sldMk cId="1026820759" sldId="353"/>
            <ac:picMk id="5" creationId="{73121F9B-2045-4B8E-A327-5B974F2F23D2}"/>
          </ac:picMkLst>
        </pc:picChg>
        <pc:picChg chg="add mod ord">
          <ac:chgData name="hayato kawachi" userId="3d62671f137ab6e0" providerId="LiveId" clId="{5CF36E05-258C-4848-8869-4B99D6BFFBDB}" dt="2021-12-23T13:35:34.757" v="1547" actId="1036"/>
          <ac:picMkLst>
            <pc:docMk/>
            <pc:sldMk cId="1026820759" sldId="353"/>
            <ac:picMk id="7" creationId="{43F46AED-C255-499C-9B3C-8562855C95A5}"/>
          </ac:picMkLst>
        </pc:picChg>
        <pc:picChg chg="del">
          <ac:chgData name="hayato kawachi" userId="3d62671f137ab6e0" providerId="LiveId" clId="{5CF36E05-258C-4848-8869-4B99D6BFFBDB}" dt="2021-12-23T13:35:20.643" v="1521" actId="478"/>
          <ac:picMkLst>
            <pc:docMk/>
            <pc:sldMk cId="1026820759" sldId="353"/>
            <ac:picMk id="41" creationId="{8EBA1F41-EA5A-4DDE-972F-CCFDC8AE5282}"/>
          </ac:picMkLst>
        </pc:picChg>
      </pc:sldChg>
      <pc:sldChg chg="modSp add mod">
        <pc:chgData name="hayato kawachi" userId="3d62671f137ab6e0" providerId="LiveId" clId="{5CF36E05-258C-4848-8869-4B99D6BFFBDB}" dt="2021-12-23T13:32:18.227" v="1458" actId="20577"/>
        <pc:sldMkLst>
          <pc:docMk/>
          <pc:sldMk cId="1332074407" sldId="354"/>
        </pc:sldMkLst>
        <pc:spChg chg="mod">
          <ac:chgData name="hayato kawachi" userId="3d62671f137ab6e0" providerId="LiveId" clId="{5CF36E05-258C-4848-8869-4B99D6BFFBDB}" dt="2021-12-23T13:32:18.227" v="1458" actId="20577"/>
          <ac:spMkLst>
            <pc:docMk/>
            <pc:sldMk cId="1332074407" sldId="354"/>
            <ac:spMk id="2" creationId="{FE0D19BB-235A-44AB-A32F-F610D8B3FF1B}"/>
          </ac:spMkLst>
        </pc:spChg>
      </pc:sldChg>
      <pc:sldChg chg="addSp delSp modSp add mod">
        <pc:chgData name="hayato kawachi" userId="3d62671f137ab6e0" providerId="LiveId" clId="{5CF36E05-258C-4848-8869-4B99D6BFFBDB}" dt="2021-12-26T03:16:06.734" v="2583" actId="20577"/>
        <pc:sldMkLst>
          <pc:docMk/>
          <pc:sldMk cId="2896192238" sldId="355"/>
        </pc:sldMkLst>
        <pc:spChg chg="mod">
          <ac:chgData name="hayato kawachi" userId="3d62671f137ab6e0" providerId="LiveId" clId="{5CF36E05-258C-4848-8869-4B99D6BFFBDB}" dt="2021-12-26T03:16:06.734" v="2583" actId="20577"/>
          <ac:spMkLst>
            <pc:docMk/>
            <pc:sldMk cId="2896192238" sldId="355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07:04.558" v="2332" actId="20577"/>
          <ac:spMkLst>
            <pc:docMk/>
            <pc:sldMk cId="2896192238" sldId="355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6T03:10:03.257" v="2418" actId="20577"/>
          <ac:spMkLst>
            <pc:docMk/>
            <pc:sldMk cId="2896192238" sldId="355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08:43.546" v="2373" actId="20577"/>
          <ac:spMkLst>
            <pc:docMk/>
            <pc:sldMk cId="2896192238" sldId="355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6T03:09:00.034" v="2382" actId="20577"/>
          <ac:spMkLst>
            <pc:docMk/>
            <pc:sldMk cId="2896192238" sldId="355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6T03:07:15.226" v="2338" actId="20577"/>
          <ac:spMkLst>
            <pc:docMk/>
            <pc:sldMk cId="2896192238" sldId="355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6T03:09:43.194" v="2406" actId="20577"/>
          <ac:spMkLst>
            <pc:docMk/>
            <pc:sldMk cId="2896192238" sldId="355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6T03:09:47.195" v="2408" actId="20577"/>
          <ac:spMkLst>
            <pc:docMk/>
            <pc:sldMk cId="2896192238" sldId="355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6T03:09:59.637" v="2414" actId="20577"/>
          <ac:spMkLst>
            <pc:docMk/>
            <pc:sldMk cId="2896192238" sldId="355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6T03:10:06.460" v="2420" actId="20577"/>
          <ac:spMkLst>
            <pc:docMk/>
            <pc:sldMk cId="2896192238" sldId="355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0:09.470" v="2422" actId="20577"/>
          <ac:spMkLst>
            <pc:docMk/>
            <pc:sldMk cId="2896192238" sldId="355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0:13.403" v="2424" actId="20577"/>
          <ac:spMkLst>
            <pc:docMk/>
            <pc:sldMk cId="2896192238" sldId="355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09:39.367" v="2404" actId="20577"/>
          <ac:spMkLst>
            <pc:docMk/>
            <pc:sldMk cId="2896192238" sldId="355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09:50.233" v="2410" actId="20577"/>
          <ac:spMkLst>
            <pc:docMk/>
            <pc:sldMk cId="2896192238" sldId="355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6T03:08:09.087" v="2362" actId="1036"/>
          <ac:picMkLst>
            <pc:docMk/>
            <pc:sldMk cId="2896192238" sldId="355"/>
            <ac:picMk id="5" creationId="{A828B1E4-5332-4096-8A47-F254A3F53FF0}"/>
          </ac:picMkLst>
        </pc:picChg>
        <pc:picChg chg="del">
          <ac:chgData name="hayato kawachi" userId="3d62671f137ab6e0" providerId="LiveId" clId="{5CF36E05-258C-4848-8869-4B99D6BFFBDB}" dt="2021-12-26T03:07:54.372" v="2342" actId="478"/>
          <ac:picMkLst>
            <pc:docMk/>
            <pc:sldMk cId="2896192238" sldId="355"/>
            <ac:picMk id="41" creationId="{8EBA1F41-EA5A-4DDE-972F-CCFDC8AE5282}"/>
          </ac:picMkLst>
        </pc:picChg>
      </pc:sldChg>
      <pc:sldChg chg="addSp delSp modSp add mod">
        <pc:chgData name="hayato kawachi" userId="3d62671f137ab6e0" providerId="LiveId" clId="{5CF36E05-258C-4848-8869-4B99D6BFFBDB}" dt="2021-12-26T03:16:10.738" v="2586" actId="20577"/>
        <pc:sldMkLst>
          <pc:docMk/>
          <pc:sldMk cId="210894258" sldId="356"/>
        </pc:sldMkLst>
        <pc:spChg chg="mod">
          <ac:chgData name="hayato kawachi" userId="3d62671f137ab6e0" providerId="LiveId" clId="{5CF36E05-258C-4848-8869-4B99D6BFFBDB}" dt="2021-12-26T03:16:10.738" v="2586" actId="20577"/>
          <ac:spMkLst>
            <pc:docMk/>
            <pc:sldMk cId="210894258" sldId="356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0:59.319" v="2436" actId="20577"/>
          <ac:spMkLst>
            <pc:docMk/>
            <pc:sldMk cId="210894258" sldId="356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6T03:13:33.636" v="2517" actId="20577"/>
          <ac:spMkLst>
            <pc:docMk/>
            <pc:sldMk cId="210894258" sldId="356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2:45.691" v="2479" actId="20577"/>
          <ac:spMkLst>
            <pc:docMk/>
            <pc:sldMk cId="210894258" sldId="356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6T03:12:28.460" v="2469" actId="20577"/>
          <ac:spMkLst>
            <pc:docMk/>
            <pc:sldMk cId="210894258" sldId="356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6T03:12:51.235" v="2484" actId="20577"/>
          <ac:spMkLst>
            <pc:docMk/>
            <pc:sldMk cId="210894258" sldId="356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6T03:13:45.558" v="2527" actId="20577"/>
          <ac:spMkLst>
            <pc:docMk/>
            <pc:sldMk cId="210894258" sldId="356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6T03:13:47.522" v="2529" actId="20577"/>
          <ac:spMkLst>
            <pc:docMk/>
            <pc:sldMk cId="210894258" sldId="356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6T03:13:27.786" v="2512" actId="20577"/>
          <ac:spMkLst>
            <pc:docMk/>
            <pc:sldMk cId="210894258" sldId="356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6T03:13:36.687" v="2519" actId="20577"/>
          <ac:spMkLst>
            <pc:docMk/>
            <pc:sldMk cId="210894258" sldId="356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3:39.889" v="2521" actId="20577"/>
          <ac:spMkLst>
            <pc:docMk/>
            <pc:sldMk cId="210894258" sldId="356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3:42.071" v="2523" actId="20577"/>
          <ac:spMkLst>
            <pc:docMk/>
            <pc:sldMk cId="210894258" sldId="356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3:43.823" v="2525" actId="20577"/>
          <ac:spMkLst>
            <pc:docMk/>
            <pc:sldMk cId="210894258" sldId="356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6T03:13:50.333" v="2531" actId="20577"/>
          <ac:spMkLst>
            <pc:docMk/>
            <pc:sldMk cId="210894258" sldId="356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6T03:11:53.060" v="2455" actId="1035"/>
          <ac:picMkLst>
            <pc:docMk/>
            <pc:sldMk cId="210894258" sldId="356"/>
            <ac:picMk id="5" creationId="{DF73B62A-308E-4AE6-A368-3A36C3127F3E}"/>
          </ac:picMkLst>
        </pc:picChg>
        <pc:picChg chg="del">
          <ac:chgData name="hayato kawachi" userId="3d62671f137ab6e0" providerId="LiveId" clId="{5CF36E05-258C-4848-8869-4B99D6BFFBDB}" dt="2021-12-26T03:11:43.507" v="2440" actId="478"/>
          <ac:picMkLst>
            <pc:docMk/>
            <pc:sldMk cId="210894258" sldId="356"/>
            <ac:picMk id="41" creationId="{8EBA1F41-EA5A-4DDE-972F-CCFDC8AE5282}"/>
          </ac:picMkLst>
        </pc:picChg>
      </pc:sldChg>
      <pc:sldChg chg="addSp delSp modSp add mod">
        <pc:chgData name="hayato kawachi" userId="3d62671f137ab6e0" providerId="LiveId" clId="{5CF36E05-258C-4848-8869-4B99D6BFFBDB}" dt="2021-12-26T03:16:22.425" v="2592" actId="20577"/>
        <pc:sldMkLst>
          <pc:docMk/>
          <pc:sldMk cId="3831984843" sldId="357"/>
        </pc:sldMkLst>
        <pc:spChg chg="mod">
          <ac:chgData name="hayato kawachi" userId="3d62671f137ab6e0" providerId="LiveId" clId="{5CF36E05-258C-4848-8869-4B99D6BFFBDB}" dt="2021-12-26T03:16:22.425" v="2592" actId="20577"/>
          <ac:spMkLst>
            <pc:docMk/>
            <pc:sldMk cId="3831984843" sldId="357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0:31.264" v="1679" actId="20577"/>
          <ac:spMkLst>
            <pc:docMk/>
            <pc:sldMk cId="3831984843" sldId="357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3:42:36.416" v="1744" actId="20577"/>
          <ac:spMkLst>
            <pc:docMk/>
            <pc:sldMk cId="3831984843" sldId="357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1:04.678" v="1695" actId="1076"/>
          <ac:spMkLst>
            <pc:docMk/>
            <pc:sldMk cId="3831984843" sldId="357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3:41:22.177" v="1707" actId="20577"/>
          <ac:spMkLst>
            <pc:docMk/>
            <pc:sldMk cId="3831984843" sldId="357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3:41:33.901" v="1712" actId="20577"/>
          <ac:spMkLst>
            <pc:docMk/>
            <pc:sldMk cId="3831984843" sldId="357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3:42:50.470" v="1754" actId="20577"/>
          <ac:spMkLst>
            <pc:docMk/>
            <pc:sldMk cId="3831984843" sldId="357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3:42:52.760" v="1756" actId="20577"/>
          <ac:spMkLst>
            <pc:docMk/>
            <pc:sldMk cId="3831984843" sldId="357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3T13:42:31.071" v="1741" actId="20577"/>
          <ac:spMkLst>
            <pc:docMk/>
            <pc:sldMk cId="3831984843" sldId="357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3:42:42.544" v="1746" actId="20577"/>
          <ac:spMkLst>
            <pc:docMk/>
            <pc:sldMk cId="3831984843" sldId="357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2:44.695" v="1748" actId="20577"/>
          <ac:spMkLst>
            <pc:docMk/>
            <pc:sldMk cId="3831984843" sldId="357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2:46.804" v="1750" actId="20577"/>
          <ac:spMkLst>
            <pc:docMk/>
            <pc:sldMk cId="3831984843" sldId="357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2:48.694" v="1752" actId="20577"/>
          <ac:spMkLst>
            <pc:docMk/>
            <pc:sldMk cId="3831984843" sldId="357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2:55.433" v="1758" actId="20577"/>
          <ac:spMkLst>
            <pc:docMk/>
            <pc:sldMk cId="3831984843" sldId="357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3T13:41:02.886" v="1694" actId="1076"/>
          <ac:picMkLst>
            <pc:docMk/>
            <pc:sldMk cId="3831984843" sldId="357"/>
            <ac:picMk id="5" creationId="{D2FDF793-1A5F-4952-9140-641CA350A7A2}"/>
          </ac:picMkLst>
        </pc:picChg>
        <pc:picChg chg="del">
          <ac:chgData name="hayato kawachi" userId="3d62671f137ab6e0" providerId="LiveId" clId="{5CF36E05-258C-4848-8869-4B99D6BFFBDB}" dt="2021-12-23T13:39:53.479" v="1644" actId="478"/>
          <ac:picMkLst>
            <pc:docMk/>
            <pc:sldMk cId="3831984843" sldId="357"/>
            <ac:picMk id="41" creationId="{8EBA1F41-EA5A-4DDE-972F-CCFDC8AE5282}"/>
          </ac:picMkLst>
        </pc:picChg>
      </pc:sldChg>
      <pc:sldChg chg="addSp delSp modSp add mod">
        <pc:chgData name="hayato kawachi" userId="3d62671f137ab6e0" providerId="LiveId" clId="{5CF36E05-258C-4848-8869-4B99D6BFFBDB}" dt="2021-12-26T03:16:26.348" v="2595" actId="20577"/>
        <pc:sldMkLst>
          <pc:docMk/>
          <pc:sldMk cId="25205361" sldId="358"/>
        </pc:sldMkLst>
        <pc:spChg chg="mod">
          <ac:chgData name="hayato kawachi" userId="3d62671f137ab6e0" providerId="LiveId" clId="{5CF36E05-258C-4848-8869-4B99D6BFFBDB}" dt="2021-12-26T03:16:26.348" v="2595" actId="20577"/>
          <ac:spMkLst>
            <pc:docMk/>
            <pc:sldMk cId="25205361" sldId="358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4:32.220" v="1768" actId="20577"/>
          <ac:spMkLst>
            <pc:docMk/>
            <pc:sldMk cId="25205361" sldId="358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3:48:22.004" v="1869" actId="20577"/>
          <ac:spMkLst>
            <pc:docMk/>
            <pc:sldMk cId="25205361" sldId="358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7:21.181" v="1834" actId="20577"/>
          <ac:spMkLst>
            <pc:docMk/>
            <pc:sldMk cId="25205361" sldId="358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3:46:57.337" v="1822" actId="20577"/>
          <ac:spMkLst>
            <pc:docMk/>
            <pc:sldMk cId="25205361" sldId="358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3:44:40.026" v="1776" actId="20577"/>
          <ac:spMkLst>
            <pc:docMk/>
            <pc:sldMk cId="25205361" sldId="358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3:48:37.843" v="1879" actId="20577"/>
          <ac:spMkLst>
            <pc:docMk/>
            <pc:sldMk cId="25205361" sldId="358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3:48:39.953" v="1881" actId="20577"/>
          <ac:spMkLst>
            <pc:docMk/>
            <pc:sldMk cId="25205361" sldId="358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3T13:48:18.678" v="1866" actId="20577"/>
          <ac:spMkLst>
            <pc:docMk/>
            <pc:sldMk cId="25205361" sldId="358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3:48:25.597" v="1871" actId="20577"/>
          <ac:spMkLst>
            <pc:docMk/>
            <pc:sldMk cId="25205361" sldId="358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8:28.637" v="1873" actId="20577"/>
          <ac:spMkLst>
            <pc:docMk/>
            <pc:sldMk cId="25205361" sldId="358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8:31.916" v="1875" actId="20577"/>
          <ac:spMkLst>
            <pc:docMk/>
            <pc:sldMk cId="25205361" sldId="358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8:35.462" v="1877" actId="20577"/>
          <ac:spMkLst>
            <pc:docMk/>
            <pc:sldMk cId="25205361" sldId="358"/>
            <ac:spMk id="69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48:41.867" v="1883" actId="20577"/>
          <ac:spMkLst>
            <pc:docMk/>
            <pc:sldMk cId="25205361" sldId="358"/>
            <ac:spMk id="73" creationId="{00000000-0000-0000-0000-000000000000}"/>
          </ac:spMkLst>
        </pc:spChg>
        <pc:picChg chg="add mod ord">
          <ac:chgData name="hayato kawachi" userId="3d62671f137ab6e0" providerId="LiveId" clId="{5CF36E05-258C-4848-8869-4B99D6BFFBDB}" dt="2021-12-23T13:46:43.165" v="1804" actId="1076"/>
          <ac:picMkLst>
            <pc:docMk/>
            <pc:sldMk cId="25205361" sldId="358"/>
            <ac:picMk id="5" creationId="{4EB44E74-319F-4D78-86FF-72AC37797709}"/>
          </ac:picMkLst>
        </pc:picChg>
        <pc:picChg chg="del">
          <ac:chgData name="hayato kawachi" userId="3d62671f137ab6e0" providerId="LiveId" clId="{5CF36E05-258C-4848-8869-4B99D6BFFBDB}" dt="2021-12-23T13:45:50.993" v="1781" actId="478"/>
          <ac:picMkLst>
            <pc:docMk/>
            <pc:sldMk cId="25205361" sldId="358"/>
            <ac:picMk id="41" creationId="{8EBA1F41-EA5A-4DDE-972F-CCFDC8AE5282}"/>
          </ac:picMkLst>
        </pc:picChg>
      </pc:sldChg>
      <pc:sldChg chg="addSp delSp modSp add mod">
        <pc:chgData name="hayato kawachi" userId="3d62671f137ab6e0" providerId="LiveId" clId="{5CF36E05-258C-4848-8869-4B99D6BFFBDB}" dt="2021-12-26T07:34:45.193" v="2647" actId="20577"/>
        <pc:sldMkLst>
          <pc:docMk/>
          <pc:sldMk cId="389173886" sldId="359"/>
        </pc:sldMkLst>
        <pc:spChg chg="mod">
          <ac:chgData name="hayato kawachi" userId="3d62671f137ab6e0" providerId="LiveId" clId="{5CF36E05-258C-4848-8869-4B99D6BFFBDB}" dt="2021-12-26T07:34:45.193" v="2647" actId="20577"/>
          <ac:spMkLst>
            <pc:docMk/>
            <pc:sldMk cId="389173886" sldId="359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52:07.622" v="1918" actId="20577"/>
          <ac:spMkLst>
            <pc:docMk/>
            <pc:sldMk cId="389173886" sldId="359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3:57:44.963" v="1993" actId="20577"/>
          <ac:spMkLst>
            <pc:docMk/>
            <pc:sldMk cId="389173886" sldId="359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56:39.629" v="1965" actId="20577"/>
          <ac:spMkLst>
            <pc:docMk/>
            <pc:sldMk cId="389173886" sldId="359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3:56:27.314" v="1957" actId="20577"/>
          <ac:spMkLst>
            <pc:docMk/>
            <pc:sldMk cId="389173886" sldId="359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3:52:16.039" v="1924" actId="20577"/>
          <ac:spMkLst>
            <pc:docMk/>
            <pc:sldMk cId="389173886" sldId="359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3:57:19.149" v="1986" actId="20577"/>
          <ac:spMkLst>
            <pc:docMk/>
            <pc:sldMk cId="389173886" sldId="359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3:57:26.649" v="1988" actId="20577"/>
          <ac:spMkLst>
            <pc:docMk/>
            <pc:sldMk cId="389173886" sldId="359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3:56:59.475" v="1976" actId="20577"/>
          <ac:spMkLst>
            <pc:docMk/>
            <pc:sldMk cId="389173886" sldId="359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57:04.094" v="1980" actId="20577"/>
          <ac:spMkLst>
            <pc:docMk/>
            <pc:sldMk cId="389173886" sldId="359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57:08.839" v="1982" actId="20577"/>
          <ac:spMkLst>
            <pc:docMk/>
            <pc:sldMk cId="389173886" sldId="359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3:57:12.544" v="1984" actId="20577"/>
          <ac:spMkLst>
            <pc:docMk/>
            <pc:sldMk cId="389173886" sldId="359"/>
            <ac:spMk id="69" creationId="{00000000-0000-0000-0000-000000000000}"/>
          </ac:spMkLst>
        </pc:spChg>
        <pc:picChg chg="del">
          <ac:chgData name="hayato kawachi" userId="3d62671f137ab6e0" providerId="LiveId" clId="{5CF36E05-258C-4848-8869-4B99D6BFFBDB}" dt="2021-12-23T13:55:32.080" v="1933" actId="478"/>
          <ac:picMkLst>
            <pc:docMk/>
            <pc:sldMk cId="389173886" sldId="359"/>
            <ac:picMk id="5" creationId="{D2FDF793-1A5F-4952-9140-641CA350A7A2}"/>
          </ac:picMkLst>
        </pc:picChg>
        <pc:picChg chg="add del mod">
          <ac:chgData name="hayato kawachi" userId="3d62671f137ab6e0" providerId="LiveId" clId="{5CF36E05-258C-4848-8869-4B99D6BFFBDB}" dt="2021-12-23T13:53:54.844" v="1929" actId="478"/>
          <ac:picMkLst>
            <pc:docMk/>
            <pc:sldMk cId="389173886" sldId="359"/>
            <ac:picMk id="6" creationId="{52004920-FF1C-4217-AC29-C0BF7C1A6BD8}"/>
          </ac:picMkLst>
        </pc:picChg>
        <pc:picChg chg="add mod ord">
          <ac:chgData name="hayato kawachi" userId="3d62671f137ab6e0" providerId="LiveId" clId="{5CF36E05-258C-4848-8869-4B99D6BFFBDB}" dt="2021-12-23T13:55:53.528" v="1950" actId="1036"/>
          <ac:picMkLst>
            <pc:docMk/>
            <pc:sldMk cId="389173886" sldId="359"/>
            <ac:picMk id="8" creationId="{E874815A-8D4F-49E9-96DE-B7D4D62F4B40}"/>
          </ac:picMkLst>
        </pc:picChg>
      </pc:sldChg>
      <pc:sldChg chg="add del">
        <pc:chgData name="hayato kawachi" userId="3d62671f137ab6e0" providerId="LiveId" clId="{5CF36E05-258C-4848-8869-4B99D6BFFBDB}" dt="2021-12-23T13:33:26.843" v="1496" actId="47"/>
        <pc:sldMkLst>
          <pc:docMk/>
          <pc:sldMk cId="809452239" sldId="359"/>
        </pc:sldMkLst>
      </pc:sldChg>
      <pc:sldChg chg="addSp delSp modSp add mod">
        <pc:chgData name="hayato kawachi" userId="3d62671f137ab6e0" providerId="LiveId" clId="{5CF36E05-258C-4848-8869-4B99D6BFFBDB}" dt="2021-12-26T07:34:51.039" v="2649" actId="20577"/>
        <pc:sldMkLst>
          <pc:docMk/>
          <pc:sldMk cId="3929515670" sldId="360"/>
        </pc:sldMkLst>
        <pc:spChg chg="mod">
          <ac:chgData name="hayato kawachi" userId="3d62671f137ab6e0" providerId="LiveId" clId="{5CF36E05-258C-4848-8869-4B99D6BFFBDB}" dt="2021-12-26T07:34:51.039" v="2649" actId="20577"/>
          <ac:spMkLst>
            <pc:docMk/>
            <pc:sldMk cId="3929515670" sldId="360"/>
            <ac:spMk id="2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4:04:54.388" v="2033" actId="20577"/>
          <ac:spMkLst>
            <pc:docMk/>
            <pc:sldMk cId="3929515670" sldId="360"/>
            <ac:spMk id="33" creationId="{29F2463A-75AA-48A3-A5BF-2C3594115A43}"/>
          </ac:spMkLst>
        </pc:spChg>
        <pc:spChg chg="mod">
          <ac:chgData name="hayato kawachi" userId="3d62671f137ab6e0" providerId="LiveId" clId="{5CF36E05-258C-4848-8869-4B99D6BFFBDB}" dt="2021-12-23T14:08:00.317" v="2100" actId="20577"/>
          <ac:spMkLst>
            <pc:docMk/>
            <pc:sldMk cId="3929515670" sldId="360"/>
            <ac:spMk id="3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4:06:20.549" v="2067" actId="1076"/>
          <ac:spMkLst>
            <pc:docMk/>
            <pc:sldMk cId="3929515670" sldId="360"/>
            <ac:spMk id="37" creationId="{3ED8FDAB-36D8-45DE-89D0-5DAAD4A3261D}"/>
          </ac:spMkLst>
        </pc:spChg>
        <pc:spChg chg="mod">
          <ac:chgData name="hayato kawachi" userId="3d62671f137ab6e0" providerId="LiveId" clId="{5CF36E05-258C-4848-8869-4B99D6BFFBDB}" dt="2021-12-23T14:06:04.067" v="2056" actId="20577"/>
          <ac:spMkLst>
            <pc:docMk/>
            <pc:sldMk cId="3929515670" sldId="360"/>
            <ac:spMk id="38" creationId="{3FB751A9-8633-43EC-82C5-807F8581EEFA}"/>
          </ac:spMkLst>
        </pc:spChg>
        <pc:spChg chg="mod">
          <ac:chgData name="hayato kawachi" userId="3d62671f137ab6e0" providerId="LiveId" clId="{5CF36E05-258C-4848-8869-4B99D6BFFBDB}" dt="2021-12-23T14:06:33.096" v="2073" actId="20577"/>
          <ac:spMkLst>
            <pc:docMk/>
            <pc:sldMk cId="3929515670" sldId="360"/>
            <ac:spMk id="39" creationId="{1B721CC6-56D4-4BD4-9D1B-18C0972D8A62}"/>
          </ac:spMkLst>
        </pc:spChg>
        <pc:spChg chg="mod">
          <ac:chgData name="hayato kawachi" userId="3d62671f137ab6e0" providerId="LiveId" clId="{5CF36E05-258C-4848-8869-4B99D6BFFBDB}" dt="2021-12-23T14:08:23.138" v="2110" actId="20577"/>
          <ac:spMkLst>
            <pc:docMk/>
            <pc:sldMk cId="3929515670" sldId="360"/>
            <ac:spMk id="43" creationId="{CE8A4983-AE32-44E5-B7C3-04B70FF944E9}"/>
          </ac:spMkLst>
        </pc:spChg>
        <pc:spChg chg="mod">
          <ac:chgData name="hayato kawachi" userId="3d62671f137ab6e0" providerId="LiveId" clId="{5CF36E05-258C-4848-8869-4B99D6BFFBDB}" dt="2021-12-23T14:08:28.846" v="2112" actId="20577"/>
          <ac:spMkLst>
            <pc:docMk/>
            <pc:sldMk cId="3929515670" sldId="360"/>
            <ac:spMk id="45" creationId="{8EB91309-2FAF-43D9-ACD3-BA0E2BDE36D9}"/>
          </ac:spMkLst>
        </pc:spChg>
        <pc:spChg chg="mod">
          <ac:chgData name="hayato kawachi" userId="3d62671f137ab6e0" providerId="LiveId" clId="{5CF36E05-258C-4848-8869-4B99D6BFFBDB}" dt="2021-12-23T14:07:55.180" v="2097" actId="20577"/>
          <ac:spMkLst>
            <pc:docMk/>
            <pc:sldMk cId="3929515670" sldId="360"/>
            <ac:spMk id="50" creationId="{E10074C8-9A6C-44D2-B375-7758BE6319F6}"/>
          </ac:spMkLst>
        </pc:spChg>
        <pc:spChg chg="mod">
          <ac:chgData name="hayato kawachi" userId="3d62671f137ab6e0" providerId="LiveId" clId="{5CF36E05-258C-4848-8869-4B99D6BFFBDB}" dt="2021-12-23T14:08:07.189" v="2102" actId="20577"/>
          <ac:spMkLst>
            <pc:docMk/>
            <pc:sldMk cId="3929515670" sldId="360"/>
            <ac:spMk id="57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4:08:10.962" v="2104" actId="20577"/>
          <ac:spMkLst>
            <pc:docMk/>
            <pc:sldMk cId="3929515670" sldId="360"/>
            <ac:spMk id="61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4:08:17.596" v="2106" actId="20577"/>
          <ac:spMkLst>
            <pc:docMk/>
            <pc:sldMk cId="3929515670" sldId="360"/>
            <ac:spMk id="65" creationId="{00000000-0000-0000-0000-000000000000}"/>
          </ac:spMkLst>
        </pc:spChg>
        <pc:spChg chg="mod">
          <ac:chgData name="hayato kawachi" userId="3d62671f137ab6e0" providerId="LiveId" clId="{5CF36E05-258C-4848-8869-4B99D6BFFBDB}" dt="2021-12-23T14:08:19.763" v="2108" actId="20577"/>
          <ac:spMkLst>
            <pc:docMk/>
            <pc:sldMk cId="3929515670" sldId="360"/>
            <ac:spMk id="69" creationId="{00000000-0000-0000-0000-000000000000}"/>
          </ac:spMkLst>
        </pc:spChg>
        <pc:picChg chg="del">
          <ac:chgData name="hayato kawachi" userId="3d62671f137ab6e0" providerId="LiveId" clId="{5CF36E05-258C-4848-8869-4B99D6BFFBDB}" dt="2021-12-23T14:00:51.530" v="1998" actId="478"/>
          <ac:picMkLst>
            <pc:docMk/>
            <pc:sldMk cId="3929515670" sldId="360"/>
            <ac:picMk id="5" creationId="{D2FDF793-1A5F-4952-9140-641CA350A7A2}"/>
          </ac:picMkLst>
        </pc:picChg>
        <pc:picChg chg="add mod ord">
          <ac:chgData name="hayato kawachi" userId="3d62671f137ab6e0" providerId="LiveId" clId="{5CF36E05-258C-4848-8869-4B99D6BFFBDB}" dt="2021-12-23T14:04:56.989" v="2035" actId="1076"/>
          <ac:picMkLst>
            <pc:docMk/>
            <pc:sldMk cId="3929515670" sldId="360"/>
            <ac:picMk id="6" creationId="{EB03D8C0-EA30-492D-82A8-C4935C0F2AC9}"/>
          </ac:picMkLst>
        </pc:picChg>
      </pc:sldChg>
      <pc:sldChg chg="modSp add del mod">
        <pc:chgData name="hayato kawachi" userId="3d62671f137ab6e0" providerId="LiveId" clId="{5CF36E05-258C-4848-8869-4B99D6BFFBDB}" dt="2021-12-26T07:36:40.253" v="2650" actId="47"/>
        <pc:sldMkLst>
          <pc:docMk/>
          <pc:sldMk cId="3125724142" sldId="361"/>
        </pc:sldMkLst>
        <pc:spChg chg="mod">
          <ac:chgData name="hayato kawachi" userId="3d62671f137ab6e0" providerId="LiveId" clId="{5CF36E05-258C-4848-8869-4B99D6BFFBDB}" dt="2021-12-26T07:34:41.082" v="2645" actId="20577"/>
          <ac:spMkLst>
            <pc:docMk/>
            <pc:sldMk cId="3125724142" sldId="361"/>
            <ac:spMk id="2" creationId="{00000000-0000-0000-0000-000000000000}"/>
          </ac:spMkLst>
        </pc:spChg>
      </pc:sldChg>
    </pc:docChg>
  </pc:docChgLst>
  <pc:docChgLst>
    <pc:chgData name="hayato kawachi" userId="3d62671f137ab6e0" providerId="LiveId" clId="{4ADF1487-8980-4609-AF87-567DB7F07707}"/>
    <pc:docChg chg="modSld">
      <pc:chgData name="hayato kawachi" userId="3d62671f137ab6e0" providerId="LiveId" clId="{4ADF1487-8980-4609-AF87-567DB7F07707}" dt="2022-03-22T05:46:37.702" v="20" actId="20577"/>
      <pc:docMkLst>
        <pc:docMk/>
      </pc:docMkLst>
      <pc:sldChg chg="modSp mod">
        <pc:chgData name="hayato kawachi" userId="3d62671f137ab6e0" providerId="LiveId" clId="{4ADF1487-8980-4609-AF87-567DB7F07707}" dt="2022-03-22T05:46:37.702" v="20" actId="20577"/>
        <pc:sldMkLst>
          <pc:docMk/>
          <pc:sldMk cId="3974256553" sldId="309"/>
        </pc:sldMkLst>
        <pc:spChg chg="mod">
          <ac:chgData name="hayato kawachi" userId="3d62671f137ab6e0" providerId="LiveId" clId="{4ADF1487-8980-4609-AF87-567DB7F07707}" dt="2022-03-22T05:46:37.702" v="20" actId="20577"/>
          <ac:spMkLst>
            <pc:docMk/>
            <pc:sldMk cId="3974256553" sldId="309"/>
            <ac:spMk id="2" creationId="{00000000-0000-0000-0000-000000000000}"/>
          </ac:spMkLst>
        </pc:spChg>
      </pc:sldChg>
    </pc:docChg>
  </pc:docChgLst>
  <pc:docChgLst>
    <pc:chgData name="hayato kawachi" userId="3d62671f137ab6e0" providerId="LiveId" clId="{516AC607-671C-41B3-93A8-0D1BABBEE29E}"/>
    <pc:docChg chg="undo custSel delSld modSld">
      <pc:chgData name="hayato kawachi" userId="3d62671f137ab6e0" providerId="LiveId" clId="{516AC607-671C-41B3-93A8-0D1BABBEE29E}" dt="2022-02-04T10:32:36.347" v="192" actId="6549"/>
      <pc:docMkLst>
        <pc:docMk/>
      </pc:docMkLst>
      <pc:sldChg chg="modSp mod">
        <pc:chgData name="hayato kawachi" userId="3d62671f137ab6e0" providerId="LiveId" clId="{516AC607-671C-41B3-93A8-0D1BABBEE29E}" dt="2022-02-04T10:31:39.100" v="89" actId="6549"/>
        <pc:sldMkLst>
          <pc:docMk/>
          <pc:sldMk cId="322658806" sldId="316"/>
        </pc:sldMkLst>
        <pc:spChg chg="mod">
          <ac:chgData name="hayato kawachi" userId="3d62671f137ab6e0" providerId="LiveId" clId="{516AC607-671C-41B3-93A8-0D1BABBEE29E}" dt="2022-02-04T10:31:39.100" v="89" actId="6549"/>
          <ac:spMkLst>
            <pc:docMk/>
            <pc:sldMk cId="322658806" sldId="316"/>
            <ac:spMk id="3" creationId="{00000000-0000-0000-0000-000000000000}"/>
          </ac:spMkLst>
        </pc:spChg>
      </pc:sldChg>
      <pc:sldChg chg="modSp mod">
        <pc:chgData name="hayato kawachi" userId="3d62671f137ab6e0" providerId="LiveId" clId="{516AC607-671C-41B3-93A8-0D1BABBEE29E}" dt="2022-02-04T10:32:10.564" v="126" actId="20577"/>
        <pc:sldMkLst>
          <pc:docMk/>
          <pc:sldMk cId="3840021381" sldId="317"/>
        </pc:sldMkLst>
        <pc:spChg chg="mod">
          <ac:chgData name="hayato kawachi" userId="3d62671f137ab6e0" providerId="LiveId" clId="{516AC607-671C-41B3-93A8-0D1BABBEE29E}" dt="2022-02-04T10:32:10.564" v="126" actId="20577"/>
          <ac:spMkLst>
            <pc:docMk/>
            <pc:sldMk cId="3840021381" sldId="317"/>
            <ac:spMk id="3" creationId="{00000000-0000-0000-0000-000000000000}"/>
          </ac:spMkLst>
        </pc:spChg>
      </pc:sldChg>
      <pc:sldChg chg="modSp mod">
        <pc:chgData name="hayato kawachi" userId="3d62671f137ab6e0" providerId="LiveId" clId="{516AC607-671C-41B3-93A8-0D1BABBEE29E}" dt="2022-02-04T10:32:26.628" v="159" actId="6549"/>
        <pc:sldMkLst>
          <pc:docMk/>
          <pc:sldMk cId="3120795257" sldId="322"/>
        </pc:sldMkLst>
        <pc:spChg chg="mod">
          <ac:chgData name="hayato kawachi" userId="3d62671f137ab6e0" providerId="LiveId" clId="{516AC607-671C-41B3-93A8-0D1BABBEE29E}" dt="2022-02-04T10:32:26.628" v="159" actId="6549"/>
          <ac:spMkLst>
            <pc:docMk/>
            <pc:sldMk cId="3120795257" sldId="322"/>
            <ac:spMk id="3" creationId="{00000000-0000-0000-0000-000000000000}"/>
          </ac:spMkLst>
        </pc:spChg>
      </pc:sldChg>
      <pc:sldChg chg="modSp mod">
        <pc:chgData name="hayato kawachi" userId="3d62671f137ab6e0" providerId="LiveId" clId="{516AC607-671C-41B3-93A8-0D1BABBEE29E}" dt="2022-02-04T10:32:36.347" v="192" actId="6549"/>
        <pc:sldMkLst>
          <pc:docMk/>
          <pc:sldMk cId="228181719" sldId="323"/>
        </pc:sldMkLst>
        <pc:spChg chg="mod">
          <ac:chgData name="hayato kawachi" userId="3d62671f137ab6e0" providerId="LiveId" clId="{516AC607-671C-41B3-93A8-0D1BABBEE29E}" dt="2022-02-04T10:32:36.347" v="192" actId="6549"/>
          <ac:spMkLst>
            <pc:docMk/>
            <pc:sldMk cId="228181719" sldId="323"/>
            <ac:spMk id="3" creationId="{00000000-0000-0000-0000-000000000000}"/>
          </ac:spMkLst>
        </pc:spChg>
      </pc:sldChg>
      <pc:sldChg chg="del">
        <pc:chgData name="hayato kawachi" userId="3d62671f137ab6e0" providerId="LiveId" clId="{516AC607-671C-41B3-93A8-0D1BABBEE29E}" dt="2022-01-16T09:14:20.943" v="1" actId="47"/>
        <pc:sldMkLst>
          <pc:docMk/>
          <pc:sldMk cId="3063060718" sldId="324"/>
        </pc:sldMkLst>
      </pc:sldChg>
      <pc:sldChg chg="del">
        <pc:chgData name="hayato kawachi" userId="3d62671f137ab6e0" providerId="LiveId" clId="{516AC607-671C-41B3-93A8-0D1BABBEE29E}" dt="2022-01-16T09:14:21.909" v="2" actId="47"/>
        <pc:sldMkLst>
          <pc:docMk/>
          <pc:sldMk cId="3163722855" sldId="325"/>
        </pc:sldMkLst>
      </pc:sldChg>
      <pc:sldChg chg="del">
        <pc:chgData name="hayato kawachi" userId="3d62671f137ab6e0" providerId="LiveId" clId="{516AC607-671C-41B3-93A8-0D1BABBEE29E}" dt="2022-01-16T09:14:20.394" v="0" actId="47"/>
        <pc:sldMkLst>
          <pc:docMk/>
          <pc:sldMk cId="1805142134" sldId="326"/>
        </pc:sldMkLst>
      </pc:sldChg>
      <pc:sldChg chg="del">
        <pc:chgData name="hayato kawachi" userId="3d62671f137ab6e0" providerId="LiveId" clId="{516AC607-671C-41B3-93A8-0D1BABBEE29E}" dt="2022-01-16T09:14:23.573" v="3" actId="47"/>
        <pc:sldMkLst>
          <pc:docMk/>
          <pc:sldMk cId="2070169754" sldId="327"/>
        </pc:sldMkLst>
      </pc:sldChg>
    </pc:docChg>
  </pc:docChgLst>
  <pc:docChgLst>
    <pc:chgData name="hayato kawachi" userId="3d62671f137ab6e0" providerId="LiveId" clId="{9DA759D2-3AF6-4AB4-98EB-6B60ADE6B3F6}"/>
    <pc:docChg chg="undo custSel addSld delSld modSld">
      <pc:chgData name="hayato kawachi" userId="3d62671f137ab6e0" providerId="LiveId" clId="{9DA759D2-3AF6-4AB4-98EB-6B60ADE6B3F6}" dt="2021-11-28T14:04:29.053" v="1478"/>
      <pc:docMkLst>
        <pc:docMk/>
      </pc:docMkLst>
      <pc:sldChg chg="modSp mod">
        <pc:chgData name="hayato kawachi" userId="3d62671f137ab6e0" providerId="LiveId" clId="{9DA759D2-3AF6-4AB4-98EB-6B60ADE6B3F6}" dt="2021-11-28T14:04:29.053" v="1478"/>
        <pc:sldMkLst>
          <pc:docMk/>
          <pc:sldMk cId="163190479" sldId="318"/>
        </pc:sldMkLst>
        <pc:spChg chg="mod">
          <ac:chgData name="hayato kawachi" userId="3d62671f137ab6e0" providerId="LiveId" clId="{9DA759D2-3AF6-4AB4-98EB-6B60ADE6B3F6}" dt="2021-11-28T14:04:29.053" v="1478"/>
          <ac:spMkLst>
            <pc:docMk/>
            <pc:sldMk cId="163190479" sldId="318"/>
            <ac:spMk id="2" creationId="{FE0D19BB-235A-44AB-A32F-F610D8B3FF1B}"/>
          </ac:spMkLst>
        </pc:spChg>
      </pc:sldChg>
      <pc:sldChg chg="modSp mod">
        <pc:chgData name="hayato kawachi" userId="3d62671f137ab6e0" providerId="LiveId" clId="{9DA759D2-3AF6-4AB4-98EB-6B60ADE6B3F6}" dt="2021-11-28T12:34:48.685" v="16" actId="20577"/>
        <pc:sldMkLst>
          <pc:docMk/>
          <pc:sldMk cId="3063060718" sldId="324"/>
        </pc:sldMkLst>
        <pc:spChg chg="mod">
          <ac:chgData name="hayato kawachi" userId="3d62671f137ab6e0" providerId="LiveId" clId="{9DA759D2-3AF6-4AB4-98EB-6B60ADE6B3F6}" dt="2021-11-28T12:34:48.685" v="16" actId="20577"/>
          <ac:spMkLst>
            <pc:docMk/>
            <pc:sldMk cId="3063060718" sldId="324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5:00.525" v="31" actId="20577"/>
        <pc:sldMkLst>
          <pc:docMk/>
          <pc:sldMk cId="2478891739" sldId="329"/>
        </pc:sldMkLst>
        <pc:spChg chg="mod">
          <ac:chgData name="hayato kawachi" userId="3d62671f137ab6e0" providerId="LiveId" clId="{9DA759D2-3AF6-4AB4-98EB-6B60ADE6B3F6}" dt="2021-11-28T12:35:00.525" v="31" actId="20577"/>
          <ac:spMkLst>
            <pc:docMk/>
            <pc:sldMk cId="2478891739" sldId="329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5:16.790" v="49" actId="20577"/>
        <pc:sldMkLst>
          <pc:docMk/>
          <pc:sldMk cId="1423261008" sldId="330"/>
        </pc:sldMkLst>
        <pc:spChg chg="mod">
          <ac:chgData name="hayato kawachi" userId="3d62671f137ab6e0" providerId="LiveId" clId="{9DA759D2-3AF6-4AB4-98EB-6B60ADE6B3F6}" dt="2021-11-28T12:35:16.790" v="49" actId="20577"/>
          <ac:spMkLst>
            <pc:docMk/>
            <pc:sldMk cId="1423261008" sldId="330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5:48.497" v="54" actId="20577"/>
        <pc:sldMkLst>
          <pc:docMk/>
          <pc:sldMk cId="607319722" sldId="331"/>
        </pc:sldMkLst>
        <pc:spChg chg="mod">
          <ac:chgData name="hayato kawachi" userId="3d62671f137ab6e0" providerId="LiveId" clId="{9DA759D2-3AF6-4AB4-98EB-6B60ADE6B3F6}" dt="2021-11-28T12:35:48.497" v="54" actId="20577"/>
          <ac:spMkLst>
            <pc:docMk/>
            <pc:sldMk cId="607319722" sldId="331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6:13.975" v="76" actId="20577"/>
        <pc:sldMkLst>
          <pc:docMk/>
          <pc:sldMk cId="1699429612" sldId="332"/>
        </pc:sldMkLst>
        <pc:spChg chg="mod">
          <ac:chgData name="hayato kawachi" userId="3d62671f137ab6e0" providerId="LiveId" clId="{9DA759D2-3AF6-4AB4-98EB-6B60ADE6B3F6}" dt="2021-11-28T12:36:13.975" v="76" actId="20577"/>
          <ac:spMkLst>
            <pc:docMk/>
            <pc:sldMk cId="1699429612" sldId="332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6:57.485" v="82" actId="20577"/>
        <pc:sldMkLst>
          <pc:docMk/>
          <pc:sldMk cId="560247447" sldId="333"/>
        </pc:sldMkLst>
        <pc:spChg chg="mod">
          <ac:chgData name="hayato kawachi" userId="3d62671f137ab6e0" providerId="LiveId" clId="{9DA759D2-3AF6-4AB4-98EB-6B60ADE6B3F6}" dt="2021-11-28T12:36:57.485" v="82" actId="20577"/>
          <ac:spMkLst>
            <pc:docMk/>
            <pc:sldMk cId="560247447" sldId="333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7:15.087" v="109" actId="20577"/>
        <pc:sldMkLst>
          <pc:docMk/>
          <pc:sldMk cId="701393163" sldId="334"/>
        </pc:sldMkLst>
        <pc:spChg chg="mod">
          <ac:chgData name="hayato kawachi" userId="3d62671f137ab6e0" providerId="LiveId" clId="{9DA759D2-3AF6-4AB4-98EB-6B60ADE6B3F6}" dt="2021-11-28T12:37:15.087" v="109" actId="20577"/>
          <ac:spMkLst>
            <pc:docMk/>
            <pc:sldMk cId="701393163" sldId="334"/>
            <ac:spMk id="2" creationId="{FE0D19BB-235A-44AB-A32F-F610D8B3FF1B}"/>
          </ac:spMkLst>
        </pc:spChg>
      </pc:sldChg>
      <pc:sldChg chg="add del">
        <pc:chgData name="hayato kawachi" userId="3d62671f137ab6e0" providerId="LiveId" clId="{9DA759D2-3AF6-4AB4-98EB-6B60ADE6B3F6}" dt="2021-11-28T12:37:17.940" v="111"/>
        <pc:sldMkLst>
          <pc:docMk/>
          <pc:sldMk cId="599008586" sldId="335"/>
        </pc:sldMkLst>
      </pc:sldChg>
      <pc:sldChg chg="modSp add mod">
        <pc:chgData name="hayato kawachi" userId="3d62671f137ab6e0" providerId="LiveId" clId="{9DA759D2-3AF6-4AB4-98EB-6B60ADE6B3F6}" dt="2021-11-28T12:37:23.386" v="116" actId="20577"/>
        <pc:sldMkLst>
          <pc:docMk/>
          <pc:sldMk cId="4128821573" sldId="335"/>
        </pc:sldMkLst>
        <pc:spChg chg="mod">
          <ac:chgData name="hayato kawachi" userId="3d62671f137ab6e0" providerId="LiveId" clId="{9DA759D2-3AF6-4AB4-98EB-6B60ADE6B3F6}" dt="2021-11-28T12:37:23.386" v="116" actId="20577"/>
          <ac:spMkLst>
            <pc:docMk/>
            <pc:sldMk cId="4128821573" sldId="335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7:33.888" v="125" actId="20577"/>
        <pc:sldMkLst>
          <pc:docMk/>
          <pc:sldMk cId="1275856381" sldId="336"/>
        </pc:sldMkLst>
        <pc:spChg chg="mod">
          <ac:chgData name="hayato kawachi" userId="3d62671f137ab6e0" providerId="LiveId" clId="{9DA759D2-3AF6-4AB4-98EB-6B60ADE6B3F6}" dt="2021-11-28T12:37:33.888" v="125" actId="20577"/>
          <ac:spMkLst>
            <pc:docMk/>
            <pc:sldMk cId="1275856381" sldId="336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7:42.955" v="144" actId="20577"/>
        <pc:sldMkLst>
          <pc:docMk/>
          <pc:sldMk cId="345601559" sldId="337"/>
        </pc:sldMkLst>
        <pc:spChg chg="mod">
          <ac:chgData name="hayato kawachi" userId="3d62671f137ab6e0" providerId="LiveId" clId="{9DA759D2-3AF6-4AB4-98EB-6B60ADE6B3F6}" dt="2021-11-28T12:37:42.955" v="144" actId="20577"/>
          <ac:spMkLst>
            <pc:docMk/>
            <pc:sldMk cId="345601559" sldId="337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9DA759D2-3AF6-4AB4-98EB-6B60ADE6B3F6}" dt="2021-11-28T12:38:24.561" v="160" actId="20577"/>
        <pc:sldMkLst>
          <pc:docMk/>
          <pc:sldMk cId="1034753792" sldId="338"/>
        </pc:sldMkLst>
        <pc:spChg chg="mod">
          <ac:chgData name="hayato kawachi" userId="3d62671f137ab6e0" providerId="LiveId" clId="{9DA759D2-3AF6-4AB4-98EB-6B60ADE6B3F6}" dt="2021-11-28T12:38:24.561" v="160" actId="20577"/>
          <ac:spMkLst>
            <pc:docMk/>
            <pc:sldMk cId="1034753792" sldId="338"/>
            <ac:spMk id="2" creationId="{FE0D19BB-235A-44AB-A32F-F610D8B3FF1B}"/>
          </ac:spMkLst>
        </pc:spChg>
      </pc:sldChg>
      <pc:sldChg chg="addSp delSp modSp add mod">
        <pc:chgData name="hayato kawachi" userId="3d62671f137ab6e0" providerId="LiveId" clId="{9DA759D2-3AF6-4AB4-98EB-6B60ADE6B3F6}" dt="2021-11-28T12:55:44.468" v="440" actId="20577"/>
        <pc:sldMkLst>
          <pc:docMk/>
          <pc:sldMk cId="4133687114" sldId="339"/>
        </pc:sldMkLst>
        <pc:spChg chg="mod">
          <ac:chgData name="hayato kawachi" userId="3d62671f137ab6e0" providerId="LiveId" clId="{9DA759D2-3AF6-4AB4-98EB-6B60ADE6B3F6}" dt="2021-11-28T12:53:44.326" v="400" actId="20577"/>
          <ac:spMkLst>
            <pc:docMk/>
            <pc:sldMk cId="4133687114" sldId="339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53:39.693" v="395" actId="20577"/>
          <ac:spMkLst>
            <pc:docMk/>
            <pc:sldMk cId="4133687114" sldId="339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2:55:38.124" v="435" actId="20577"/>
          <ac:spMkLst>
            <pc:docMk/>
            <pc:sldMk cId="4133687114" sldId="339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53:25.119" v="387" actId="20577"/>
          <ac:spMkLst>
            <pc:docMk/>
            <pc:sldMk cId="4133687114" sldId="339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2:52:57.703" v="375" actId="20577"/>
          <ac:spMkLst>
            <pc:docMk/>
            <pc:sldMk cId="4133687114" sldId="339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2:54:03.111" v="406" actId="20577"/>
          <ac:spMkLst>
            <pc:docMk/>
            <pc:sldMk cId="4133687114" sldId="339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2:55:27.588" v="432" actId="20577"/>
          <ac:spMkLst>
            <pc:docMk/>
            <pc:sldMk cId="4133687114" sldId="339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2:55:41.604" v="438" actId="20577"/>
          <ac:spMkLst>
            <pc:docMk/>
            <pc:sldMk cId="4133687114" sldId="339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55:44.468" v="440" actId="20577"/>
          <ac:spMkLst>
            <pc:docMk/>
            <pc:sldMk cId="4133687114" sldId="339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54:54.817" v="424" actId="20577"/>
          <ac:spMkLst>
            <pc:docMk/>
            <pc:sldMk cId="4133687114" sldId="339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55:00.255" v="426" actId="20577"/>
          <ac:spMkLst>
            <pc:docMk/>
            <pc:sldMk cId="4133687114" sldId="339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55:05.985" v="428" actId="20577"/>
          <ac:spMkLst>
            <pc:docMk/>
            <pc:sldMk cId="4133687114" sldId="339"/>
            <ac:spMk id="73" creationId="{00000000-0000-0000-0000-000000000000}"/>
          </ac:spMkLst>
        </pc:spChg>
        <pc:picChg chg="add mod ord">
          <ac:chgData name="hayato kawachi" userId="3d62671f137ab6e0" providerId="LiveId" clId="{9DA759D2-3AF6-4AB4-98EB-6B60ADE6B3F6}" dt="2021-11-28T12:52:04.389" v="357" actId="1037"/>
          <ac:picMkLst>
            <pc:docMk/>
            <pc:sldMk cId="4133687114" sldId="339"/>
            <ac:picMk id="5" creationId="{5FAA0B28-C075-47B9-B920-8453A2BA4340}"/>
          </ac:picMkLst>
        </pc:picChg>
        <pc:picChg chg="del">
          <ac:chgData name="hayato kawachi" userId="3d62671f137ab6e0" providerId="LiveId" clId="{9DA759D2-3AF6-4AB4-98EB-6B60ADE6B3F6}" dt="2021-11-28T12:51:41.443" v="332" actId="478"/>
          <ac:picMkLst>
            <pc:docMk/>
            <pc:sldMk cId="4133687114" sldId="339"/>
            <ac:picMk id="40" creationId="{917C2BE5-1ED9-4C06-A123-6B3FE957320B}"/>
          </ac:picMkLst>
        </pc:picChg>
      </pc:sldChg>
      <pc:sldChg chg="addSp delSp modSp add mod">
        <pc:chgData name="hayato kawachi" userId="3d62671f137ab6e0" providerId="LiveId" clId="{9DA759D2-3AF6-4AB4-98EB-6B60ADE6B3F6}" dt="2021-11-28T13:03:12.045" v="514" actId="20577"/>
        <pc:sldMkLst>
          <pc:docMk/>
          <pc:sldMk cId="3607678172" sldId="340"/>
        </pc:sldMkLst>
        <pc:spChg chg="mod">
          <ac:chgData name="hayato kawachi" userId="3d62671f137ab6e0" providerId="LiveId" clId="{9DA759D2-3AF6-4AB4-98EB-6B60ADE6B3F6}" dt="2021-11-28T12:45:21.311" v="239" actId="20577"/>
          <ac:spMkLst>
            <pc:docMk/>
            <pc:sldMk cId="3607678172" sldId="340"/>
            <ac:spMk id="2" creationId="{00000000-0000-0000-0000-000000000000}"/>
          </ac:spMkLst>
        </pc:spChg>
        <pc:spChg chg="add del">
          <ac:chgData name="hayato kawachi" userId="3d62671f137ab6e0" providerId="LiveId" clId="{9DA759D2-3AF6-4AB4-98EB-6B60ADE6B3F6}" dt="2021-11-28T12:44:40.109" v="225" actId="478"/>
          <ac:spMkLst>
            <pc:docMk/>
            <pc:sldMk cId="3607678172" sldId="340"/>
            <ac:spMk id="4" creationId="{10E6071C-0F9A-4C15-BFE4-F4AFB869AA01}"/>
          </ac:spMkLst>
        </pc:spChg>
        <pc:spChg chg="mod">
          <ac:chgData name="hayato kawachi" userId="3d62671f137ab6e0" providerId="LiveId" clId="{9DA759D2-3AF6-4AB4-98EB-6B60ADE6B3F6}" dt="2021-11-28T12:45:14.946" v="234" actId="20577"/>
          <ac:spMkLst>
            <pc:docMk/>
            <pc:sldMk cId="3607678172" sldId="340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2:50:16.738" v="324" actId="20577"/>
          <ac:spMkLst>
            <pc:docMk/>
            <pc:sldMk cId="3607678172" sldId="340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47:52.603" v="284" actId="20577"/>
          <ac:spMkLst>
            <pc:docMk/>
            <pc:sldMk cId="3607678172" sldId="340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2:48:06.086" v="286" actId="20577"/>
          <ac:spMkLst>
            <pc:docMk/>
            <pc:sldMk cId="3607678172" sldId="340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2:43:53.113" v="223" actId="20577"/>
          <ac:spMkLst>
            <pc:docMk/>
            <pc:sldMk cId="3607678172" sldId="340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03:12.045" v="514" actId="20577"/>
          <ac:spMkLst>
            <pc:docMk/>
            <pc:sldMk cId="3607678172" sldId="340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2:50:23.099" v="327" actId="20577"/>
          <ac:spMkLst>
            <pc:docMk/>
            <pc:sldMk cId="3607678172" sldId="340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49:16.286" v="307" actId="20577"/>
          <ac:spMkLst>
            <pc:docMk/>
            <pc:sldMk cId="3607678172" sldId="340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49:29.439" v="310" actId="20577"/>
          <ac:spMkLst>
            <pc:docMk/>
            <pc:sldMk cId="3607678172" sldId="340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49:49.769" v="316" actId="20577"/>
          <ac:spMkLst>
            <pc:docMk/>
            <pc:sldMk cId="3607678172" sldId="340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2:49:51.393" v="318" actId="20577"/>
          <ac:spMkLst>
            <pc:docMk/>
            <pc:sldMk cId="3607678172" sldId="340"/>
            <ac:spMk id="73" creationId="{00000000-0000-0000-0000-000000000000}"/>
          </ac:spMkLst>
        </pc:spChg>
        <pc:picChg chg="del">
          <ac:chgData name="hayato kawachi" userId="3d62671f137ab6e0" providerId="LiveId" clId="{9DA759D2-3AF6-4AB4-98EB-6B60ADE6B3F6}" dt="2021-11-28T12:46:48.980" v="260" actId="478"/>
          <ac:picMkLst>
            <pc:docMk/>
            <pc:sldMk cId="3607678172" sldId="340"/>
            <ac:picMk id="40" creationId="{917C2BE5-1ED9-4C06-A123-6B3FE957320B}"/>
          </ac:picMkLst>
        </pc:picChg>
        <pc:picChg chg="add mod ord">
          <ac:chgData name="hayato kawachi" userId="3d62671f137ab6e0" providerId="LiveId" clId="{9DA759D2-3AF6-4AB4-98EB-6B60ADE6B3F6}" dt="2021-11-28T12:47:02.218" v="276" actId="1035"/>
          <ac:picMkLst>
            <pc:docMk/>
            <pc:sldMk cId="3607678172" sldId="340"/>
            <ac:picMk id="41" creationId="{9A12F9B0-9E6A-461C-BC75-FDE68199C9DA}"/>
          </ac:picMkLst>
        </pc:picChg>
      </pc:sldChg>
      <pc:sldChg chg="addSp delSp modSp add mod">
        <pc:chgData name="hayato kawachi" userId="3d62671f137ab6e0" providerId="LiveId" clId="{9DA759D2-3AF6-4AB4-98EB-6B60ADE6B3F6}" dt="2021-11-28T13:09:43.188" v="610" actId="20577"/>
        <pc:sldMkLst>
          <pc:docMk/>
          <pc:sldMk cId="2250381105" sldId="341"/>
        </pc:sldMkLst>
        <pc:spChg chg="mod">
          <ac:chgData name="hayato kawachi" userId="3d62671f137ab6e0" providerId="LiveId" clId="{9DA759D2-3AF6-4AB4-98EB-6B60ADE6B3F6}" dt="2021-11-28T13:09:43.188" v="610" actId="20577"/>
          <ac:spMkLst>
            <pc:docMk/>
            <pc:sldMk cId="2250381105" sldId="341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00:49.049" v="482" actId="20577"/>
          <ac:spMkLst>
            <pc:docMk/>
            <pc:sldMk cId="2250381105" sldId="341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06:16.827" v="573" actId="20577"/>
          <ac:spMkLst>
            <pc:docMk/>
            <pc:sldMk cId="2250381105" sldId="341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00:26.679" v="466" actId="20577"/>
          <ac:spMkLst>
            <pc:docMk/>
            <pc:sldMk cId="2250381105" sldId="341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01:41.066" v="486" actId="20577"/>
          <ac:spMkLst>
            <pc:docMk/>
            <pc:sldMk cId="2250381105" sldId="341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00:04.215" v="458" actId="20577"/>
          <ac:spMkLst>
            <pc:docMk/>
            <pc:sldMk cId="2250381105" sldId="341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06:10.234" v="569" actId="20577"/>
          <ac:spMkLst>
            <pc:docMk/>
            <pc:sldMk cId="2250381105" sldId="341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06:21.462" v="576" actId="20577"/>
          <ac:spMkLst>
            <pc:docMk/>
            <pc:sldMk cId="2250381105" sldId="341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06:31.170" v="581" actId="20577"/>
          <ac:spMkLst>
            <pc:docMk/>
            <pc:sldMk cId="2250381105" sldId="341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06:34.299" v="584" actId="20577"/>
          <ac:spMkLst>
            <pc:docMk/>
            <pc:sldMk cId="2250381105" sldId="341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06:36.497" v="586" actId="20577"/>
          <ac:spMkLst>
            <pc:docMk/>
            <pc:sldMk cId="2250381105" sldId="341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05:58.338" v="565" actId="20577"/>
          <ac:spMkLst>
            <pc:docMk/>
            <pc:sldMk cId="2250381105" sldId="341"/>
            <ac:spMk id="73" creationId="{00000000-0000-0000-0000-000000000000}"/>
          </ac:spMkLst>
        </pc:spChg>
        <pc:picChg chg="add del mod ord">
          <ac:chgData name="hayato kawachi" userId="3d62671f137ab6e0" providerId="LiveId" clId="{9DA759D2-3AF6-4AB4-98EB-6B60ADE6B3F6}" dt="2021-11-28T13:09:07.398" v="603" actId="478"/>
          <ac:picMkLst>
            <pc:docMk/>
            <pc:sldMk cId="2250381105" sldId="341"/>
            <ac:picMk id="5" creationId="{32CA5A4C-F914-49E5-A752-7941AABD5D9B}"/>
          </ac:picMkLst>
        </pc:picChg>
        <pc:picChg chg="add del mod ord">
          <ac:chgData name="hayato kawachi" userId="3d62671f137ab6e0" providerId="LiveId" clId="{9DA759D2-3AF6-4AB4-98EB-6B60ADE6B3F6}" dt="2021-11-28T13:09:11.869" v="606" actId="22"/>
          <ac:picMkLst>
            <pc:docMk/>
            <pc:sldMk cId="2250381105" sldId="341"/>
            <ac:picMk id="7" creationId="{28AC2729-2579-447C-B597-E7B560D868B3}"/>
          </ac:picMkLst>
        </pc:picChg>
        <pc:picChg chg="del">
          <ac:chgData name="hayato kawachi" userId="3d62671f137ab6e0" providerId="LiveId" clId="{9DA759D2-3AF6-4AB4-98EB-6B60ADE6B3F6}" dt="2021-11-28T13:02:16.215" v="490" actId="478"/>
          <ac:picMkLst>
            <pc:docMk/>
            <pc:sldMk cId="2250381105" sldId="341"/>
            <ac:picMk id="41" creationId="{9A12F9B0-9E6A-461C-BC75-FDE68199C9DA}"/>
          </ac:picMkLst>
        </pc:picChg>
      </pc:sldChg>
      <pc:sldChg chg="addSp new del mod">
        <pc:chgData name="hayato kawachi" userId="3d62671f137ab6e0" providerId="LiveId" clId="{9DA759D2-3AF6-4AB4-98EB-6B60ADE6B3F6}" dt="2021-11-28T12:46:54.757" v="275" actId="47"/>
        <pc:sldMkLst>
          <pc:docMk/>
          <pc:sldMk cId="3067279496" sldId="341"/>
        </pc:sldMkLst>
        <pc:picChg chg="add">
          <ac:chgData name="hayato kawachi" userId="3d62671f137ab6e0" providerId="LiveId" clId="{9DA759D2-3AF6-4AB4-98EB-6B60ADE6B3F6}" dt="2021-11-28T12:46:20.372" v="254" actId="22"/>
          <ac:picMkLst>
            <pc:docMk/>
            <pc:sldMk cId="3067279496" sldId="341"/>
            <ac:picMk id="3" creationId="{2138D879-16A1-4B72-8BE8-E36B1CB3DF74}"/>
          </ac:picMkLst>
        </pc:picChg>
      </pc:sldChg>
      <pc:sldChg chg="addSp delSp modSp add mod">
        <pc:chgData name="hayato kawachi" userId="3d62671f137ab6e0" providerId="LiveId" clId="{9DA759D2-3AF6-4AB4-98EB-6B60ADE6B3F6}" dt="2021-11-28T13:14:26.568" v="721" actId="20577"/>
        <pc:sldMkLst>
          <pc:docMk/>
          <pc:sldMk cId="3299340242" sldId="342"/>
        </pc:sldMkLst>
        <pc:spChg chg="mod">
          <ac:chgData name="hayato kawachi" userId="3d62671f137ab6e0" providerId="LiveId" clId="{9DA759D2-3AF6-4AB4-98EB-6B60ADE6B3F6}" dt="2021-11-28T13:10:21.116" v="614" actId="20577"/>
          <ac:spMkLst>
            <pc:docMk/>
            <pc:sldMk cId="3299340242" sldId="342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0:32.917" v="631" actId="20577"/>
          <ac:spMkLst>
            <pc:docMk/>
            <pc:sldMk cId="3299340242" sldId="342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14:18.420" v="717" actId="20577"/>
          <ac:spMkLst>
            <pc:docMk/>
            <pc:sldMk cId="3299340242" sldId="342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3:18.638" v="691" actId="1076"/>
          <ac:spMkLst>
            <pc:docMk/>
            <pc:sldMk cId="3299340242" sldId="342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13:22.746" v="692" actId="1076"/>
          <ac:spMkLst>
            <pc:docMk/>
            <pc:sldMk cId="3299340242" sldId="342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11:14.657" v="649" actId="20577"/>
          <ac:spMkLst>
            <pc:docMk/>
            <pc:sldMk cId="3299340242" sldId="342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14:13.765" v="714" actId="20577"/>
          <ac:spMkLst>
            <pc:docMk/>
            <pc:sldMk cId="3299340242" sldId="342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14:23.025" v="719" actId="20577"/>
          <ac:spMkLst>
            <pc:docMk/>
            <pc:sldMk cId="3299340242" sldId="342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4:26.568" v="721" actId="20577"/>
          <ac:spMkLst>
            <pc:docMk/>
            <pc:sldMk cId="3299340242" sldId="342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3:58.478" v="707" actId="20577"/>
          <ac:spMkLst>
            <pc:docMk/>
            <pc:sldMk cId="3299340242" sldId="342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4:00.722" v="709" actId="20577"/>
          <ac:spMkLst>
            <pc:docMk/>
            <pc:sldMk cId="3299340242" sldId="342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4:03.731" v="711" actId="20577"/>
          <ac:spMkLst>
            <pc:docMk/>
            <pc:sldMk cId="3299340242" sldId="342"/>
            <ac:spMk id="73" creationId="{00000000-0000-0000-0000-000000000000}"/>
          </ac:spMkLst>
        </pc:spChg>
        <pc:picChg chg="add mod ord">
          <ac:chgData name="hayato kawachi" userId="3d62671f137ab6e0" providerId="LiveId" clId="{9DA759D2-3AF6-4AB4-98EB-6B60ADE6B3F6}" dt="2021-11-28T13:13:06.101" v="689" actId="1038"/>
          <ac:picMkLst>
            <pc:docMk/>
            <pc:sldMk cId="3299340242" sldId="342"/>
            <ac:picMk id="5" creationId="{BA687A8F-F6AA-4D04-841E-32531EBD5EB5}"/>
          </ac:picMkLst>
        </pc:picChg>
        <pc:picChg chg="del">
          <ac:chgData name="hayato kawachi" userId="3d62671f137ab6e0" providerId="LiveId" clId="{9DA759D2-3AF6-4AB4-98EB-6B60ADE6B3F6}" dt="2021-11-28T13:12:30.609" v="662" actId="478"/>
          <ac:picMkLst>
            <pc:docMk/>
            <pc:sldMk cId="3299340242" sldId="342"/>
            <ac:picMk id="41" creationId="{9A12F9B0-9E6A-461C-BC75-FDE68199C9DA}"/>
          </ac:picMkLst>
        </pc:picChg>
      </pc:sldChg>
      <pc:sldChg chg="addSp delSp modSp add mod">
        <pc:chgData name="hayato kawachi" userId="3d62671f137ab6e0" providerId="LiveId" clId="{9DA759D2-3AF6-4AB4-98EB-6B60ADE6B3F6}" dt="2021-11-28T13:25:24.151" v="861" actId="1076"/>
        <pc:sldMkLst>
          <pc:docMk/>
          <pc:sldMk cId="443460557" sldId="343"/>
        </pc:sldMkLst>
        <pc:spChg chg="mod">
          <ac:chgData name="hayato kawachi" userId="3d62671f137ab6e0" providerId="LiveId" clId="{9DA759D2-3AF6-4AB4-98EB-6B60ADE6B3F6}" dt="2021-11-28T13:18:51.370" v="752" actId="20577"/>
          <ac:spMkLst>
            <pc:docMk/>
            <pc:sldMk cId="443460557" sldId="343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19:00.804" v="760" actId="20577"/>
          <ac:spMkLst>
            <pc:docMk/>
            <pc:sldMk cId="443460557" sldId="343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22:54.172" v="826" actId="20577"/>
          <ac:spMkLst>
            <pc:docMk/>
            <pc:sldMk cId="443460557" sldId="343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25:24.151" v="861" actId="1076"/>
          <ac:spMkLst>
            <pc:docMk/>
            <pc:sldMk cId="443460557" sldId="343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25:15.999" v="860" actId="1076"/>
          <ac:spMkLst>
            <pc:docMk/>
            <pc:sldMk cId="443460557" sldId="343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21:53.807" v="800" actId="20577"/>
          <ac:spMkLst>
            <pc:docMk/>
            <pc:sldMk cId="443460557" sldId="343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22:49.449" v="823" actId="20577"/>
          <ac:spMkLst>
            <pc:docMk/>
            <pc:sldMk cId="443460557" sldId="343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22:58.340" v="828" actId="20577"/>
          <ac:spMkLst>
            <pc:docMk/>
            <pc:sldMk cId="443460557" sldId="343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23:04.021" v="830" actId="20577"/>
          <ac:spMkLst>
            <pc:docMk/>
            <pc:sldMk cId="443460557" sldId="343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22:32.076" v="816" actId="20577"/>
          <ac:spMkLst>
            <pc:docMk/>
            <pc:sldMk cId="443460557" sldId="343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22:38.291" v="818" actId="20577"/>
          <ac:spMkLst>
            <pc:docMk/>
            <pc:sldMk cId="443460557" sldId="343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22:41.473" v="820" actId="20577"/>
          <ac:spMkLst>
            <pc:docMk/>
            <pc:sldMk cId="443460557" sldId="343"/>
            <ac:spMk id="73" creationId="{00000000-0000-0000-0000-000000000000}"/>
          </ac:spMkLst>
        </pc:spChg>
        <pc:picChg chg="del">
          <ac:chgData name="hayato kawachi" userId="3d62671f137ab6e0" providerId="LiveId" clId="{9DA759D2-3AF6-4AB4-98EB-6B60ADE6B3F6}" dt="2021-11-28T13:24:37.477" v="838" actId="478"/>
          <ac:picMkLst>
            <pc:docMk/>
            <pc:sldMk cId="443460557" sldId="343"/>
            <ac:picMk id="5" creationId="{32CA5A4C-F914-49E5-A752-7941AABD5D9B}"/>
          </ac:picMkLst>
        </pc:picChg>
        <pc:picChg chg="add mod ord">
          <ac:chgData name="hayato kawachi" userId="3d62671f137ab6e0" providerId="LiveId" clId="{9DA759D2-3AF6-4AB4-98EB-6B60ADE6B3F6}" dt="2021-11-28T13:24:50.800" v="859" actId="1037"/>
          <ac:picMkLst>
            <pc:docMk/>
            <pc:sldMk cId="443460557" sldId="343"/>
            <ac:picMk id="6" creationId="{A89B2019-62F2-4D8A-9242-7BB9B929D48C}"/>
          </ac:picMkLst>
        </pc:picChg>
      </pc:sldChg>
      <pc:sldChg chg="addSp delSp modSp add mod">
        <pc:chgData name="hayato kawachi" userId="3d62671f137ab6e0" providerId="LiveId" clId="{9DA759D2-3AF6-4AB4-98EB-6B60ADE6B3F6}" dt="2021-11-28T13:42:50.547" v="1046" actId="20577"/>
        <pc:sldMkLst>
          <pc:docMk/>
          <pc:sldMk cId="3856532166" sldId="344"/>
        </pc:sldMkLst>
        <pc:spChg chg="mod">
          <ac:chgData name="hayato kawachi" userId="3d62671f137ab6e0" providerId="LiveId" clId="{9DA759D2-3AF6-4AB4-98EB-6B60ADE6B3F6}" dt="2021-11-28T13:42:50.547" v="1046" actId="20577"/>
          <ac:spMkLst>
            <pc:docMk/>
            <pc:sldMk cId="3856532166" sldId="344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28:01.456" v="868" actId="20577"/>
          <ac:spMkLst>
            <pc:docMk/>
            <pc:sldMk cId="3856532166" sldId="344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35:57.693" v="922" actId="20577"/>
          <ac:spMkLst>
            <pc:docMk/>
            <pc:sldMk cId="3856532166" sldId="344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34:40.096" v="892" actId="20577"/>
          <ac:spMkLst>
            <pc:docMk/>
            <pc:sldMk cId="3856532166" sldId="344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37:35.813" v="949" actId="1076"/>
          <ac:spMkLst>
            <pc:docMk/>
            <pc:sldMk cId="3856532166" sldId="344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28:33.630" v="887" actId="20577"/>
          <ac:spMkLst>
            <pc:docMk/>
            <pc:sldMk cId="3856532166" sldId="344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35:51.075" v="919" actId="20577"/>
          <ac:spMkLst>
            <pc:docMk/>
            <pc:sldMk cId="3856532166" sldId="344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36:01.400" v="924" actId="20577"/>
          <ac:spMkLst>
            <pc:docMk/>
            <pc:sldMk cId="3856532166" sldId="344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36:09.093" v="926" actId="20577"/>
          <ac:spMkLst>
            <pc:docMk/>
            <pc:sldMk cId="3856532166" sldId="344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35:38.382" v="912" actId="20577"/>
          <ac:spMkLst>
            <pc:docMk/>
            <pc:sldMk cId="3856532166" sldId="344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35:41.091" v="914" actId="20577"/>
          <ac:spMkLst>
            <pc:docMk/>
            <pc:sldMk cId="3856532166" sldId="344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35:43.440" v="916" actId="20577"/>
          <ac:spMkLst>
            <pc:docMk/>
            <pc:sldMk cId="3856532166" sldId="344"/>
            <ac:spMk id="73" creationId="{00000000-0000-0000-0000-000000000000}"/>
          </ac:spMkLst>
        </pc:spChg>
        <pc:picChg chg="del">
          <ac:chgData name="hayato kawachi" userId="3d62671f137ab6e0" providerId="LiveId" clId="{9DA759D2-3AF6-4AB4-98EB-6B60ADE6B3F6}" dt="2021-11-28T13:36:44.237" v="930" actId="478"/>
          <ac:picMkLst>
            <pc:docMk/>
            <pc:sldMk cId="3856532166" sldId="344"/>
            <ac:picMk id="5" creationId="{32CA5A4C-F914-49E5-A752-7941AABD5D9B}"/>
          </ac:picMkLst>
        </pc:picChg>
        <pc:picChg chg="add mod ord">
          <ac:chgData name="hayato kawachi" userId="3d62671f137ab6e0" providerId="LiveId" clId="{9DA759D2-3AF6-4AB4-98EB-6B60ADE6B3F6}" dt="2021-11-28T13:37:22.762" v="948" actId="1076"/>
          <ac:picMkLst>
            <pc:docMk/>
            <pc:sldMk cId="3856532166" sldId="344"/>
            <ac:picMk id="6" creationId="{C6E8E2CB-84A0-463B-B53B-FDB893147839}"/>
          </ac:picMkLst>
        </pc:picChg>
      </pc:sldChg>
      <pc:sldChg chg="addSp delSp modSp add mod">
        <pc:chgData name="hayato kawachi" userId="3d62671f137ab6e0" providerId="LiveId" clId="{9DA759D2-3AF6-4AB4-98EB-6B60ADE6B3F6}" dt="2021-11-28T13:42:55.848" v="1051" actId="20577"/>
        <pc:sldMkLst>
          <pc:docMk/>
          <pc:sldMk cId="1102546100" sldId="345"/>
        </pc:sldMkLst>
        <pc:spChg chg="mod">
          <ac:chgData name="hayato kawachi" userId="3d62671f137ab6e0" providerId="LiveId" clId="{9DA759D2-3AF6-4AB4-98EB-6B60ADE6B3F6}" dt="2021-11-28T13:42:55.848" v="1051" actId="20577"/>
          <ac:spMkLst>
            <pc:docMk/>
            <pc:sldMk cId="1102546100" sldId="345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38:04.839" v="957" actId="20577"/>
          <ac:spMkLst>
            <pc:docMk/>
            <pc:sldMk cId="1102546100" sldId="345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42:28.191" v="1035" actId="20577"/>
          <ac:spMkLst>
            <pc:docMk/>
            <pc:sldMk cId="1102546100" sldId="345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41:15.052" v="1005" actId="1076"/>
          <ac:spMkLst>
            <pc:docMk/>
            <pc:sldMk cId="1102546100" sldId="345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41:18.584" v="1006" actId="1076"/>
          <ac:spMkLst>
            <pc:docMk/>
            <pc:sldMk cId="1102546100" sldId="345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38:58.358" v="983" actId="6549"/>
          <ac:spMkLst>
            <pc:docMk/>
            <pc:sldMk cId="1102546100" sldId="345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42:22.667" v="1031" actId="20577"/>
          <ac:spMkLst>
            <pc:docMk/>
            <pc:sldMk cId="1102546100" sldId="345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42:32.860" v="1037" actId="20577"/>
          <ac:spMkLst>
            <pc:docMk/>
            <pc:sldMk cId="1102546100" sldId="345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42:37.473" v="1041" actId="20577"/>
          <ac:spMkLst>
            <pc:docMk/>
            <pc:sldMk cId="1102546100" sldId="345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41:58.526" v="1023" actId="20577"/>
          <ac:spMkLst>
            <pc:docMk/>
            <pc:sldMk cId="1102546100" sldId="345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42:07.838" v="1025" actId="20577"/>
          <ac:spMkLst>
            <pc:docMk/>
            <pc:sldMk cId="1102546100" sldId="345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42:11.859" v="1027" actId="20577"/>
          <ac:spMkLst>
            <pc:docMk/>
            <pc:sldMk cId="1102546100" sldId="345"/>
            <ac:spMk id="73" creationId="{00000000-0000-0000-0000-000000000000}"/>
          </ac:spMkLst>
        </pc:spChg>
        <pc:picChg chg="del">
          <ac:chgData name="hayato kawachi" userId="3d62671f137ab6e0" providerId="LiveId" clId="{9DA759D2-3AF6-4AB4-98EB-6B60ADE6B3F6}" dt="2021-11-28T13:40:41.262" v="988" actId="478"/>
          <ac:picMkLst>
            <pc:docMk/>
            <pc:sldMk cId="1102546100" sldId="345"/>
            <ac:picMk id="5" creationId="{32CA5A4C-F914-49E5-A752-7941AABD5D9B}"/>
          </ac:picMkLst>
        </pc:picChg>
        <pc:picChg chg="add mod ord">
          <ac:chgData name="hayato kawachi" userId="3d62671f137ab6e0" providerId="LiveId" clId="{9DA759D2-3AF6-4AB4-98EB-6B60ADE6B3F6}" dt="2021-11-28T13:40:59.645" v="1004" actId="1035"/>
          <ac:picMkLst>
            <pc:docMk/>
            <pc:sldMk cId="1102546100" sldId="345"/>
            <ac:picMk id="6" creationId="{BFB708AF-AC13-48AD-BB5F-DF69097F1D11}"/>
          </ac:picMkLst>
        </pc:picChg>
      </pc:sldChg>
      <pc:sldChg chg="add del">
        <pc:chgData name="hayato kawachi" userId="3d62671f137ab6e0" providerId="LiveId" clId="{9DA759D2-3AF6-4AB4-98EB-6B60ADE6B3F6}" dt="2021-11-28T13:45:19.584" v="1053" actId="47"/>
        <pc:sldMkLst>
          <pc:docMk/>
          <pc:sldMk cId="1052128559" sldId="346"/>
        </pc:sldMkLst>
      </pc:sldChg>
      <pc:sldChg chg="addSp delSp modSp add mod">
        <pc:chgData name="hayato kawachi" userId="3d62671f137ab6e0" providerId="LiveId" clId="{9DA759D2-3AF6-4AB4-98EB-6B60ADE6B3F6}" dt="2021-11-28T13:54:45.010" v="1304" actId="20577"/>
        <pc:sldMkLst>
          <pc:docMk/>
          <pc:sldMk cId="2593710206" sldId="346"/>
        </pc:sldMkLst>
        <pc:spChg chg="mod">
          <ac:chgData name="hayato kawachi" userId="3d62671f137ab6e0" providerId="LiveId" clId="{9DA759D2-3AF6-4AB4-98EB-6B60ADE6B3F6}" dt="2021-11-28T13:53:03.409" v="1272" actId="20577"/>
          <ac:spMkLst>
            <pc:docMk/>
            <pc:sldMk cId="2593710206" sldId="346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0:26.082" v="1196"/>
          <ac:spMkLst>
            <pc:docMk/>
            <pc:sldMk cId="2593710206" sldId="346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54:38.585" v="1300" actId="20577"/>
          <ac:spMkLst>
            <pc:docMk/>
            <pc:sldMk cId="2593710206" sldId="346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3:30.234" v="1273" actId="1076"/>
          <ac:spMkLst>
            <pc:docMk/>
            <pc:sldMk cId="2593710206" sldId="346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53:42.821" v="1274" actId="1076"/>
          <ac:spMkLst>
            <pc:docMk/>
            <pc:sldMk cId="2593710206" sldId="346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50:08.172" v="1181"/>
          <ac:spMkLst>
            <pc:docMk/>
            <pc:sldMk cId="2593710206" sldId="346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54:34.189" v="1297" actId="20577"/>
          <ac:spMkLst>
            <pc:docMk/>
            <pc:sldMk cId="2593710206" sldId="346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54:41.858" v="1302" actId="20577"/>
          <ac:spMkLst>
            <pc:docMk/>
            <pc:sldMk cId="2593710206" sldId="346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4:45.010" v="1304" actId="20577"/>
          <ac:spMkLst>
            <pc:docMk/>
            <pc:sldMk cId="2593710206" sldId="346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4:18.610" v="1290" actId="20577"/>
          <ac:spMkLst>
            <pc:docMk/>
            <pc:sldMk cId="2593710206" sldId="346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4:24.159" v="1292" actId="20577"/>
          <ac:spMkLst>
            <pc:docMk/>
            <pc:sldMk cId="2593710206" sldId="346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4:27.794" v="1294" actId="20577"/>
          <ac:spMkLst>
            <pc:docMk/>
            <pc:sldMk cId="2593710206" sldId="346"/>
            <ac:spMk id="73" creationId="{00000000-0000-0000-0000-000000000000}"/>
          </ac:spMkLst>
        </pc:spChg>
        <pc:picChg chg="del">
          <ac:chgData name="hayato kawachi" userId="3d62671f137ab6e0" providerId="LiveId" clId="{9DA759D2-3AF6-4AB4-98EB-6B60ADE6B3F6}" dt="2021-11-28T13:52:21.062" v="1245" actId="478"/>
          <ac:picMkLst>
            <pc:docMk/>
            <pc:sldMk cId="2593710206" sldId="346"/>
            <ac:picMk id="5" creationId="{32CA5A4C-F914-49E5-A752-7941AABD5D9B}"/>
          </ac:picMkLst>
        </pc:picChg>
        <pc:picChg chg="add mod ord">
          <ac:chgData name="hayato kawachi" userId="3d62671f137ab6e0" providerId="LiveId" clId="{9DA759D2-3AF6-4AB4-98EB-6B60ADE6B3F6}" dt="2021-11-28T13:52:39.735" v="1269" actId="1037"/>
          <ac:picMkLst>
            <pc:docMk/>
            <pc:sldMk cId="2593710206" sldId="346"/>
            <ac:picMk id="6" creationId="{E942CDB1-C05B-4F1B-8739-BB3D3A1C7A59}"/>
          </ac:picMkLst>
        </pc:picChg>
      </pc:sldChg>
      <pc:sldChg chg="add del">
        <pc:chgData name="hayato kawachi" userId="3d62671f137ab6e0" providerId="LiveId" clId="{9DA759D2-3AF6-4AB4-98EB-6B60ADE6B3F6}" dt="2021-11-28T13:45:20.718" v="1054" actId="47"/>
        <pc:sldMkLst>
          <pc:docMk/>
          <pc:sldMk cId="162756179" sldId="347"/>
        </pc:sldMkLst>
      </pc:sldChg>
      <pc:sldChg chg="modSp add del mod">
        <pc:chgData name="hayato kawachi" userId="3d62671f137ab6e0" providerId="LiveId" clId="{9DA759D2-3AF6-4AB4-98EB-6B60ADE6B3F6}" dt="2021-11-28T14:02:45.156" v="1383" actId="47"/>
        <pc:sldMkLst>
          <pc:docMk/>
          <pc:sldMk cId="2281542420" sldId="347"/>
        </pc:sldMkLst>
        <pc:spChg chg="mod">
          <ac:chgData name="hayato kawachi" userId="3d62671f137ab6e0" providerId="LiveId" clId="{9DA759D2-3AF6-4AB4-98EB-6B60ADE6B3F6}" dt="2021-11-28T13:46:22.892" v="1118" actId="20577"/>
          <ac:spMkLst>
            <pc:docMk/>
            <pc:sldMk cId="2281542420" sldId="347"/>
            <ac:spMk id="2" creationId="{00000000-0000-0000-0000-000000000000}"/>
          </ac:spMkLst>
        </pc:spChg>
      </pc:sldChg>
      <pc:sldChg chg="add del">
        <pc:chgData name="hayato kawachi" userId="3d62671f137ab6e0" providerId="LiveId" clId="{9DA759D2-3AF6-4AB4-98EB-6B60ADE6B3F6}" dt="2021-11-28T13:45:21.843" v="1055" actId="47"/>
        <pc:sldMkLst>
          <pc:docMk/>
          <pc:sldMk cId="2894248297" sldId="348"/>
        </pc:sldMkLst>
      </pc:sldChg>
      <pc:sldChg chg="modSp add del mod">
        <pc:chgData name="hayato kawachi" userId="3d62671f137ab6e0" providerId="LiveId" clId="{9DA759D2-3AF6-4AB4-98EB-6B60ADE6B3F6}" dt="2021-11-28T14:02:46.663" v="1384" actId="47"/>
        <pc:sldMkLst>
          <pc:docMk/>
          <pc:sldMk cId="4045002677" sldId="348"/>
        </pc:sldMkLst>
        <pc:spChg chg="mod">
          <ac:chgData name="hayato kawachi" userId="3d62671f137ab6e0" providerId="LiveId" clId="{9DA759D2-3AF6-4AB4-98EB-6B60ADE6B3F6}" dt="2021-11-28T13:46:30.383" v="1128" actId="20577"/>
          <ac:spMkLst>
            <pc:docMk/>
            <pc:sldMk cId="4045002677" sldId="348"/>
            <ac:spMk id="2" creationId="{00000000-0000-0000-0000-000000000000}"/>
          </ac:spMkLst>
        </pc:spChg>
      </pc:sldChg>
      <pc:sldChg chg="addSp delSp modSp add mod">
        <pc:chgData name="hayato kawachi" userId="3d62671f137ab6e0" providerId="LiveId" clId="{9DA759D2-3AF6-4AB4-98EB-6B60ADE6B3F6}" dt="2021-11-28T13:59:01.609" v="1382" actId="1038"/>
        <pc:sldMkLst>
          <pc:docMk/>
          <pc:sldMk cId="2662816316" sldId="349"/>
        </pc:sldMkLst>
        <pc:spChg chg="mod">
          <ac:chgData name="hayato kawachi" userId="3d62671f137ab6e0" providerId="LiveId" clId="{9DA759D2-3AF6-4AB4-98EB-6B60ADE6B3F6}" dt="2021-11-28T13:46:50.948" v="1173"/>
          <ac:spMkLst>
            <pc:docMk/>
            <pc:sldMk cId="2662816316" sldId="349"/>
            <ac:spMk id="2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6:23.010" v="1306" actId="20577"/>
          <ac:spMkLst>
            <pc:docMk/>
            <pc:sldMk cId="2662816316" sldId="349"/>
            <ac:spMk id="33" creationId="{29F2463A-75AA-48A3-A5BF-2C3594115A43}"/>
          </ac:spMkLst>
        </pc:spChg>
        <pc:spChg chg="mod">
          <ac:chgData name="hayato kawachi" userId="3d62671f137ab6e0" providerId="LiveId" clId="{9DA759D2-3AF6-4AB4-98EB-6B60ADE6B3F6}" dt="2021-11-28T13:58:09.630" v="1353" actId="20577"/>
          <ac:spMkLst>
            <pc:docMk/>
            <pc:sldMk cId="2662816316" sldId="349"/>
            <ac:spMk id="3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6:40.407" v="1312" actId="20577"/>
          <ac:spMkLst>
            <pc:docMk/>
            <pc:sldMk cId="2662816316" sldId="349"/>
            <ac:spMk id="37" creationId="{3ED8FDAB-36D8-45DE-89D0-5DAAD4A3261D}"/>
          </ac:spMkLst>
        </pc:spChg>
        <pc:spChg chg="mod">
          <ac:chgData name="hayato kawachi" userId="3d62671f137ab6e0" providerId="LiveId" clId="{9DA759D2-3AF6-4AB4-98EB-6B60ADE6B3F6}" dt="2021-11-28T13:56:54.889" v="1320" actId="20577"/>
          <ac:spMkLst>
            <pc:docMk/>
            <pc:sldMk cId="2662816316" sldId="349"/>
            <ac:spMk id="38" creationId="{3FB751A9-8633-43EC-82C5-807F8581EEFA}"/>
          </ac:spMkLst>
        </pc:spChg>
        <pc:spChg chg="mod">
          <ac:chgData name="hayato kawachi" userId="3d62671f137ab6e0" providerId="LiveId" clId="{9DA759D2-3AF6-4AB4-98EB-6B60ADE6B3F6}" dt="2021-11-28T13:57:07.094" v="1330" actId="20577"/>
          <ac:spMkLst>
            <pc:docMk/>
            <pc:sldMk cId="2662816316" sldId="349"/>
            <ac:spMk id="39" creationId="{1B721CC6-56D4-4BD4-9D1B-18C0972D8A62}"/>
          </ac:spMkLst>
        </pc:spChg>
        <pc:spChg chg="mod">
          <ac:chgData name="hayato kawachi" userId="3d62671f137ab6e0" providerId="LiveId" clId="{9DA759D2-3AF6-4AB4-98EB-6B60ADE6B3F6}" dt="2021-11-28T13:57:20.515" v="1332" actId="20577"/>
          <ac:spMkLst>
            <pc:docMk/>
            <pc:sldMk cId="2662816316" sldId="349"/>
            <ac:spMk id="50" creationId="{E10074C8-9A6C-44D2-B375-7758BE6319F6}"/>
          </ac:spMkLst>
        </pc:spChg>
        <pc:spChg chg="mod">
          <ac:chgData name="hayato kawachi" userId="3d62671f137ab6e0" providerId="LiveId" clId="{9DA759D2-3AF6-4AB4-98EB-6B60ADE6B3F6}" dt="2021-11-28T13:58:15.497" v="1355" actId="20577"/>
          <ac:spMkLst>
            <pc:docMk/>
            <pc:sldMk cId="2662816316" sldId="349"/>
            <ac:spMk id="57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8:19.057" v="1357" actId="20577"/>
          <ac:spMkLst>
            <pc:docMk/>
            <pc:sldMk cId="2662816316" sldId="349"/>
            <ac:spMk id="61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7:53.197" v="1345" actId="20577"/>
          <ac:spMkLst>
            <pc:docMk/>
            <pc:sldMk cId="2662816316" sldId="349"/>
            <ac:spMk id="65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7:57.528" v="1347" actId="20577"/>
          <ac:spMkLst>
            <pc:docMk/>
            <pc:sldMk cId="2662816316" sldId="349"/>
            <ac:spMk id="69" creationId="{00000000-0000-0000-0000-000000000000}"/>
          </ac:spMkLst>
        </pc:spChg>
        <pc:spChg chg="mod">
          <ac:chgData name="hayato kawachi" userId="3d62671f137ab6e0" providerId="LiveId" clId="{9DA759D2-3AF6-4AB4-98EB-6B60ADE6B3F6}" dt="2021-11-28T13:58:00.516" v="1349" actId="20577"/>
          <ac:spMkLst>
            <pc:docMk/>
            <pc:sldMk cId="2662816316" sldId="349"/>
            <ac:spMk id="73" creationId="{00000000-0000-0000-0000-000000000000}"/>
          </ac:spMkLst>
        </pc:spChg>
        <pc:picChg chg="del">
          <ac:chgData name="hayato kawachi" userId="3d62671f137ab6e0" providerId="LiveId" clId="{9DA759D2-3AF6-4AB4-98EB-6B60ADE6B3F6}" dt="2021-11-28T13:58:48.651" v="1361" actId="478"/>
          <ac:picMkLst>
            <pc:docMk/>
            <pc:sldMk cId="2662816316" sldId="349"/>
            <ac:picMk id="5" creationId="{32CA5A4C-F914-49E5-A752-7941AABD5D9B}"/>
          </ac:picMkLst>
        </pc:picChg>
        <pc:picChg chg="add mod ord">
          <ac:chgData name="hayato kawachi" userId="3d62671f137ab6e0" providerId="LiveId" clId="{9DA759D2-3AF6-4AB4-98EB-6B60ADE6B3F6}" dt="2021-11-28T13:59:01.609" v="1382" actId="1038"/>
          <ac:picMkLst>
            <pc:docMk/>
            <pc:sldMk cId="2662816316" sldId="349"/>
            <ac:picMk id="6" creationId="{F8E2AA2C-829E-4CB8-93AC-54949A5F1E45}"/>
          </ac:picMkLst>
        </pc:picChg>
      </pc:sldChg>
    </pc:docChg>
  </pc:docChgLst>
  <pc:docChgLst>
    <pc:chgData name="hayato kawachi" userId="3d62671f137ab6e0" providerId="LiveId" clId="{DB04560C-556B-4A0D-8815-8300505C8A90}"/>
    <pc:docChg chg="delSld">
      <pc:chgData name="hayato kawachi" userId="3d62671f137ab6e0" providerId="LiveId" clId="{DB04560C-556B-4A0D-8815-8300505C8A90}" dt="2022-03-06T06:14:49.231" v="5" actId="47"/>
      <pc:docMkLst>
        <pc:docMk/>
      </pc:docMkLst>
      <pc:sldChg chg="del">
        <pc:chgData name="hayato kawachi" userId="3d62671f137ab6e0" providerId="LiveId" clId="{DB04560C-556B-4A0D-8815-8300505C8A90}" dt="2022-03-06T06:14:46.587" v="0" actId="47"/>
        <pc:sldMkLst>
          <pc:docMk/>
          <pc:sldMk cId="216619969" sldId="283"/>
        </pc:sldMkLst>
      </pc:sldChg>
      <pc:sldChg chg="del">
        <pc:chgData name="hayato kawachi" userId="3d62671f137ab6e0" providerId="LiveId" clId="{DB04560C-556B-4A0D-8815-8300505C8A90}" dt="2022-03-06T06:14:49.231" v="5" actId="47"/>
        <pc:sldMkLst>
          <pc:docMk/>
          <pc:sldMk cId="1571256114" sldId="311"/>
        </pc:sldMkLst>
      </pc:sldChg>
      <pc:sldChg chg="del">
        <pc:chgData name="hayato kawachi" userId="3d62671f137ab6e0" providerId="LiveId" clId="{DB04560C-556B-4A0D-8815-8300505C8A90}" dt="2022-03-06T06:14:48.965" v="4" actId="47"/>
        <pc:sldMkLst>
          <pc:docMk/>
          <pc:sldMk cId="1507186253" sldId="315"/>
        </pc:sldMkLst>
      </pc:sldChg>
      <pc:sldChg chg="del">
        <pc:chgData name="hayato kawachi" userId="3d62671f137ab6e0" providerId="LiveId" clId="{DB04560C-556B-4A0D-8815-8300505C8A90}" dt="2022-03-06T06:14:48.735" v="3" actId="47"/>
        <pc:sldMkLst>
          <pc:docMk/>
          <pc:sldMk cId="2460127092" sldId="319"/>
        </pc:sldMkLst>
      </pc:sldChg>
      <pc:sldChg chg="del">
        <pc:chgData name="hayato kawachi" userId="3d62671f137ab6e0" providerId="LiveId" clId="{DB04560C-556B-4A0D-8815-8300505C8A90}" dt="2022-03-06T06:14:48.576" v="2" actId="47"/>
        <pc:sldMkLst>
          <pc:docMk/>
          <pc:sldMk cId="3184214258" sldId="320"/>
        </pc:sldMkLst>
      </pc:sldChg>
      <pc:sldChg chg="del">
        <pc:chgData name="hayato kawachi" userId="3d62671f137ab6e0" providerId="LiveId" clId="{DB04560C-556B-4A0D-8815-8300505C8A90}" dt="2022-03-06T06:14:48.406" v="1" actId="47"/>
        <pc:sldMkLst>
          <pc:docMk/>
          <pc:sldMk cId="2663189720" sldId="321"/>
        </pc:sldMkLst>
      </pc:sldChg>
    </pc:docChg>
  </pc:docChgLst>
  <pc:docChgLst>
    <pc:chgData name="hayato kawachi" userId="3d62671f137ab6e0" providerId="LiveId" clId="{6B835C9C-5A28-4A98-84F0-B7948C68F133}"/>
    <pc:docChg chg="custSel addSld delSld modSld">
      <pc:chgData name="hayato kawachi" userId="3d62671f137ab6e0" providerId="LiveId" clId="{6B835C9C-5A28-4A98-84F0-B7948C68F133}" dt="2022-03-01T05:50:26.466" v="928" actId="6549"/>
      <pc:docMkLst>
        <pc:docMk/>
      </pc:docMkLst>
      <pc:sldChg chg="modSp mod">
        <pc:chgData name="hayato kawachi" userId="3d62671f137ab6e0" providerId="LiveId" clId="{6B835C9C-5A28-4A98-84F0-B7948C68F133}" dt="2022-03-01T05:44:24.008" v="244" actId="1035"/>
        <pc:sldMkLst>
          <pc:docMk/>
          <pc:sldMk cId="216619969" sldId="283"/>
        </pc:sldMkLst>
        <pc:spChg chg="mod">
          <ac:chgData name="hayato kawachi" userId="3d62671f137ab6e0" providerId="LiveId" clId="{6B835C9C-5A28-4A98-84F0-B7948C68F133}" dt="2022-03-01T05:41:20.338" v="65" actId="20577"/>
          <ac:spMkLst>
            <pc:docMk/>
            <pc:sldMk cId="216619969" sldId="283"/>
            <ac:spMk id="33" creationId="{AA508394-E198-497C-A5C3-D12695FD7FA7}"/>
          </ac:spMkLst>
        </pc:spChg>
        <pc:spChg chg="mod">
          <ac:chgData name="hayato kawachi" userId="3d62671f137ab6e0" providerId="LiveId" clId="{6B835C9C-5A28-4A98-84F0-B7948C68F133}" dt="2022-03-01T05:44:24.008" v="244" actId="1035"/>
          <ac:spMkLst>
            <pc:docMk/>
            <pc:sldMk cId="216619969" sldId="283"/>
            <ac:spMk id="56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5:33.724" v="296" actId="20577"/>
        <pc:sldMkLst>
          <pc:docMk/>
          <pc:sldMk cId="3974256553" sldId="309"/>
        </pc:sldMkLst>
        <pc:spChg chg="mod">
          <ac:chgData name="hayato kawachi" userId="3d62671f137ab6e0" providerId="LiveId" clId="{6B835C9C-5A28-4A98-84F0-B7948C68F133}" dt="2022-03-01T05:45:33.724" v="296" actId="20577"/>
          <ac:spMkLst>
            <pc:docMk/>
            <pc:sldMk cId="3974256553" sldId="309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5:54.218" v="338" actId="20577"/>
        <pc:sldMkLst>
          <pc:docMk/>
          <pc:sldMk cId="1571256114" sldId="311"/>
        </pc:sldMkLst>
        <pc:spChg chg="mod">
          <ac:chgData name="hayato kawachi" userId="3d62671f137ab6e0" providerId="LiveId" clId="{6B835C9C-5A28-4A98-84F0-B7948C68F133}" dt="2022-03-01T05:45:54.218" v="338" actId="20577"/>
          <ac:spMkLst>
            <pc:docMk/>
            <pc:sldMk cId="1571256114" sldId="311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7:20.263" v="478" actId="20577"/>
        <pc:sldMkLst>
          <pc:docMk/>
          <pc:sldMk cId="1507186253" sldId="315"/>
        </pc:sldMkLst>
        <pc:spChg chg="mod">
          <ac:chgData name="hayato kawachi" userId="3d62671f137ab6e0" providerId="LiveId" clId="{6B835C9C-5A28-4A98-84F0-B7948C68F133}" dt="2022-03-01T05:47:20.263" v="478" actId="20577"/>
          <ac:spMkLst>
            <pc:docMk/>
            <pc:sldMk cId="1507186253" sldId="315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6:31.273" v="376" actId="20577"/>
        <pc:sldMkLst>
          <pc:docMk/>
          <pc:sldMk cId="322658806" sldId="316"/>
        </pc:sldMkLst>
        <pc:spChg chg="mod">
          <ac:chgData name="hayato kawachi" userId="3d62671f137ab6e0" providerId="LiveId" clId="{6B835C9C-5A28-4A98-84F0-B7948C68F133}" dt="2022-03-01T05:46:31.273" v="376" actId="20577"/>
          <ac:spMkLst>
            <pc:docMk/>
            <pc:sldMk cId="322658806" sldId="316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7:41.869" v="557" actId="6549"/>
        <pc:sldMkLst>
          <pc:docMk/>
          <pc:sldMk cId="3840021381" sldId="317"/>
        </pc:sldMkLst>
        <pc:spChg chg="mod">
          <ac:chgData name="hayato kawachi" userId="3d62671f137ab6e0" providerId="LiveId" clId="{6B835C9C-5A28-4A98-84F0-B7948C68F133}" dt="2022-03-01T05:47:41.869" v="557" actId="6549"/>
          <ac:spMkLst>
            <pc:docMk/>
            <pc:sldMk cId="3840021381" sldId="317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8:42.631" v="654" actId="14100"/>
        <pc:sldMkLst>
          <pc:docMk/>
          <pc:sldMk cId="2460127092" sldId="319"/>
        </pc:sldMkLst>
        <pc:spChg chg="mod">
          <ac:chgData name="hayato kawachi" userId="3d62671f137ab6e0" providerId="LiveId" clId="{6B835C9C-5A28-4A98-84F0-B7948C68F133}" dt="2022-03-01T05:48:42.631" v="654" actId="14100"/>
          <ac:spMkLst>
            <pc:docMk/>
            <pc:sldMk cId="2460127092" sldId="319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49:04.737" v="715" actId="552"/>
        <pc:sldMkLst>
          <pc:docMk/>
          <pc:sldMk cId="3184214258" sldId="320"/>
        </pc:sldMkLst>
        <pc:spChg chg="mod">
          <ac:chgData name="hayato kawachi" userId="3d62671f137ab6e0" providerId="LiveId" clId="{6B835C9C-5A28-4A98-84F0-B7948C68F133}" dt="2022-03-01T05:49:04.737" v="715" actId="552"/>
          <ac:spMkLst>
            <pc:docMk/>
            <pc:sldMk cId="3184214258" sldId="320"/>
            <ac:spMk id="2" creationId="{00000000-0000-0000-0000-000000000000}"/>
          </ac:spMkLst>
        </pc:spChg>
      </pc:sldChg>
      <pc:sldChg chg="modSp mod">
        <pc:chgData name="hayato kawachi" userId="3d62671f137ab6e0" providerId="LiveId" clId="{6B835C9C-5A28-4A98-84F0-B7948C68F133}" dt="2022-03-01T05:50:06.444" v="875" actId="255"/>
        <pc:sldMkLst>
          <pc:docMk/>
          <pc:sldMk cId="2663189720" sldId="321"/>
        </pc:sldMkLst>
        <pc:spChg chg="mod">
          <ac:chgData name="hayato kawachi" userId="3d62671f137ab6e0" providerId="LiveId" clId="{6B835C9C-5A28-4A98-84F0-B7948C68F133}" dt="2022-03-01T05:50:06.444" v="875" actId="255"/>
          <ac:spMkLst>
            <pc:docMk/>
            <pc:sldMk cId="2663189720" sldId="321"/>
            <ac:spMk id="2" creationId="{00000000-0000-0000-0000-000000000000}"/>
          </ac:spMkLst>
        </pc:spChg>
      </pc:sldChg>
      <pc:sldChg chg="addSp delSp modSp mod">
        <pc:chgData name="hayato kawachi" userId="3d62671f137ab6e0" providerId="LiveId" clId="{6B835C9C-5A28-4A98-84F0-B7948C68F133}" dt="2022-03-01T05:49:30.704" v="780" actId="552"/>
        <pc:sldMkLst>
          <pc:docMk/>
          <pc:sldMk cId="3120795257" sldId="322"/>
        </pc:sldMkLst>
        <pc:spChg chg="mod">
          <ac:chgData name="hayato kawachi" userId="3d62671f137ab6e0" providerId="LiveId" clId="{6B835C9C-5A28-4A98-84F0-B7948C68F133}" dt="2022-03-01T05:49:30.704" v="780" actId="552"/>
          <ac:spMkLst>
            <pc:docMk/>
            <pc:sldMk cId="3120795257" sldId="322"/>
            <ac:spMk id="2" creationId="{00000000-0000-0000-0000-000000000000}"/>
          </ac:spMkLst>
        </pc:spChg>
        <pc:picChg chg="del">
          <ac:chgData name="hayato kawachi" userId="3d62671f137ab6e0" providerId="LiveId" clId="{6B835C9C-5A28-4A98-84F0-B7948C68F133}" dt="2022-02-21T11:15:37.006" v="6" actId="478"/>
          <ac:picMkLst>
            <pc:docMk/>
            <pc:sldMk cId="3120795257" sldId="322"/>
            <ac:picMk id="40" creationId="{8C6AA4A8-88AB-4F11-94F7-86D66E969FBE}"/>
          </ac:picMkLst>
        </pc:picChg>
        <pc:picChg chg="add mod ord">
          <ac:chgData name="hayato kawachi" userId="3d62671f137ab6e0" providerId="LiveId" clId="{6B835C9C-5A28-4A98-84F0-B7948C68F133}" dt="2022-02-21T11:17:37.320" v="33" actId="1036"/>
          <ac:picMkLst>
            <pc:docMk/>
            <pc:sldMk cId="3120795257" sldId="322"/>
            <ac:picMk id="41" creationId="{4DABA710-994D-4FF4-9056-B0ACD5145FEA}"/>
          </ac:picMkLst>
        </pc:picChg>
      </pc:sldChg>
      <pc:sldChg chg="modSp mod">
        <pc:chgData name="hayato kawachi" userId="3d62671f137ab6e0" providerId="LiveId" clId="{6B835C9C-5A28-4A98-84F0-B7948C68F133}" dt="2022-03-01T05:50:26.466" v="928" actId="6549"/>
        <pc:sldMkLst>
          <pc:docMk/>
          <pc:sldMk cId="228181719" sldId="323"/>
        </pc:sldMkLst>
        <pc:spChg chg="mod">
          <ac:chgData name="hayato kawachi" userId="3d62671f137ab6e0" providerId="LiveId" clId="{6B835C9C-5A28-4A98-84F0-B7948C68F133}" dt="2022-03-01T05:50:26.466" v="928" actId="6549"/>
          <ac:spMkLst>
            <pc:docMk/>
            <pc:sldMk cId="228181719" sldId="323"/>
            <ac:spMk id="2" creationId="{00000000-0000-0000-0000-000000000000}"/>
          </ac:spMkLst>
        </pc:spChg>
      </pc:sldChg>
      <pc:sldChg chg="addSp new del mod">
        <pc:chgData name="hayato kawachi" userId="3d62671f137ab6e0" providerId="LiveId" clId="{6B835C9C-5A28-4A98-84F0-B7948C68F133}" dt="2022-02-21T11:15:54.663" v="30" actId="47"/>
        <pc:sldMkLst>
          <pc:docMk/>
          <pc:sldMk cId="3304027739" sldId="324"/>
        </pc:sldMkLst>
        <pc:picChg chg="add">
          <ac:chgData name="hayato kawachi" userId="3d62671f137ab6e0" providerId="LiveId" clId="{6B835C9C-5A28-4A98-84F0-B7948C68F133}" dt="2022-02-21T11:15:11.020" v="1" actId="22"/>
          <ac:picMkLst>
            <pc:docMk/>
            <pc:sldMk cId="3304027739" sldId="324"/>
            <ac:picMk id="3" creationId="{3408E3A5-94BA-49CD-B741-1DA6A3D3B64B}"/>
          </ac:picMkLst>
        </pc:picChg>
      </pc:sldChg>
    </pc:docChg>
  </pc:docChgLst>
  <pc:docChgLst>
    <pc:chgData name="hayato kawachi" userId="3d62671f137ab6e0" providerId="LiveId" clId="{8273DE0A-6436-4874-BA8C-9063327110AE}"/>
    <pc:docChg chg="delSld modSld">
      <pc:chgData name="hayato kawachi" userId="3d62671f137ab6e0" providerId="LiveId" clId="{8273DE0A-6436-4874-BA8C-9063327110AE}" dt="2022-03-06T03:18:14.690" v="41" actId="20577"/>
      <pc:docMkLst>
        <pc:docMk/>
      </pc:docMkLst>
      <pc:sldChg chg="modSp mod">
        <pc:chgData name="hayato kawachi" userId="3d62671f137ab6e0" providerId="LiveId" clId="{8273DE0A-6436-4874-BA8C-9063327110AE}" dt="2022-03-01T11:05:41.305" v="7" actId="1076"/>
        <pc:sldMkLst>
          <pc:docMk/>
          <pc:sldMk cId="216619969" sldId="283"/>
        </pc:sldMkLst>
        <pc:spChg chg="mod">
          <ac:chgData name="hayato kawachi" userId="3d62671f137ab6e0" providerId="LiveId" clId="{8273DE0A-6436-4874-BA8C-9063327110AE}" dt="2022-03-01T11:05:41.305" v="7" actId="1076"/>
          <ac:spMkLst>
            <pc:docMk/>
            <pc:sldMk cId="216619969" sldId="283"/>
            <ac:spMk id="43" creationId="{929F15B9-502E-4938-A774-1F6D383B671D}"/>
          </ac:spMkLst>
        </pc:spChg>
      </pc:sldChg>
      <pc:sldChg chg="modSp mod">
        <pc:chgData name="hayato kawachi" userId="3d62671f137ab6e0" providerId="LiveId" clId="{8273DE0A-6436-4874-BA8C-9063327110AE}" dt="2022-03-06T03:13:29.550" v="17" actId="20577"/>
        <pc:sldMkLst>
          <pc:docMk/>
          <pc:sldMk cId="3974256553" sldId="309"/>
        </pc:sldMkLst>
        <pc:spChg chg="mod">
          <ac:chgData name="hayato kawachi" userId="3d62671f137ab6e0" providerId="LiveId" clId="{8273DE0A-6436-4874-BA8C-9063327110AE}" dt="2022-03-06T03:13:29.550" v="17" actId="20577"/>
          <ac:spMkLst>
            <pc:docMk/>
            <pc:sldMk cId="3974256553" sldId="309"/>
            <ac:spMk id="2" creationId="{00000000-0000-0000-0000-000000000000}"/>
          </ac:spMkLst>
        </pc:spChg>
      </pc:sldChg>
      <pc:sldChg chg="modSp mod">
        <pc:chgData name="hayato kawachi" userId="3d62671f137ab6e0" providerId="LiveId" clId="{8273DE0A-6436-4874-BA8C-9063327110AE}" dt="2022-03-06T03:17:44.619" v="21" actId="20577"/>
        <pc:sldMkLst>
          <pc:docMk/>
          <pc:sldMk cId="1571256114" sldId="311"/>
        </pc:sldMkLst>
        <pc:spChg chg="mod">
          <ac:chgData name="hayato kawachi" userId="3d62671f137ab6e0" providerId="LiveId" clId="{8273DE0A-6436-4874-BA8C-9063327110AE}" dt="2022-03-06T03:17:44.619" v="21" actId="20577"/>
          <ac:spMkLst>
            <pc:docMk/>
            <pc:sldMk cId="1571256114" sldId="311"/>
            <ac:spMk id="2" creationId="{00000000-0000-0000-0000-000000000000}"/>
          </ac:spMkLst>
        </pc:spChg>
      </pc:sldChg>
      <pc:sldChg chg="modSp mod">
        <pc:chgData name="hayato kawachi" userId="3d62671f137ab6e0" providerId="LiveId" clId="{8273DE0A-6436-4874-BA8C-9063327110AE}" dt="2022-03-06T03:17:50.752" v="27" actId="20577"/>
        <pc:sldMkLst>
          <pc:docMk/>
          <pc:sldMk cId="1507186253" sldId="315"/>
        </pc:sldMkLst>
        <pc:spChg chg="mod">
          <ac:chgData name="hayato kawachi" userId="3d62671f137ab6e0" providerId="LiveId" clId="{8273DE0A-6436-4874-BA8C-9063327110AE}" dt="2022-03-06T03:17:50.752" v="27" actId="20577"/>
          <ac:spMkLst>
            <pc:docMk/>
            <pc:sldMk cId="1507186253" sldId="315"/>
            <ac:spMk id="2" creationId="{00000000-0000-0000-0000-000000000000}"/>
          </ac:spMkLst>
        </pc:spChg>
      </pc:sldChg>
      <pc:sldChg chg="del">
        <pc:chgData name="hayato kawachi" userId="3d62671f137ab6e0" providerId="LiveId" clId="{8273DE0A-6436-4874-BA8C-9063327110AE}" dt="2022-03-01T05:51:13.308" v="0" actId="47"/>
        <pc:sldMkLst>
          <pc:docMk/>
          <pc:sldMk cId="322658806" sldId="316"/>
        </pc:sldMkLst>
      </pc:sldChg>
      <pc:sldChg chg="del">
        <pc:chgData name="hayato kawachi" userId="3d62671f137ab6e0" providerId="LiveId" clId="{8273DE0A-6436-4874-BA8C-9063327110AE}" dt="2022-03-01T05:51:16.554" v="1" actId="47"/>
        <pc:sldMkLst>
          <pc:docMk/>
          <pc:sldMk cId="3840021381" sldId="317"/>
        </pc:sldMkLst>
      </pc:sldChg>
      <pc:sldChg chg="modSp mod">
        <pc:chgData name="hayato kawachi" userId="3d62671f137ab6e0" providerId="LiveId" clId="{8273DE0A-6436-4874-BA8C-9063327110AE}" dt="2022-03-06T03:18:02.577" v="31" actId="20577"/>
        <pc:sldMkLst>
          <pc:docMk/>
          <pc:sldMk cId="2460127092" sldId="319"/>
        </pc:sldMkLst>
        <pc:spChg chg="mod">
          <ac:chgData name="hayato kawachi" userId="3d62671f137ab6e0" providerId="LiveId" clId="{8273DE0A-6436-4874-BA8C-9063327110AE}" dt="2022-03-06T03:18:02.577" v="31" actId="20577"/>
          <ac:spMkLst>
            <pc:docMk/>
            <pc:sldMk cId="2460127092" sldId="319"/>
            <ac:spMk id="2" creationId="{00000000-0000-0000-0000-000000000000}"/>
          </ac:spMkLst>
        </pc:spChg>
      </pc:sldChg>
      <pc:sldChg chg="modSp mod">
        <pc:chgData name="hayato kawachi" userId="3d62671f137ab6e0" providerId="LiveId" clId="{8273DE0A-6436-4874-BA8C-9063327110AE}" dt="2022-03-06T03:18:08.622" v="35" actId="20577"/>
        <pc:sldMkLst>
          <pc:docMk/>
          <pc:sldMk cId="3184214258" sldId="320"/>
        </pc:sldMkLst>
        <pc:spChg chg="mod">
          <ac:chgData name="hayato kawachi" userId="3d62671f137ab6e0" providerId="LiveId" clId="{8273DE0A-6436-4874-BA8C-9063327110AE}" dt="2022-03-06T03:18:08.622" v="35" actId="20577"/>
          <ac:spMkLst>
            <pc:docMk/>
            <pc:sldMk cId="3184214258" sldId="320"/>
            <ac:spMk id="2" creationId="{00000000-0000-0000-0000-000000000000}"/>
          </ac:spMkLst>
        </pc:spChg>
      </pc:sldChg>
      <pc:sldChg chg="modSp mod">
        <pc:chgData name="hayato kawachi" userId="3d62671f137ab6e0" providerId="LiveId" clId="{8273DE0A-6436-4874-BA8C-9063327110AE}" dt="2022-03-06T03:18:14.690" v="41" actId="20577"/>
        <pc:sldMkLst>
          <pc:docMk/>
          <pc:sldMk cId="2663189720" sldId="321"/>
        </pc:sldMkLst>
        <pc:spChg chg="mod">
          <ac:chgData name="hayato kawachi" userId="3d62671f137ab6e0" providerId="LiveId" clId="{8273DE0A-6436-4874-BA8C-9063327110AE}" dt="2022-03-06T03:18:14.690" v="41" actId="20577"/>
          <ac:spMkLst>
            <pc:docMk/>
            <pc:sldMk cId="2663189720" sldId="321"/>
            <ac:spMk id="2" creationId="{00000000-0000-0000-0000-000000000000}"/>
          </ac:spMkLst>
        </pc:spChg>
      </pc:sldChg>
      <pc:sldChg chg="del">
        <pc:chgData name="hayato kawachi" userId="3d62671f137ab6e0" providerId="LiveId" clId="{8273DE0A-6436-4874-BA8C-9063327110AE}" dt="2022-03-01T05:51:27.147" v="2" actId="47"/>
        <pc:sldMkLst>
          <pc:docMk/>
          <pc:sldMk cId="3120795257" sldId="322"/>
        </pc:sldMkLst>
      </pc:sldChg>
      <pc:sldChg chg="del">
        <pc:chgData name="hayato kawachi" userId="3d62671f137ab6e0" providerId="LiveId" clId="{8273DE0A-6436-4874-BA8C-9063327110AE}" dt="2022-03-01T05:51:28.756" v="3" actId="47"/>
        <pc:sldMkLst>
          <pc:docMk/>
          <pc:sldMk cId="228181719" sldId="323"/>
        </pc:sldMkLst>
      </pc:sldChg>
    </pc:docChg>
  </pc:docChgLst>
  <pc:docChgLst>
    <pc:chgData name="hayato kawachi" userId="3d62671f137ab6e0" providerId="LiveId" clId="{4416E229-5B0E-46C2-BCD2-E4FDB29F65FE}"/>
    <pc:docChg chg="modSld">
      <pc:chgData name="hayato kawachi" userId="3d62671f137ab6e0" providerId="LiveId" clId="{4416E229-5B0E-46C2-BCD2-E4FDB29F65FE}" dt="2022-03-06T03:46:35.691" v="23" actId="20577"/>
      <pc:docMkLst>
        <pc:docMk/>
      </pc:docMkLst>
      <pc:sldChg chg="modSp mod">
        <pc:chgData name="hayato kawachi" userId="3d62671f137ab6e0" providerId="LiveId" clId="{4416E229-5B0E-46C2-BCD2-E4FDB29F65FE}" dt="2022-03-06T03:46:13.970" v="3" actId="20577"/>
        <pc:sldMkLst>
          <pc:docMk/>
          <pc:sldMk cId="3974256553" sldId="309"/>
        </pc:sldMkLst>
        <pc:spChg chg="mod">
          <ac:chgData name="hayato kawachi" userId="3d62671f137ab6e0" providerId="LiveId" clId="{4416E229-5B0E-46C2-BCD2-E4FDB29F65FE}" dt="2022-03-06T03:46:13.970" v="3" actId="20577"/>
          <ac:spMkLst>
            <pc:docMk/>
            <pc:sldMk cId="3974256553" sldId="309"/>
            <ac:spMk id="2" creationId="{00000000-0000-0000-0000-000000000000}"/>
          </ac:spMkLst>
        </pc:spChg>
      </pc:sldChg>
      <pc:sldChg chg="modSp mod">
        <pc:chgData name="hayato kawachi" userId="3d62671f137ab6e0" providerId="LiveId" clId="{4416E229-5B0E-46C2-BCD2-E4FDB29F65FE}" dt="2022-03-06T03:46:17.573" v="7" actId="20577"/>
        <pc:sldMkLst>
          <pc:docMk/>
          <pc:sldMk cId="1571256114" sldId="311"/>
        </pc:sldMkLst>
        <pc:spChg chg="mod">
          <ac:chgData name="hayato kawachi" userId="3d62671f137ab6e0" providerId="LiveId" clId="{4416E229-5B0E-46C2-BCD2-E4FDB29F65FE}" dt="2022-03-06T03:46:17.573" v="7" actId="20577"/>
          <ac:spMkLst>
            <pc:docMk/>
            <pc:sldMk cId="1571256114" sldId="311"/>
            <ac:spMk id="2" creationId="{00000000-0000-0000-0000-000000000000}"/>
          </ac:spMkLst>
        </pc:spChg>
      </pc:sldChg>
      <pc:sldChg chg="modSp mod">
        <pc:chgData name="hayato kawachi" userId="3d62671f137ab6e0" providerId="LiveId" clId="{4416E229-5B0E-46C2-BCD2-E4FDB29F65FE}" dt="2022-03-06T03:46:21.181" v="11" actId="20577"/>
        <pc:sldMkLst>
          <pc:docMk/>
          <pc:sldMk cId="1507186253" sldId="315"/>
        </pc:sldMkLst>
        <pc:spChg chg="mod">
          <ac:chgData name="hayato kawachi" userId="3d62671f137ab6e0" providerId="LiveId" clId="{4416E229-5B0E-46C2-BCD2-E4FDB29F65FE}" dt="2022-03-06T03:46:21.181" v="11" actId="20577"/>
          <ac:spMkLst>
            <pc:docMk/>
            <pc:sldMk cId="1507186253" sldId="315"/>
            <ac:spMk id="2" creationId="{00000000-0000-0000-0000-000000000000}"/>
          </ac:spMkLst>
        </pc:spChg>
      </pc:sldChg>
      <pc:sldChg chg="modSp mod">
        <pc:chgData name="hayato kawachi" userId="3d62671f137ab6e0" providerId="LiveId" clId="{4416E229-5B0E-46C2-BCD2-E4FDB29F65FE}" dt="2022-03-06T03:46:25.911" v="15" actId="20577"/>
        <pc:sldMkLst>
          <pc:docMk/>
          <pc:sldMk cId="2460127092" sldId="319"/>
        </pc:sldMkLst>
        <pc:spChg chg="mod">
          <ac:chgData name="hayato kawachi" userId="3d62671f137ab6e0" providerId="LiveId" clId="{4416E229-5B0E-46C2-BCD2-E4FDB29F65FE}" dt="2022-03-06T03:46:25.911" v="15" actId="20577"/>
          <ac:spMkLst>
            <pc:docMk/>
            <pc:sldMk cId="2460127092" sldId="319"/>
            <ac:spMk id="2" creationId="{00000000-0000-0000-0000-000000000000}"/>
          </ac:spMkLst>
        </pc:spChg>
      </pc:sldChg>
      <pc:sldChg chg="modSp mod">
        <pc:chgData name="hayato kawachi" userId="3d62671f137ab6e0" providerId="LiveId" clId="{4416E229-5B0E-46C2-BCD2-E4FDB29F65FE}" dt="2022-03-06T03:46:31.989" v="19" actId="20577"/>
        <pc:sldMkLst>
          <pc:docMk/>
          <pc:sldMk cId="3184214258" sldId="320"/>
        </pc:sldMkLst>
        <pc:spChg chg="mod">
          <ac:chgData name="hayato kawachi" userId="3d62671f137ab6e0" providerId="LiveId" clId="{4416E229-5B0E-46C2-BCD2-E4FDB29F65FE}" dt="2022-03-06T03:46:31.989" v="19" actId="20577"/>
          <ac:spMkLst>
            <pc:docMk/>
            <pc:sldMk cId="3184214258" sldId="320"/>
            <ac:spMk id="2" creationId="{00000000-0000-0000-0000-000000000000}"/>
          </ac:spMkLst>
        </pc:spChg>
      </pc:sldChg>
      <pc:sldChg chg="modSp mod">
        <pc:chgData name="hayato kawachi" userId="3d62671f137ab6e0" providerId="LiveId" clId="{4416E229-5B0E-46C2-BCD2-E4FDB29F65FE}" dt="2022-03-06T03:46:35.691" v="23" actId="20577"/>
        <pc:sldMkLst>
          <pc:docMk/>
          <pc:sldMk cId="2663189720" sldId="321"/>
        </pc:sldMkLst>
        <pc:spChg chg="mod">
          <ac:chgData name="hayato kawachi" userId="3d62671f137ab6e0" providerId="LiveId" clId="{4416E229-5B0E-46C2-BCD2-E4FDB29F65FE}" dt="2022-03-06T03:46:35.691" v="23" actId="20577"/>
          <ac:spMkLst>
            <pc:docMk/>
            <pc:sldMk cId="2663189720" sldId="321"/>
            <ac:spMk id="2" creationId="{00000000-0000-0000-0000-000000000000}"/>
          </ac:spMkLst>
        </pc:spChg>
      </pc:sldChg>
    </pc:docChg>
  </pc:docChgLst>
  <pc:docChgLst>
    <pc:chgData name="hayato kawachi" userId="3d62671f137ab6e0" providerId="LiveId" clId="{C20C878D-8684-4CB5-A807-DEC940797302}"/>
    <pc:docChg chg="undo redo custSel addSld delSld modSld sldOrd">
      <pc:chgData name="hayato kawachi" userId="3d62671f137ab6e0" providerId="LiveId" clId="{C20C878D-8684-4CB5-A807-DEC940797302}" dt="2021-10-17T15:20:45.866" v="1141" actId="20577"/>
      <pc:docMkLst>
        <pc:docMk/>
      </pc:docMkLst>
      <pc:sldChg chg="modSp mod">
        <pc:chgData name="hayato kawachi" userId="3d62671f137ab6e0" providerId="LiveId" clId="{C20C878D-8684-4CB5-A807-DEC940797302}" dt="2021-10-17T12:05:04.179" v="465" actId="20577"/>
        <pc:sldMkLst>
          <pc:docMk/>
          <pc:sldMk cId="216619969" sldId="283"/>
        </pc:sldMkLst>
        <pc:spChg chg="mod">
          <ac:chgData name="hayato kawachi" userId="3d62671f137ab6e0" providerId="LiveId" clId="{C20C878D-8684-4CB5-A807-DEC940797302}" dt="2021-10-17T12:05:04.179" v="465" actId="20577"/>
          <ac:spMkLst>
            <pc:docMk/>
            <pc:sldMk cId="216619969" sldId="283"/>
            <ac:spMk id="62" creationId="{490070DA-7E2C-4015-B6C9-4581F63E838A}"/>
          </ac:spMkLst>
        </pc:spChg>
        <pc:spChg chg="mod">
          <ac:chgData name="hayato kawachi" userId="3d62671f137ab6e0" providerId="LiveId" clId="{C20C878D-8684-4CB5-A807-DEC940797302}" dt="2021-10-17T12:05:01.820" v="463" actId="20577"/>
          <ac:spMkLst>
            <pc:docMk/>
            <pc:sldMk cId="216619969" sldId="283"/>
            <ac:spMk id="64" creationId="{6BD38B94-B562-431C-8AB0-03875060A0BB}"/>
          </ac:spMkLst>
        </pc:spChg>
      </pc:sldChg>
      <pc:sldChg chg="addSp delSp modSp mod">
        <pc:chgData name="hayato kawachi" userId="3d62671f137ab6e0" providerId="LiveId" clId="{C20C878D-8684-4CB5-A807-DEC940797302}" dt="2021-10-17T12:15:39.701" v="503" actId="20577"/>
        <pc:sldMkLst>
          <pc:docMk/>
          <pc:sldMk cId="3974256553" sldId="309"/>
        </pc:sldMkLst>
        <pc:spChg chg="mod">
          <ac:chgData name="hayato kawachi" userId="3d62671f137ab6e0" providerId="LiveId" clId="{C20C878D-8684-4CB5-A807-DEC940797302}" dt="2021-10-17T12:10:13.292" v="469" actId="20577"/>
          <ac:spMkLst>
            <pc:docMk/>
            <pc:sldMk cId="3974256553" sldId="309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2:10:11.103" v="467" actId="20577"/>
          <ac:spMkLst>
            <pc:docMk/>
            <pc:sldMk cId="3974256553" sldId="309"/>
            <ac:spMk id="33" creationId="{29F2463A-75AA-48A3-A5BF-2C3594115A43}"/>
          </ac:spMkLst>
        </pc:spChg>
        <pc:spChg chg="mod">
          <ac:chgData name="hayato kawachi" userId="3d62671f137ab6e0" providerId="LiveId" clId="{C20C878D-8684-4CB5-A807-DEC940797302}" dt="2021-10-17T12:15:20.654" v="501" actId="20577"/>
          <ac:spMkLst>
            <pc:docMk/>
            <pc:sldMk cId="3974256553" sldId="309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2:14:31.417" v="493" actId="20577"/>
          <ac:spMkLst>
            <pc:docMk/>
            <pc:sldMk cId="3974256553" sldId="309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12:12:58.978" v="471" actId="20577"/>
          <ac:spMkLst>
            <pc:docMk/>
            <pc:sldMk cId="3974256553" sldId="309"/>
            <ac:spMk id="39" creationId="{1B721CC6-56D4-4BD4-9D1B-18C0972D8A62}"/>
          </ac:spMkLst>
        </pc:spChg>
        <pc:spChg chg="mod">
          <ac:chgData name="hayato kawachi" userId="3d62671f137ab6e0" providerId="LiveId" clId="{C20C878D-8684-4CB5-A807-DEC940797302}" dt="2021-10-17T12:15:03.459" v="495" actId="20577"/>
          <ac:spMkLst>
            <pc:docMk/>
            <pc:sldMk cId="3974256553" sldId="309"/>
            <ac:spMk id="50" creationId="{E10074C8-9A6C-44D2-B375-7758BE6319F6}"/>
          </ac:spMkLst>
        </pc:spChg>
        <pc:spChg chg="mod">
          <ac:chgData name="hayato kawachi" userId="3d62671f137ab6e0" providerId="LiveId" clId="{C20C878D-8684-4CB5-A807-DEC940797302}" dt="2021-10-17T12:15:39.701" v="503" actId="20577"/>
          <ac:spMkLst>
            <pc:docMk/>
            <pc:sldMk cId="3974256553" sldId="309"/>
            <ac:spMk id="61" creationId="{00000000-0000-0000-0000-000000000000}"/>
          </ac:spMkLst>
        </pc:spChg>
        <pc:picChg chg="add mod ord">
          <ac:chgData name="hayato kawachi" userId="3d62671f137ab6e0" providerId="LiveId" clId="{C20C878D-8684-4CB5-A807-DEC940797302}" dt="2021-10-17T12:14:02.865" v="489" actId="1037"/>
          <ac:picMkLst>
            <pc:docMk/>
            <pc:sldMk cId="3974256553" sldId="309"/>
            <ac:picMk id="40" creationId="{917C2BE5-1ED9-4C06-A123-6B3FE957320B}"/>
          </ac:picMkLst>
        </pc:picChg>
        <pc:picChg chg="del">
          <ac:chgData name="hayato kawachi" userId="3d62671f137ab6e0" providerId="LiveId" clId="{C20C878D-8684-4CB5-A807-DEC940797302}" dt="2021-10-17T12:13:35.930" v="477" actId="478"/>
          <ac:picMkLst>
            <pc:docMk/>
            <pc:sldMk cId="3974256553" sldId="309"/>
            <ac:picMk id="41" creationId="{1411E4AC-4033-46F2-A6BE-E895E5B70B9C}"/>
          </ac:picMkLst>
        </pc:picChg>
      </pc:sldChg>
      <pc:sldChg chg="del">
        <pc:chgData name="hayato kawachi" userId="3d62671f137ab6e0" providerId="LiveId" clId="{C20C878D-8684-4CB5-A807-DEC940797302}" dt="2021-10-17T03:00:26.026" v="0" actId="47"/>
        <pc:sldMkLst>
          <pc:docMk/>
          <pc:sldMk cId="1780759030" sldId="310"/>
        </pc:sldMkLst>
      </pc:sldChg>
      <pc:sldChg chg="addSp delSp modSp mod">
        <pc:chgData name="hayato kawachi" userId="3d62671f137ab6e0" providerId="LiveId" clId="{C20C878D-8684-4CB5-A807-DEC940797302}" dt="2021-10-17T12:42:32.351" v="675" actId="20577"/>
        <pc:sldMkLst>
          <pc:docMk/>
          <pc:sldMk cId="1571256114" sldId="311"/>
        </pc:sldMkLst>
        <pc:spChg chg="mod">
          <ac:chgData name="hayato kawachi" userId="3d62671f137ab6e0" providerId="LiveId" clId="{C20C878D-8684-4CB5-A807-DEC940797302}" dt="2021-10-17T12:42:32.351" v="675" actId="20577"/>
          <ac:spMkLst>
            <pc:docMk/>
            <pc:sldMk cId="1571256114" sldId="311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2:41:40.867" v="669" actId="20577"/>
          <ac:spMkLst>
            <pc:docMk/>
            <pc:sldMk cId="1571256114" sldId="311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2:18:26.270" v="511" actId="20577"/>
          <ac:spMkLst>
            <pc:docMk/>
            <pc:sldMk cId="1571256114" sldId="311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12:23:01.754" v="619" actId="20577"/>
          <ac:spMkLst>
            <pc:docMk/>
            <pc:sldMk cId="1571256114" sldId="311"/>
            <ac:spMk id="39" creationId="{1B721CC6-56D4-4BD4-9D1B-18C0972D8A62}"/>
          </ac:spMkLst>
        </pc:spChg>
        <pc:spChg chg="add del mod">
          <ac:chgData name="hayato kawachi" userId="3d62671f137ab6e0" providerId="LiveId" clId="{C20C878D-8684-4CB5-A807-DEC940797302}" dt="2021-10-17T12:19:21.707" v="538"/>
          <ac:spMkLst>
            <pc:docMk/>
            <pc:sldMk cId="1571256114" sldId="311"/>
            <ac:spMk id="40" creationId="{94140FD6-1EE5-4C6F-95D9-4306E285135B}"/>
          </ac:spMkLst>
        </pc:spChg>
        <pc:spChg chg="mod">
          <ac:chgData name="hayato kawachi" userId="3d62671f137ab6e0" providerId="LiveId" clId="{C20C878D-8684-4CB5-A807-DEC940797302}" dt="2021-10-17T12:42:19.389" v="673" actId="20577"/>
          <ac:spMkLst>
            <pc:docMk/>
            <pc:sldMk cId="1571256114" sldId="311"/>
            <ac:spMk id="43" creationId="{FCF209F4-3112-40D3-B484-4BE2BCF1C86D}"/>
          </ac:spMkLst>
        </pc:spChg>
        <pc:spChg chg="mod">
          <ac:chgData name="hayato kawachi" userId="3d62671f137ab6e0" providerId="LiveId" clId="{C20C878D-8684-4CB5-A807-DEC940797302}" dt="2021-10-17T12:41:14.029" v="665" actId="20577"/>
          <ac:spMkLst>
            <pc:docMk/>
            <pc:sldMk cId="1571256114" sldId="311"/>
            <ac:spMk id="47" creationId="{8B72101C-BE11-4C80-8D28-74E638A82CF8}"/>
          </ac:spMkLst>
        </pc:spChg>
        <pc:spChg chg="mod">
          <ac:chgData name="hayato kawachi" userId="3d62671f137ab6e0" providerId="LiveId" clId="{C20C878D-8684-4CB5-A807-DEC940797302}" dt="2021-10-17T12:41:21.547" v="667" actId="20577"/>
          <ac:spMkLst>
            <pc:docMk/>
            <pc:sldMk cId="1571256114" sldId="311"/>
            <ac:spMk id="50" creationId="{E10074C8-9A6C-44D2-B375-7758BE6319F6}"/>
          </ac:spMkLst>
        </pc:spChg>
        <pc:spChg chg="add del mod">
          <ac:chgData name="hayato kawachi" userId="3d62671f137ab6e0" providerId="LiveId" clId="{C20C878D-8684-4CB5-A807-DEC940797302}" dt="2021-10-17T12:19:23.846" v="542"/>
          <ac:spMkLst>
            <pc:docMk/>
            <pc:sldMk cId="1571256114" sldId="311"/>
            <ac:spMk id="51" creationId="{BFB4D78A-0F70-489A-B2EE-9016F337FD48}"/>
          </ac:spMkLst>
        </pc:spChg>
        <pc:spChg chg="mod">
          <ac:chgData name="hayato kawachi" userId="3d62671f137ab6e0" providerId="LiveId" clId="{C20C878D-8684-4CB5-A807-DEC940797302}" dt="2021-10-17T12:41:51.971" v="671" actId="20577"/>
          <ac:spMkLst>
            <pc:docMk/>
            <pc:sldMk cId="1571256114" sldId="311"/>
            <ac:spMk id="57" creationId="{00000000-0000-0000-0000-000000000000}"/>
          </ac:spMkLst>
        </pc:spChg>
        <pc:picChg chg="del">
          <ac:chgData name="hayato kawachi" userId="3d62671f137ab6e0" providerId="LiveId" clId="{C20C878D-8684-4CB5-A807-DEC940797302}" dt="2021-10-17T12:36:39.100" v="627" actId="478"/>
          <ac:picMkLst>
            <pc:docMk/>
            <pc:sldMk cId="1571256114" sldId="311"/>
            <ac:picMk id="41" creationId="{3FFC67E1-CAA9-41DB-AC96-14E9602E4657}"/>
          </ac:picMkLst>
        </pc:picChg>
        <pc:picChg chg="add mod ord">
          <ac:chgData name="hayato kawachi" userId="3d62671f137ab6e0" providerId="LiveId" clId="{C20C878D-8684-4CB5-A807-DEC940797302}" dt="2021-10-17T12:37:23.671" v="652" actId="1038"/>
          <ac:picMkLst>
            <pc:docMk/>
            <pc:sldMk cId="1571256114" sldId="311"/>
            <ac:picMk id="54" creationId="{9D577BB2-769A-4CB8-B70A-7DB4D6D5239B}"/>
          </ac:picMkLst>
        </pc:picChg>
      </pc:sldChg>
      <pc:sldChg chg="del">
        <pc:chgData name="hayato kawachi" userId="3d62671f137ab6e0" providerId="LiveId" clId="{C20C878D-8684-4CB5-A807-DEC940797302}" dt="2021-10-17T03:00:54.008" v="1" actId="47"/>
        <pc:sldMkLst>
          <pc:docMk/>
          <pc:sldMk cId="3852358235" sldId="312"/>
        </pc:sldMkLst>
      </pc:sldChg>
      <pc:sldChg chg="del">
        <pc:chgData name="hayato kawachi" userId="3d62671f137ab6e0" providerId="LiveId" clId="{C20C878D-8684-4CB5-A807-DEC940797302}" dt="2021-10-17T03:00:55.862" v="2" actId="47"/>
        <pc:sldMkLst>
          <pc:docMk/>
          <pc:sldMk cId="4047624437" sldId="313"/>
        </pc:sldMkLst>
      </pc:sldChg>
      <pc:sldChg chg="del">
        <pc:chgData name="hayato kawachi" userId="3d62671f137ab6e0" providerId="LiveId" clId="{C20C878D-8684-4CB5-A807-DEC940797302}" dt="2021-10-17T03:00:57.675" v="3" actId="47"/>
        <pc:sldMkLst>
          <pc:docMk/>
          <pc:sldMk cId="761655977" sldId="314"/>
        </pc:sldMkLst>
      </pc:sldChg>
      <pc:sldChg chg="addSp delSp modSp mod">
        <pc:chgData name="hayato kawachi" userId="3d62671f137ab6e0" providerId="LiveId" clId="{C20C878D-8684-4CB5-A807-DEC940797302}" dt="2021-10-17T14:54:19.068" v="951" actId="20577"/>
        <pc:sldMkLst>
          <pc:docMk/>
          <pc:sldMk cId="1507186253" sldId="315"/>
        </pc:sldMkLst>
        <pc:spChg chg="mod">
          <ac:chgData name="hayato kawachi" userId="3d62671f137ab6e0" providerId="LiveId" clId="{C20C878D-8684-4CB5-A807-DEC940797302}" dt="2021-10-17T14:54:19.009" v="949" actId="20577"/>
          <ac:spMkLst>
            <pc:docMk/>
            <pc:sldMk cId="1507186253" sldId="315"/>
            <ac:spMk id="35" creationId="{00000000-0000-0000-0000-000000000000}"/>
          </ac:spMkLst>
        </pc:spChg>
        <pc:spChg chg="add mod">
          <ac:chgData name="hayato kawachi" userId="3d62671f137ab6e0" providerId="LiveId" clId="{C20C878D-8684-4CB5-A807-DEC940797302}" dt="2021-10-17T14:52:44.476" v="907" actId="20577"/>
          <ac:spMkLst>
            <pc:docMk/>
            <pc:sldMk cId="1507186253" sldId="315"/>
            <ac:spMk id="40" creationId="{A0CCB378-2481-4C18-BC52-DB71A9E83295}"/>
          </ac:spMkLst>
        </pc:spChg>
        <pc:spChg chg="mod">
          <ac:chgData name="hayato kawachi" userId="3d62671f137ab6e0" providerId="LiveId" clId="{C20C878D-8684-4CB5-A807-DEC940797302}" dt="2021-10-17T14:54:18.711" v="939" actId="20577"/>
          <ac:spMkLst>
            <pc:docMk/>
            <pc:sldMk cId="1507186253" sldId="315"/>
            <ac:spMk id="43" creationId="{CE8A4983-AE32-44E5-B7C3-04B70FF944E9}"/>
          </ac:spMkLst>
        </pc:spChg>
        <pc:spChg chg="mod">
          <ac:chgData name="hayato kawachi" userId="3d62671f137ab6e0" providerId="LiveId" clId="{C20C878D-8684-4CB5-A807-DEC940797302}" dt="2021-10-17T14:54:18.651" v="937" actId="20577"/>
          <ac:spMkLst>
            <pc:docMk/>
            <pc:sldMk cId="1507186253" sldId="315"/>
            <ac:spMk id="45" creationId="{8EB91309-2FAF-43D9-ACD3-BA0E2BDE36D9}"/>
          </ac:spMkLst>
        </pc:spChg>
        <pc:spChg chg="mod">
          <ac:chgData name="hayato kawachi" userId="3d62671f137ab6e0" providerId="LiveId" clId="{C20C878D-8684-4CB5-A807-DEC940797302}" dt="2021-10-17T14:54:19.068" v="951" actId="20577"/>
          <ac:spMkLst>
            <pc:docMk/>
            <pc:sldMk cId="1507186253" sldId="315"/>
            <ac:spMk id="50" creationId="{E10074C8-9A6C-44D2-B375-7758BE6319F6}"/>
          </ac:spMkLst>
        </pc:spChg>
        <pc:spChg chg="del mod">
          <ac:chgData name="hayato kawachi" userId="3d62671f137ab6e0" providerId="LiveId" clId="{C20C878D-8684-4CB5-A807-DEC940797302}" dt="2021-10-17T14:52:24.144" v="885" actId="478"/>
          <ac:spMkLst>
            <pc:docMk/>
            <pc:sldMk cId="1507186253" sldId="315"/>
            <ac:spMk id="53" creationId="{1FB50F88-B6D0-4B32-83D0-D60F6E12E6F7}"/>
          </ac:spMkLst>
        </pc:spChg>
        <pc:spChg chg="mod">
          <ac:chgData name="hayato kawachi" userId="3d62671f137ab6e0" providerId="LiveId" clId="{C20C878D-8684-4CB5-A807-DEC940797302}" dt="2021-10-17T14:54:18.949" v="947" actId="20577"/>
          <ac:spMkLst>
            <pc:docMk/>
            <pc:sldMk cId="1507186253" sldId="315"/>
            <ac:spMk id="57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4:18.890" v="945" actId="20577"/>
          <ac:spMkLst>
            <pc:docMk/>
            <pc:sldMk cId="1507186253" sldId="315"/>
            <ac:spMk id="61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4:18.829" v="943" actId="20577"/>
          <ac:spMkLst>
            <pc:docMk/>
            <pc:sldMk cId="1507186253" sldId="315"/>
            <ac:spMk id="6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4:18.772" v="941" actId="20577"/>
          <ac:spMkLst>
            <pc:docMk/>
            <pc:sldMk cId="1507186253" sldId="315"/>
            <ac:spMk id="69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4:18.126" v="935" actId="20577"/>
          <ac:spMkLst>
            <pc:docMk/>
            <pc:sldMk cId="1507186253" sldId="315"/>
            <ac:spMk id="73" creationId="{00000000-0000-0000-0000-000000000000}"/>
          </ac:spMkLst>
        </pc:spChg>
      </pc:sldChg>
      <pc:sldChg chg="addSp delSp modSp mod ord">
        <pc:chgData name="hayato kawachi" userId="3d62671f137ab6e0" providerId="LiveId" clId="{C20C878D-8684-4CB5-A807-DEC940797302}" dt="2021-10-17T12:49:43.952" v="725" actId="20577"/>
        <pc:sldMkLst>
          <pc:docMk/>
          <pc:sldMk cId="322658806" sldId="316"/>
        </pc:sldMkLst>
        <pc:spChg chg="mod">
          <ac:chgData name="hayato kawachi" userId="3d62671f137ab6e0" providerId="LiveId" clId="{C20C878D-8684-4CB5-A807-DEC940797302}" dt="2021-10-17T12:49:43.952" v="725" actId="20577"/>
          <ac:spMkLst>
            <pc:docMk/>
            <pc:sldMk cId="322658806" sldId="316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2:44:42.496" v="687" actId="20577"/>
          <ac:spMkLst>
            <pc:docMk/>
            <pc:sldMk cId="322658806" sldId="316"/>
            <ac:spMk id="33" creationId="{29F2463A-75AA-48A3-A5BF-2C3594115A43}"/>
          </ac:spMkLst>
        </pc:spChg>
        <pc:spChg chg="mod">
          <ac:chgData name="hayato kawachi" userId="3d62671f137ab6e0" providerId="LiveId" clId="{C20C878D-8684-4CB5-A807-DEC940797302}" dt="2021-10-17T12:48:29.539" v="693" actId="20577"/>
          <ac:spMkLst>
            <pc:docMk/>
            <pc:sldMk cId="322658806" sldId="316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2:44:27.447" v="677" actId="20577"/>
          <ac:spMkLst>
            <pc:docMk/>
            <pc:sldMk cId="322658806" sldId="316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12:44:38.227" v="685" actId="20577"/>
          <ac:spMkLst>
            <pc:docMk/>
            <pc:sldMk cId="322658806" sldId="316"/>
            <ac:spMk id="39" creationId="{1B721CC6-56D4-4BD4-9D1B-18C0972D8A62}"/>
          </ac:spMkLst>
        </pc:spChg>
        <pc:spChg chg="mod">
          <ac:chgData name="hayato kawachi" userId="3d62671f137ab6e0" providerId="LiveId" clId="{C20C878D-8684-4CB5-A807-DEC940797302}" dt="2021-10-17T12:47:44.517" v="689" actId="20577"/>
          <ac:spMkLst>
            <pc:docMk/>
            <pc:sldMk cId="322658806" sldId="316"/>
            <ac:spMk id="50" creationId="{E10074C8-9A6C-44D2-B375-7758BE6319F6}"/>
          </ac:spMkLst>
        </pc:spChg>
        <pc:picChg chg="del">
          <ac:chgData name="hayato kawachi" userId="3d62671f137ab6e0" providerId="LiveId" clId="{C20C878D-8684-4CB5-A807-DEC940797302}" dt="2021-10-17T12:49:01.643" v="699" actId="478"/>
          <ac:picMkLst>
            <pc:docMk/>
            <pc:sldMk cId="322658806" sldId="316"/>
            <ac:picMk id="4" creationId="{64E1501D-25F3-4A68-968A-A495078EF778}"/>
          </ac:picMkLst>
        </pc:picChg>
        <pc:picChg chg="add mod ord">
          <ac:chgData name="hayato kawachi" userId="3d62671f137ab6e0" providerId="LiveId" clId="{C20C878D-8684-4CB5-A807-DEC940797302}" dt="2021-10-17T12:49:29.544" v="721" actId="1036"/>
          <ac:picMkLst>
            <pc:docMk/>
            <pc:sldMk cId="322658806" sldId="316"/>
            <ac:picMk id="40" creationId="{8EE4D8AE-F829-4454-994D-ED54119F99EA}"/>
          </ac:picMkLst>
        </pc:picChg>
      </pc:sldChg>
      <pc:sldChg chg="addSp delSp modSp mod">
        <pc:chgData name="hayato kawachi" userId="3d62671f137ab6e0" providerId="LiveId" clId="{C20C878D-8684-4CB5-A807-DEC940797302}" dt="2021-10-17T14:52:54.168" v="909"/>
        <pc:sldMkLst>
          <pc:docMk/>
          <pc:sldMk cId="3840021381" sldId="317"/>
        </pc:sldMkLst>
        <pc:spChg chg="add del mod">
          <ac:chgData name="hayato kawachi" userId="3d62671f137ab6e0" providerId="LiveId" clId="{C20C878D-8684-4CB5-A807-DEC940797302}" dt="2021-10-17T14:52:53.950" v="908" actId="478"/>
          <ac:spMkLst>
            <pc:docMk/>
            <pc:sldMk cId="3840021381" sldId="317"/>
            <ac:spMk id="41" creationId="{1B8BEDDA-B31D-429C-A311-43F5DFE2D145}"/>
          </ac:spMkLst>
        </pc:spChg>
        <pc:spChg chg="add mod">
          <ac:chgData name="hayato kawachi" userId="3d62671f137ab6e0" providerId="LiveId" clId="{C20C878D-8684-4CB5-A807-DEC940797302}" dt="2021-10-17T14:52:54.168" v="909"/>
          <ac:spMkLst>
            <pc:docMk/>
            <pc:sldMk cId="3840021381" sldId="317"/>
            <ac:spMk id="46" creationId="{1C76D1D0-273A-4A80-9EE8-F89CF6284E6C}"/>
          </ac:spMkLst>
        </pc:spChg>
        <pc:spChg chg="del">
          <ac:chgData name="hayato kawachi" userId="3d62671f137ab6e0" providerId="LiveId" clId="{C20C878D-8684-4CB5-A807-DEC940797302}" dt="2021-10-17T14:52:03.636" v="863" actId="478"/>
          <ac:spMkLst>
            <pc:docMk/>
            <pc:sldMk cId="3840021381" sldId="317"/>
            <ac:spMk id="53" creationId="{1FB50F88-B6D0-4B32-83D0-D60F6E12E6F7}"/>
          </ac:spMkLst>
        </pc:spChg>
      </pc:sldChg>
      <pc:sldChg chg="addSp modSp new mod">
        <pc:chgData name="hayato kawachi" userId="3d62671f137ab6e0" providerId="LiveId" clId="{C20C878D-8684-4CB5-A807-DEC940797302}" dt="2021-10-17T03:01:40.111" v="71" actId="1076"/>
        <pc:sldMkLst>
          <pc:docMk/>
          <pc:sldMk cId="163190479" sldId="318"/>
        </pc:sldMkLst>
        <pc:spChg chg="add mod">
          <ac:chgData name="hayato kawachi" userId="3d62671f137ab6e0" providerId="LiveId" clId="{C20C878D-8684-4CB5-A807-DEC940797302}" dt="2021-10-17T03:01:40.111" v="71" actId="1076"/>
          <ac:spMkLst>
            <pc:docMk/>
            <pc:sldMk cId="163190479" sldId="318"/>
            <ac:spMk id="2" creationId="{FE0D19BB-235A-44AB-A32F-F610D8B3FF1B}"/>
          </ac:spMkLst>
        </pc:spChg>
      </pc:sldChg>
      <pc:sldChg chg="addSp delSp modSp add mod">
        <pc:chgData name="hayato kawachi" userId="3d62671f137ab6e0" providerId="LiveId" clId="{C20C878D-8684-4CB5-A807-DEC940797302}" dt="2021-10-17T14:55:37.758" v="985"/>
        <pc:sldMkLst>
          <pc:docMk/>
          <pc:sldMk cId="2460127092" sldId="319"/>
        </pc:sldMkLst>
        <pc:spChg chg="mod">
          <ac:chgData name="hayato kawachi" userId="3d62671f137ab6e0" providerId="LiveId" clId="{C20C878D-8684-4CB5-A807-DEC940797302}" dt="2021-10-17T14:55:21.709" v="975" actId="20577"/>
          <ac:spMkLst>
            <pc:docMk/>
            <pc:sldMk cId="2460127092" sldId="319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5:27.021" v="983" actId="20577"/>
          <ac:spMkLst>
            <pc:docMk/>
            <pc:sldMk cId="2460127092" sldId="319"/>
            <ac:spMk id="33" creationId="{29F2463A-75AA-48A3-A5BF-2C3594115A43}"/>
          </ac:spMkLst>
        </pc:spChg>
        <pc:spChg chg="mod">
          <ac:chgData name="hayato kawachi" userId="3d62671f137ab6e0" providerId="LiveId" clId="{C20C878D-8684-4CB5-A807-DEC940797302}" dt="2021-10-17T03:14:05.504" v="210" actId="20577"/>
          <ac:spMkLst>
            <pc:docMk/>
            <pc:sldMk cId="2460127092" sldId="319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11:10.233" v="182" actId="1076"/>
          <ac:spMkLst>
            <pc:docMk/>
            <pc:sldMk cId="2460127092" sldId="319"/>
            <ac:spMk id="37" creationId="{3ED8FDAB-36D8-45DE-89D0-5DAAD4A3261D}"/>
          </ac:spMkLst>
        </pc:spChg>
        <pc:spChg chg="mod">
          <ac:chgData name="hayato kawachi" userId="3d62671f137ab6e0" providerId="LiveId" clId="{C20C878D-8684-4CB5-A807-DEC940797302}" dt="2021-10-17T03:11:08.019" v="181" actId="1076"/>
          <ac:spMkLst>
            <pc:docMk/>
            <pc:sldMk cId="2460127092" sldId="319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03:05:17.416" v="138"/>
          <ac:spMkLst>
            <pc:docMk/>
            <pc:sldMk cId="2460127092" sldId="319"/>
            <ac:spMk id="39" creationId="{1B721CC6-56D4-4BD4-9D1B-18C0972D8A62}"/>
          </ac:spMkLst>
        </pc:spChg>
        <pc:spChg chg="add del mod">
          <ac:chgData name="hayato kawachi" userId="3d62671f137ab6e0" providerId="LiveId" clId="{C20C878D-8684-4CB5-A807-DEC940797302}" dt="2021-10-17T14:55:37.523" v="984" actId="478"/>
          <ac:spMkLst>
            <pc:docMk/>
            <pc:sldMk cId="2460127092" sldId="319"/>
            <ac:spMk id="41" creationId="{D1C3662C-61B6-4862-8CD1-8177299ADCBD}"/>
          </ac:spMkLst>
        </pc:spChg>
        <pc:spChg chg="add mod">
          <ac:chgData name="hayato kawachi" userId="3d62671f137ab6e0" providerId="LiveId" clId="{C20C878D-8684-4CB5-A807-DEC940797302}" dt="2021-10-17T14:55:37.758" v="985"/>
          <ac:spMkLst>
            <pc:docMk/>
            <pc:sldMk cId="2460127092" sldId="319"/>
            <ac:spMk id="42" creationId="{0327A1DA-81BE-416E-9C5D-F34729FB5687}"/>
          </ac:spMkLst>
        </pc:spChg>
        <pc:spChg chg="mod">
          <ac:chgData name="hayato kawachi" userId="3d62671f137ab6e0" providerId="LiveId" clId="{C20C878D-8684-4CB5-A807-DEC940797302}" dt="2021-10-17T03:11:43.085" v="190" actId="20577"/>
          <ac:spMkLst>
            <pc:docMk/>
            <pc:sldMk cId="2460127092" sldId="319"/>
            <ac:spMk id="50" creationId="{E10074C8-9A6C-44D2-B375-7758BE6319F6}"/>
          </ac:spMkLst>
        </pc:spChg>
        <pc:spChg chg="del">
          <ac:chgData name="hayato kawachi" userId="3d62671f137ab6e0" providerId="LiveId" clId="{C20C878D-8684-4CB5-A807-DEC940797302}" dt="2021-10-17T14:52:58.480" v="910" actId="478"/>
          <ac:spMkLst>
            <pc:docMk/>
            <pc:sldMk cId="2460127092" sldId="319"/>
            <ac:spMk id="53" creationId="{1FB50F88-B6D0-4B32-83D0-D60F6E12E6F7}"/>
          </ac:spMkLst>
        </pc:spChg>
        <pc:spChg chg="mod">
          <ac:chgData name="hayato kawachi" userId="3d62671f137ab6e0" providerId="LiveId" clId="{C20C878D-8684-4CB5-A807-DEC940797302}" dt="2021-10-17T03:14:13.136" v="214" actId="20577"/>
          <ac:spMkLst>
            <pc:docMk/>
            <pc:sldMk cId="2460127092" sldId="319"/>
            <ac:spMk id="57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14:20.248" v="216" actId="20577"/>
          <ac:spMkLst>
            <pc:docMk/>
            <pc:sldMk cId="2460127092" sldId="319"/>
            <ac:spMk id="61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13:26.635" v="202" actId="20577"/>
          <ac:spMkLst>
            <pc:docMk/>
            <pc:sldMk cId="2460127092" sldId="319"/>
            <ac:spMk id="6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13:31.558" v="204" actId="20577"/>
          <ac:spMkLst>
            <pc:docMk/>
            <pc:sldMk cId="2460127092" sldId="319"/>
            <ac:spMk id="69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13:44.767" v="206" actId="20577"/>
          <ac:spMkLst>
            <pc:docMk/>
            <pc:sldMk cId="2460127092" sldId="319"/>
            <ac:spMk id="73" creationId="{00000000-0000-0000-0000-000000000000}"/>
          </ac:spMkLst>
        </pc:spChg>
        <pc:picChg chg="add mod ord">
          <ac:chgData name="hayato kawachi" userId="3d62671f137ab6e0" providerId="LiveId" clId="{C20C878D-8684-4CB5-A807-DEC940797302}" dt="2021-10-17T03:10:56.448" v="180" actId="1038"/>
          <ac:picMkLst>
            <pc:docMk/>
            <pc:sldMk cId="2460127092" sldId="319"/>
            <ac:picMk id="40" creationId="{D4900121-FDE2-4AA1-BB2F-01D1F6648DBB}"/>
          </ac:picMkLst>
        </pc:picChg>
        <pc:picChg chg="del">
          <ac:chgData name="hayato kawachi" userId="3d62671f137ab6e0" providerId="LiveId" clId="{C20C878D-8684-4CB5-A807-DEC940797302}" dt="2021-10-17T03:10:13.732" v="165" actId="478"/>
          <ac:picMkLst>
            <pc:docMk/>
            <pc:sldMk cId="2460127092" sldId="319"/>
            <ac:picMk id="41" creationId="{1411E4AC-4033-46F2-A6BE-E895E5B70B9C}"/>
          </ac:picMkLst>
        </pc:picChg>
      </pc:sldChg>
      <pc:sldChg chg="addSp delSp modSp add mod">
        <pc:chgData name="hayato kawachi" userId="3d62671f137ab6e0" providerId="LiveId" clId="{C20C878D-8684-4CB5-A807-DEC940797302}" dt="2021-10-17T14:55:42.193" v="987"/>
        <pc:sldMkLst>
          <pc:docMk/>
          <pc:sldMk cId="3184214258" sldId="320"/>
        </pc:sldMkLst>
        <pc:spChg chg="mod">
          <ac:chgData name="hayato kawachi" userId="3d62671f137ab6e0" providerId="LiveId" clId="{C20C878D-8684-4CB5-A807-DEC940797302}" dt="2021-10-17T03:25:10.848" v="340" actId="20577"/>
          <ac:spMkLst>
            <pc:docMk/>
            <pc:sldMk cId="3184214258" sldId="320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23:44.615" v="296" actId="20577"/>
          <ac:spMkLst>
            <pc:docMk/>
            <pc:sldMk cId="3184214258" sldId="320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18:26.802" v="245" actId="20577"/>
          <ac:spMkLst>
            <pc:docMk/>
            <pc:sldMk cId="3184214258" sldId="320"/>
            <ac:spMk id="37" creationId="{3ED8FDAB-36D8-45DE-89D0-5DAAD4A3261D}"/>
          </ac:spMkLst>
        </pc:spChg>
        <pc:spChg chg="mod">
          <ac:chgData name="hayato kawachi" userId="3d62671f137ab6e0" providerId="LiveId" clId="{C20C878D-8684-4CB5-A807-DEC940797302}" dt="2021-10-17T03:18:15.272" v="241" actId="20577"/>
          <ac:spMkLst>
            <pc:docMk/>
            <pc:sldMk cId="3184214258" sldId="320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03:16:29.414" v="220" actId="20577"/>
          <ac:spMkLst>
            <pc:docMk/>
            <pc:sldMk cId="3184214258" sldId="320"/>
            <ac:spMk id="39" creationId="{1B721CC6-56D4-4BD4-9D1B-18C0972D8A62}"/>
          </ac:spMkLst>
        </pc:spChg>
        <pc:spChg chg="add del mod">
          <ac:chgData name="hayato kawachi" userId="3d62671f137ab6e0" providerId="LiveId" clId="{C20C878D-8684-4CB5-A807-DEC940797302}" dt="2021-10-17T14:54:28.024" v="956"/>
          <ac:spMkLst>
            <pc:docMk/>
            <pc:sldMk cId="3184214258" sldId="320"/>
            <ac:spMk id="41" creationId="{E92CB56E-9804-4CDB-90B2-C816AF6AC15A}"/>
          </ac:spMkLst>
        </pc:spChg>
        <pc:spChg chg="mod">
          <ac:chgData name="hayato kawachi" userId="3d62671f137ab6e0" providerId="LiveId" clId="{C20C878D-8684-4CB5-A807-DEC940797302}" dt="2021-10-17T03:23:13.888" v="285" actId="20577"/>
          <ac:spMkLst>
            <pc:docMk/>
            <pc:sldMk cId="3184214258" sldId="320"/>
            <ac:spMk id="43" creationId="{FCF209F4-3112-40D3-B484-4BE2BCF1C86D}"/>
          </ac:spMkLst>
        </pc:spChg>
        <pc:spChg chg="mod">
          <ac:chgData name="hayato kawachi" userId="3d62671f137ab6e0" providerId="LiveId" clId="{C20C878D-8684-4CB5-A807-DEC940797302}" dt="2021-10-17T03:23:01.583" v="283" actId="20577"/>
          <ac:spMkLst>
            <pc:docMk/>
            <pc:sldMk cId="3184214258" sldId="320"/>
            <ac:spMk id="45" creationId="{C8C3E270-B328-4ADA-BD8F-95EBE4EC2EDA}"/>
          </ac:spMkLst>
        </pc:spChg>
        <pc:spChg chg="mod">
          <ac:chgData name="hayato kawachi" userId="3d62671f137ab6e0" providerId="LiveId" clId="{C20C878D-8684-4CB5-A807-DEC940797302}" dt="2021-10-17T03:17:02.780" v="226" actId="20577"/>
          <ac:spMkLst>
            <pc:docMk/>
            <pc:sldMk cId="3184214258" sldId="320"/>
            <ac:spMk id="47" creationId="{8B72101C-BE11-4C80-8D28-74E638A82CF8}"/>
          </ac:spMkLst>
        </pc:spChg>
        <pc:spChg chg="mod">
          <ac:chgData name="hayato kawachi" userId="3d62671f137ab6e0" providerId="LiveId" clId="{C20C878D-8684-4CB5-A807-DEC940797302}" dt="2021-10-17T03:18:50.095" v="255" actId="20577"/>
          <ac:spMkLst>
            <pc:docMk/>
            <pc:sldMk cId="3184214258" sldId="320"/>
            <ac:spMk id="50" creationId="{E10074C8-9A6C-44D2-B375-7758BE6319F6}"/>
          </ac:spMkLst>
        </pc:spChg>
        <pc:spChg chg="add del mod">
          <ac:chgData name="hayato kawachi" userId="3d62671f137ab6e0" providerId="LiveId" clId="{C20C878D-8684-4CB5-A807-DEC940797302}" dt="2021-10-17T14:55:41.955" v="986" actId="478"/>
          <ac:spMkLst>
            <pc:docMk/>
            <pc:sldMk cId="3184214258" sldId="320"/>
            <ac:spMk id="51" creationId="{F9AA966A-E5CF-4E6E-BFC9-F18113FEC67E}"/>
          </ac:spMkLst>
        </pc:spChg>
        <pc:spChg chg="add del">
          <ac:chgData name="hayato kawachi" userId="3d62671f137ab6e0" providerId="LiveId" clId="{C20C878D-8684-4CB5-A807-DEC940797302}" dt="2021-10-17T14:54:39.050" v="958" actId="478"/>
          <ac:spMkLst>
            <pc:docMk/>
            <pc:sldMk cId="3184214258" sldId="320"/>
            <ac:spMk id="53" creationId="{1FB50F88-B6D0-4B32-83D0-D60F6E12E6F7}"/>
          </ac:spMkLst>
        </pc:spChg>
        <pc:spChg chg="add mod">
          <ac:chgData name="hayato kawachi" userId="3d62671f137ab6e0" providerId="LiveId" clId="{C20C878D-8684-4CB5-A807-DEC940797302}" dt="2021-10-17T14:55:42.193" v="987"/>
          <ac:spMkLst>
            <pc:docMk/>
            <pc:sldMk cId="3184214258" sldId="320"/>
            <ac:spMk id="54" creationId="{6B034BB4-87EC-4C4C-A9AF-B8FCEF11E244}"/>
          </ac:spMkLst>
        </pc:spChg>
        <pc:spChg chg="mod">
          <ac:chgData name="hayato kawachi" userId="3d62671f137ab6e0" providerId="LiveId" clId="{C20C878D-8684-4CB5-A807-DEC940797302}" dt="2021-10-17T03:23:54.456" v="300" actId="20577"/>
          <ac:spMkLst>
            <pc:docMk/>
            <pc:sldMk cId="3184214258" sldId="320"/>
            <ac:spMk id="57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24:00.318" v="302" actId="20577"/>
          <ac:spMkLst>
            <pc:docMk/>
            <pc:sldMk cId="3184214258" sldId="320"/>
            <ac:spMk id="61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24:05.086" v="304" actId="20577"/>
          <ac:spMkLst>
            <pc:docMk/>
            <pc:sldMk cId="3184214258" sldId="320"/>
            <ac:spMk id="6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22:56.226" v="278" actId="20577"/>
          <ac:spMkLst>
            <pc:docMk/>
            <pc:sldMk cId="3184214258" sldId="320"/>
            <ac:spMk id="69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23:18.335" v="287" actId="20577"/>
          <ac:spMkLst>
            <pc:docMk/>
            <pc:sldMk cId="3184214258" sldId="320"/>
            <ac:spMk id="73" creationId="{00000000-0000-0000-0000-000000000000}"/>
          </ac:spMkLst>
        </pc:spChg>
        <pc:picChg chg="add mod ord">
          <ac:chgData name="hayato kawachi" userId="3d62671f137ab6e0" providerId="LiveId" clId="{C20C878D-8684-4CB5-A807-DEC940797302}" dt="2021-10-17T03:24:58.890" v="334" actId="1035"/>
          <ac:picMkLst>
            <pc:docMk/>
            <pc:sldMk cId="3184214258" sldId="320"/>
            <ac:picMk id="40" creationId="{2B609B19-D643-495C-BF49-864F4783605B}"/>
          </ac:picMkLst>
        </pc:picChg>
        <pc:picChg chg="del">
          <ac:chgData name="hayato kawachi" userId="3d62671f137ab6e0" providerId="LiveId" clId="{C20C878D-8684-4CB5-A807-DEC940797302}" dt="2021-10-17T03:24:39.986" v="311" actId="478"/>
          <ac:picMkLst>
            <pc:docMk/>
            <pc:sldMk cId="3184214258" sldId="320"/>
            <ac:picMk id="41" creationId="{3FFC67E1-CAA9-41DB-AC96-14E9602E4657}"/>
          </ac:picMkLst>
        </pc:picChg>
      </pc:sldChg>
      <pc:sldChg chg="addSp delSp modSp add mod">
        <pc:chgData name="hayato kawachi" userId="3d62671f137ab6e0" providerId="LiveId" clId="{C20C878D-8684-4CB5-A807-DEC940797302}" dt="2021-10-17T14:58:39.304" v="1038" actId="20577"/>
        <pc:sldMkLst>
          <pc:docMk/>
          <pc:sldMk cId="2663189720" sldId="321"/>
        </pc:sldMkLst>
        <pc:spChg chg="mod">
          <ac:chgData name="hayato kawachi" userId="3d62671f137ab6e0" providerId="LiveId" clId="{C20C878D-8684-4CB5-A807-DEC940797302}" dt="2021-10-17T14:56:11.862" v="996" actId="20577"/>
          <ac:spMkLst>
            <pc:docMk/>
            <pc:sldMk cId="2663189720" sldId="321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0:37.867" v="778" actId="6549"/>
          <ac:spMkLst>
            <pc:docMk/>
            <pc:sldMk cId="2663189720" sldId="321"/>
            <ac:spMk id="33" creationId="{29F2463A-75AA-48A3-A5BF-2C3594115A43}"/>
          </ac:spMkLst>
        </pc:spChg>
        <pc:spChg chg="mod">
          <ac:chgData name="hayato kawachi" userId="3d62671f137ab6e0" providerId="LiveId" clId="{C20C878D-8684-4CB5-A807-DEC940797302}" dt="2021-10-17T14:57:54.274" v="1030" actId="20577"/>
          <ac:spMkLst>
            <pc:docMk/>
            <pc:sldMk cId="2663189720" sldId="321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0:14.786" v="772" actId="20577"/>
          <ac:spMkLst>
            <pc:docMk/>
            <pc:sldMk cId="2663189720" sldId="321"/>
            <ac:spMk id="37" creationId="{3ED8FDAB-36D8-45DE-89D0-5DAAD4A3261D}"/>
          </ac:spMkLst>
        </pc:spChg>
        <pc:spChg chg="mod">
          <ac:chgData name="hayato kawachi" userId="3d62671f137ab6e0" providerId="LiveId" clId="{C20C878D-8684-4CB5-A807-DEC940797302}" dt="2021-10-17T14:50:26.412" v="773" actId="1076"/>
          <ac:spMkLst>
            <pc:docMk/>
            <pc:sldMk cId="2663189720" sldId="321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14:50:57.799" v="793" actId="20577"/>
          <ac:spMkLst>
            <pc:docMk/>
            <pc:sldMk cId="2663189720" sldId="321"/>
            <ac:spMk id="39" creationId="{1B721CC6-56D4-4BD4-9D1B-18C0972D8A62}"/>
          </ac:spMkLst>
        </pc:spChg>
        <pc:spChg chg="add mod">
          <ac:chgData name="hayato kawachi" userId="3d62671f137ab6e0" providerId="LiveId" clId="{C20C878D-8684-4CB5-A807-DEC940797302}" dt="2021-10-17T14:56:03.792" v="989"/>
          <ac:spMkLst>
            <pc:docMk/>
            <pc:sldMk cId="2663189720" sldId="321"/>
            <ac:spMk id="41" creationId="{62BF21F2-7E4B-4985-86B3-0F1AE019B64E}"/>
          </ac:spMkLst>
        </pc:spChg>
        <pc:spChg chg="mod">
          <ac:chgData name="hayato kawachi" userId="3d62671f137ab6e0" providerId="LiveId" clId="{C20C878D-8684-4CB5-A807-DEC940797302}" dt="2021-10-17T14:57:03.673" v="1022" actId="20577"/>
          <ac:spMkLst>
            <pc:docMk/>
            <pc:sldMk cId="2663189720" sldId="321"/>
            <ac:spMk id="43" creationId="{CE8A4983-AE32-44E5-B7C3-04B70FF944E9}"/>
          </ac:spMkLst>
        </pc:spChg>
        <pc:spChg chg="mod">
          <ac:chgData name="hayato kawachi" userId="3d62671f137ab6e0" providerId="LiveId" clId="{C20C878D-8684-4CB5-A807-DEC940797302}" dt="2021-10-17T14:57:06.605" v="1024" actId="20577"/>
          <ac:spMkLst>
            <pc:docMk/>
            <pc:sldMk cId="2663189720" sldId="321"/>
            <ac:spMk id="45" creationId="{8EB91309-2FAF-43D9-ACD3-BA0E2BDE36D9}"/>
          </ac:spMkLst>
        </pc:spChg>
        <pc:spChg chg="mod">
          <ac:chgData name="hayato kawachi" userId="3d62671f137ab6e0" providerId="LiveId" clId="{C20C878D-8684-4CB5-A807-DEC940797302}" dt="2021-10-17T14:57:48.343" v="1026" actId="20577"/>
          <ac:spMkLst>
            <pc:docMk/>
            <pc:sldMk cId="2663189720" sldId="321"/>
            <ac:spMk id="50" creationId="{E10074C8-9A6C-44D2-B375-7758BE6319F6}"/>
          </ac:spMkLst>
        </pc:spChg>
        <pc:spChg chg="del">
          <ac:chgData name="hayato kawachi" userId="3d62671f137ab6e0" providerId="LiveId" clId="{C20C878D-8684-4CB5-A807-DEC940797302}" dt="2021-10-17T14:56:03.489" v="988" actId="478"/>
          <ac:spMkLst>
            <pc:docMk/>
            <pc:sldMk cId="2663189720" sldId="321"/>
            <ac:spMk id="53" creationId="{1FB50F88-B6D0-4B32-83D0-D60F6E12E6F7}"/>
          </ac:spMkLst>
        </pc:spChg>
        <pc:spChg chg="mod">
          <ac:chgData name="hayato kawachi" userId="3d62671f137ab6e0" providerId="LiveId" clId="{C20C878D-8684-4CB5-A807-DEC940797302}" dt="2021-10-17T14:58:04.735" v="1032" actId="20577"/>
          <ac:spMkLst>
            <pc:docMk/>
            <pc:sldMk cId="2663189720" sldId="321"/>
            <ac:spMk id="57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6:37.745" v="1011" actId="20577"/>
          <ac:spMkLst>
            <pc:docMk/>
            <pc:sldMk cId="2663189720" sldId="321"/>
            <ac:spMk id="61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8:17.677" v="1034" actId="20577"/>
          <ac:spMkLst>
            <pc:docMk/>
            <pc:sldMk cId="2663189720" sldId="321"/>
            <ac:spMk id="6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8:22.510" v="1036" actId="20577"/>
          <ac:spMkLst>
            <pc:docMk/>
            <pc:sldMk cId="2663189720" sldId="321"/>
            <ac:spMk id="69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8:39.304" v="1038" actId="20577"/>
          <ac:spMkLst>
            <pc:docMk/>
            <pc:sldMk cId="2663189720" sldId="321"/>
            <ac:spMk id="73" creationId="{00000000-0000-0000-0000-000000000000}"/>
          </ac:spMkLst>
        </pc:spChg>
        <pc:picChg chg="add mod ord">
          <ac:chgData name="hayato kawachi" userId="3d62671f137ab6e0" providerId="LiveId" clId="{C20C878D-8684-4CB5-A807-DEC940797302}" dt="2021-10-17T14:49:07.827" v="749" actId="1038"/>
          <ac:picMkLst>
            <pc:docMk/>
            <pc:sldMk cId="2663189720" sldId="321"/>
            <ac:picMk id="40" creationId="{DB42677F-4A04-42E8-9B69-9D5175347B44}"/>
          </ac:picMkLst>
        </pc:picChg>
        <pc:picChg chg="del">
          <ac:chgData name="hayato kawachi" userId="3d62671f137ab6e0" providerId="LiveId" clId="{C20C878D-8684-4CB5-A807-DEC940797302}" dt="2021-10-17T14:48:41.668" v="733" actId="478"/>
          <ac:picMkLst>
            <pc:docMk/>
            <pc:sldMk cId="2663189720" sldId="321"/>
            <ac:picMk id="46" creationId="{4666B752-A8CB-4FEF-86DC-F3629D28C7FB}"/>
          </ac:picMkLst>
        </pc:picChg>
      </pc:sldChg>
      <pc:sldChg chg="addSp delSp modSp add mod ord">
        <pc:chgData name="hayato kawachi" userId="3d62671f137ab6e0" providerId="LiveId" clId="{C20C878D-8684-4CB5-A807-DEC940797302}" dt="2021-10-17T12:21:29.558" v="617" actId="20577"/>
        <pc:sldMkLst>
          <pc:docMk/>
          <pc:sldMk cId="3120795257" sldId="322"/>
        </pc:sldMkLst>
        <pc:spChg chg="mod">
          <ac:chgData name="hayato kawachi" userId="3d62671f137ab6e0" providerId="LiveId" clId="{C20C878D-8684-4CB5-A807-DEC940797302}" dt="2021-10-17T12:21:29.558" v="617" actId="20577"/>
          <ac:spMkLst>
            <pc:docMk/>
            <pc:sldMk cId="3120795257" sldId="322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33:11.639" v="418" actId="20577"/>
          <ac:spMkLst>
            <pc:docMk/>
            <pc:sldMk cId="3120795257" sldId="322"/>
            <ac:spMk id="33" creationId="{29F2463A-75AA-48A3-A5BF-2C3594115A43}"/>
          </ac:spMkLst>
        </pc:spChg>
        <pc:spChg chg="mod">
          <ac:chgData name="hayato kawachi" userId="3d62671f137ab6e0" providerId="LiveId" clId="{C20C878D-8684-4CB5-A807-DEC940797302}" dt="2021-10-17T03:36:18.362" v="457" actId="20577"/>
          <ac:spMkLst>
            <pc:docMk/>
            <pc:sldMk cId="3120795257" sldId="322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33:26.179" v="420" actId="20577"/>
          <ac:spMkLst>
            <pc:docMk/>
            <pc:sldMk cId="3120795257" sldId="322"/>
            <ac:spMk id="37" creationId="{3ED8FDAB-36D8-45DE-89D0-5DAAD4A3261D}"/>
          </ac:spMkLst>
        </pc:spChg>
        <pc:spChg chg="mod">
          <ac:chgData name="hayato kawachi" userId="3d62671f137ab6e0" providerId="LiveId" clId="{C20C878D-8684-4CB5-A807-DEC940797302}" dt="2021-10-17T03:33:32.417" v="429" actId="20577"/>
          <ac:spMkLst>
            <pc:docMk/>
            <pc:sldMk cId="3120795257" sldId="322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03:31:04.652" v="351"/>
          <ac:spMkLst>
            <pc:docMk/>
            <pc:sldMk cId="3120795257" sldId="322"/>
            <ac:spMk id="39" creationId="{1B721CC6-56D4-4BD4-9D1B-18C0972D8A62}"/>
          </ac:spMkLst>
        </pc:spChg>
        <pc:spChg chg="mod">
          <ac:chgData name="hayato kawachi" userId="3d62671f137ab6e0" providerId="LiveId" clId="{C20C878D-8684-4CB5-A807-DEC940797302}" dt="2021-10-17T03:34:58.952" v="437" actId="20577"/>
          <ac:spMkLst>
            <pc:docMk/>
            <pc:sldMk cId="3120795257" sldId="322"/>
            <ac:spMk id="50" creationId="{E10074C8-9A6C-44D2-B375-7758BE6319F6}"/>
          </ac:spMkLst>
        </pc:spChg>
        <pc:spChg chg="mod">
          <ac:chgData name="hayato kawachi" userId="3d62671f137ab6e0" providerId="LiveId" clId="{C20C878D-8684-4CB5-A807-DEC940797302}" dt="2021-10-17T03:36:33.471" v="459" actId="20577"/>
          <ac:spMkLst>
            <pc:docMk/>
            <pc:sldMk cId="3120795257" sldId="322"/>
            <ac:spMk id="57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35:44.566" v="446" actId="20577"/>
          <ac:spMkLst>
            <pc:docMk/>
            <pc:sldMk cId="3120795257" sldId="322"/>
            <ac:spMk id="61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36:46.940" v="461" actId="20577"/>
          <ac:spMkLst>
            <pc:docMk/>
            <pc:sldMk cId="3120795257" sldId="322"/>
            <ac:spMk id="6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35:52.581" v="451" actId="20577"/>
          <ac:spMkLst>
            <pc:docMk/>
            <pc:sldMk cId="3120795257" sldId="322"/>
            <ac:spMk id="69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03:35:55.394" v="453" actId="20577"/>
          <ac:spMkLst>
            <pc:docMk/>
            <pc:sldMk cId="3120795257" sldId="322"/>
            <ac:spMk id="73" creationId="{00000000-0000-0000-0000-000000000000}"/>
          </ac:spMkLst>
        </pc:spChg>
        <pc:picChg chg="del">
          <ac:chgData name="hayato kawachi" userId="3d62671f137ab6e0" providerId="LiveId" clId="{C20C878D-8684-4CB5-A807-DEC940797302}" dt="2021-10-17T03:32:34.485" v="380" actId="478"/>
          <ac:picMkLst>
            <pc:docMk/>
            <pc:sldMk cId="3120795257" sldId="322"/>
            <ac:picMk id="4" creationId="{64E1501D-25F3-4A68-968A-A495078EF778}"/>
          </ac:picMkLst>
        </pc:picChg>
        <pc:picChg chg="add mod ord">
          <ac:chgData name="hayato kawachi" userId="3d62671f137ab6e0" providerId="LiveId" clId="{C20C878D-8684-4CB5-A807-DEC940797302}" dt="2021-10-17T03:32:42.427" v="401" actId="1036"/>
          <ac:picMkLst>
            <pc:docMk/>
            <pc:sldMk cId="3120795257" sldId="322"/>
            <ac:picMk id="6" creationId="{1D86EBC2-9120-4B1D-8F34-EC840D786D14}"/>
          </ac:picMkLst>
        </pc:picChg>
      </pc:sldChg>
      <pc:sldChg chg="addSp delSp modSp add mod">
        <pc:chgData name="hayato kawachi" userId="3d62671f137ab6e0" providerId="LiveId" clId="{C20C878D-8684-4CB5-A807-DEC940797302}" dt="2021-10-17T15:20:45.866" v="1141" actId="20577"/>
        <pc:sldMkLst>
          <pc:docMk/>
          <pc:sldMk cId="228181719" sldId="323"/>
        </pc:sldMkLst>
        <pc:spChg chg="mod">
          <ac:chgData name="hayato kawachi" userId="3d62671f137ab6e0" providerId="LiveId" clId="{C20C878D-8684-4CB5-A807-DEC940797302}" dt="2021-10-17T14:59:06.752" v="1053" actId="20577"/>
          <ac:spMkLst>
            <pc:docMk/>
            <pc:sldMk cId="228181719" sldId="323"/>
            <ac:spMk id="2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4:59:17.776" v="1060" actId="20577"/>
          <ac:spMkLst>
            <pc:docMk/>
            <pc:sldMk cId="228181719" sldId="323"/>
            <ac:spMk id="33" creationId="{29F2463A-75AA-48A3-A5BF-2C3594115A43}"/>
          </ac:spMkLst>
        </pc:spChg>
        <pc:spChg chg="mod">
          <ac:chgData name="hayato kawachi" userId="3d62671f137ab6e0" providerId="LiveId" clId="{C20C878D-8684-4CB5-A807-DEC940797302}" dt="2021-10-17T15:20:28.598" v="1135" actId="20577"/>
          <ac:spMkLst>
            <pc:docMk/>
            <pc:sldMk cId="228181719" sldId="323"/>
            <ac:spMk id="3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5:19:11.206" v="1087" actId="20577"/>
          <ac:spMkLst>
            <pc:docMk/>
            <pc:sldMk cId="228181719" sldId="323"/>
            <ac:spMk id="37" creationId="{3ED8FDAB-36D8-45DE-89D0-5DAAD4A3261D}"/>
          </ac:spMkLst>
        </pc:spChg>
        <pc:spChg chg="mod">
          <ac:chgData name="hayato kawachi" userId="3d62671f137ab6e0" providerId="LiveId" clId="{C20C878D-8684-4CB5-A807-DEC940797302}" dt="2021-10-17T15:19:17.048" v="1095" actId="20577"/>
          <ac:spMkLst>
            <pc:docMk/>
            <pc:sldMk cId="228181719" sldId="323"/>
            <ac:spMk id="38" creationId="{3FB751A9-8633-43EC-82C5-807F8581EEFA}"/>
          </ac:spMkLst>
        </pc:spChg>
        <pc:spChg chg="mod">
          <ac:chgData name="hayato kawachi" userId="3d62671f137ab6e0" providerId="LiveId" clId="{C20C878D-8684-4CB5-A807-DEC940797302}" dt="2021-10-17T15:19:27.151" v="1100" actId="20577"/>
          <ac:spMkLst>
            <pc:docMk/>
            <pc:sldMk cId="228181719" sldId="323"/>
            <ac:spMk id="39" creationId="{1B721CC6-56D4-4BD4-9D1B-18C0972D8A62}"/>
          </ac:spMkLst>
        </pc:spChg>
        <pc:spChg chg="add mod">
          <ac:chgData name="hayato kawachi" userId="3d62671f137ab6e0" providerId="LiveId" clId="{C20C878D-8684-4CB5-A807-DEC940797302}" dt="2021-10-17T14:56:07.820" v="991"/>
          <ac:spMkLst>
            <pc:docMk/>
            <pc:sldMk cId="228181719" sldId="323"/>
            <ac:spMk id="41" creationId="{4321BAE2-D648-4BEE-B683-767D1B7639CC}"/>
          </ac:spMkLst>
        </pc:spChg>
        <pc:spChg chg="mod">
          <ac:chgData name="hayato kawachi" userId="3d62671f137ab6e0" providerId="LiveId" clId="{C20C878D-8684-4CB5-A807-DEC940797302}" dt="2021-10-17T15:20:13.048" v="1127" actId="20577"/>
          <ac:spMkLst>
            <pc:docMk/>
            <pc:sldMk cId="228181719" sldId="323"/>
            <ac:spMk id="43" creationId="{CE8A4983-AE32-44E5-B7C3-04B70FF944E9}"/>
          </ac:spMkLst>
        </pc:spChg>
        <pc:spChg chg="mod">
          <ac:chgData name="hayato kawachi" userId="3d62671f137ab6e0" providerId="LiveId" clId="{C20C878D-8684-4CB5-A807-DEC940797302}" dt="2021-10-17T15:20:15.852" v="1129" actId="20577"/>
          <ac:spMkLst>
            <pc:docMk/>
            <pc:sldMk cId="228181719" sldId="323"/>
            <ac:spMk id="45" creationId="{8EB91309-2FAF-43D9-ACD3-BA0E2BDE36D9}"/>
          </ac:spMkLst>
        </pc:spChg>
        <pc:spChg chg="mod">
          <ac:chgData name="hayato kawachi" userId="3d62671f137ab6e0" providerId="LiveId" clId="{C20C878D-8684-4CB5-A807-DEC940797302}" dt="2021-10-17T15:20:23.251" v="1131" actId="20577"/>
          <ac:spMkLst>
            <pc:docMk/>
            <pc:sldMk cId="228181719" sldId="323"/>
            <ac:spMk id="50" creationId="{E10074C8-9A6C-44D2-B375-7758BE6319F6}"/>
          </ac:spMkLst>
        </pc:spChg>
        <pc:spChg chg="del">
          <ac:chgData name="hayato kawachi" userId="3d62671f137ab6e0" providerId="LiveId" clId="{C20C878D-8684-4CB5-A807-DEC940797302}" dt="2021-10-17T14:56:07.431" v="990" actId="478"/>
          <ac:spMkLst>
            <pc:docMk/>
            <pc:sldMk cId="228181719" sldId="323"/>
            <ac:spMk id="53" creationId="{1FB50F88-B6D0-4B32-83D0-D60F6E12E6F7}"/>
          </ac:spMkLst>
        </pc:spChg>
        <pc:spChg chg="mod">
          <ac:chgData name="hayato kawachi" userId="3d62671f137ab6e0" providerId="LiveId" clId="{C20C878D-8684-4CB5-A807-DEC940797302}" dt="2021-10-17T15:20:34.705" v="1137" actId="20577"/>
          <ac:spMkLst>
            <pc:docMk/>
            <pc:sldMk cId="228181719" sldId="323"/>
            <ac:spMk id="57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5:20:39.219" v="1139" actId="20577"/>
          <ac:spMkLst>
            <pc:docMk/>
            <pc:sldMk cId="228181719" sldId="323"/>
            <ac:spMk id="61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5:20:45.866" v="1141" actId="20577"/>
          <ac:spMkLst>
            <pc:docMk/>
            <pc:sldMk cId="228181719" sldId="323"/>
            <ac:spMk id="65" creationId="{00000000-0000-0000-0000-000000000000}"/>
          </ac:spMkLst>
        </pc:spChg>
        <pc:spChg chg="mod">
          <ac:chgData name="hayato kawachi" userId="3d62671f137ab6e0" providerId="LiveId" clId="{C20C878D-8684-4CB5-A807-DEC940797302}" dt="2021-10-17T15:20:08.413" v="1125" actId="20577"/>
          <ac:spMkLst>
            <pc:docMk/>
            <pc:sldMk cId="228181719" sldId="323"/>
            <ac:spMk id="69" creationId="{00000000-0000-0000-0000-000000000000}"/>
          </ac:spMkLst>
        </pc:spChg>
        <pc:picChg chg="del">
          <ac:chgData name="hayato kawachi" userId="3d62671f137ab6e0" providerId="LiveId" clId="{C20C878D-8684-4CB5-A807-DEC940797302}" dt="2021-10-17T15:18:28.999" v="1066" actId="478"/>
          <ac:picMkLst>
            <pc:docMk/>
            <pc:sldMk cId="228181719" sldId="323"/>
            <ac:picMk id="40" creationId="{9E4E7BE0-43E1-4FB6-A208-2E04C2C844BD}"/>
          </ac:picMkLst>
        </pc:picChg>
        <pc:picChg chg="add mod ord">
          <ac:chgData name="hayato kawachi" userId="3d62671f137ab6e0" providerId="LiveId" clId="{C20C878D-8684-4CB5-A807-DEC940797302}" dt="2021-10-17T15:18:45.360" v="1080" actId="1035"/>
          <ac:picMkLst>
            <pc:docMk/>
            <pc:sldMk cId="228181719" sldId="323"/>
            <ac:picMk id="46" creationId="{115B4DA3-E2BA-45FE-BF2F-FF63BDC74196}"/>
          </ac:picMkLst>
        </pc:picChg>
      </pc:sldChg>
      <pc:sldChg chg="addSp new del mod">
        <pc:chgData name="hayato kawachi" userId="3d62671f137ab6e0" providerId="LiveId" clId="{C20C878D-8684-4CB5-A807-DEC940797302}" dt="2021-10-17T03:10:09.888" v="164" actId="47"/>
        <pc:sldMkLst>
          <pc:docMk/>
          <pc:sldMk cId="829420445" sldId="324"/>
        </pc:sldMkLst>
        <pc:picChg chg="add">
          <ac:chgData name="hayato kawachi" userId="3d62671f137ab6e0" providerId="LiveId" clId="{C20C878D-8684-4CB5-A807-DEC940797302}" dt="2021-10-17T03:09:32.850" v="159" actId="22"/>
          <ac:picMkLst>
            <pc:docMk/>
            <pc:sldMk cId="829420445" sldId="324"/>
            <ac:picMk id="3" creationId="{59AEF663-DC83-4DB1-94C3-7D17737C28F3}"/>
          </ac:picMkLst>
        </pc:picChg>
      </pc:sldChg>
      <pc:sldChg chg="addSp delSp modSp new del mod">
        <pc:chgData name="hayato kawachi" userId="3d62671f137ab6e0" providerId="LiveId" clId="{C20C878D-8684-4CB5-A807-DEC940797302}" dt="2021-10-17T03:25:03.866" v="335" actId="47"/>
        <pc:sldMkLst>
          <pc:docMk/>
          <pc:sldMk cId="2457283109" sldId="324"/>
        </pc:sldMkLst>
        <pc:picChg chg="add mod">
          <ac:chgData name="hayato kawachi" userId="3d62671f137ab6e0" providerId="LiveId" clId="{C20C878D-8684-4CB5-A807-DEC940797302}" dt="2021-10-17T03:21:43.514" v="260" actId="1076"/>
          <ac:picMkLst>
            <pc:docMk/>
            <pc:sldMk cId="2457283109" sldId="324"/>
            <ac:picMk id="3" creationId="{D71F597D-43CB-4A14-A37F-CD7B41379806}"/>
          </ac:picMkLst>
        </pc:picChg>
        <pc:picChg chg="add del">
          <ac:chgData name="hayato kawachi" userId="3d62671f137ab6e0" providerId="LiveId" clId="{C20C878D-8684-4CB5-A807-DEC940797302}" dt="2021-10-17T03:24:14.893" v="306" actId="22"/>
          <ac:picMkLst>
            <pc:docMk/>
            <pc:sldMk cId="2457283109" sldId="324"/>
            <ac:picMk id="5" creationId="{93177EA4-4BF6-4F2E-9A27-A5BD72529A12}"/>
          </ac:picMkLst>
        </pc:picChg>
      </pc:sldChg>
      <pc:sldChg chg="modSp add mod">
        <pc:chgData name="hayato kawachi" userId="3d62671f137ab6e0" providerId="LiveId" clId="{C20C878D-8684-4CB5-A807-DEC940797302}" dt="2021-10-17T12:19:15.258" v="536" actId="404"/>
        <pc:sldMkLst>
          <pc:docMk/>
          <pc:sldMk cId="3063060718" sldId="324"/>
        </pc:sldMkLst>
        <pc:spChg chg="mod">
          <ac:chgData name="hayato kawachi" userId="3d62671f137ab6e0" providerId="LiveId" clId="{C20C878D-8684-4CB5-A807-DEC940797302}" dt="2021-10-17T12:19:15.258" v="536" actId="404"/>
          <ac:spMkLst>
            <pc:docMk/>
            <pc:sldMk cId="3063060718" sldId="324"/>
            <ac:spMk id="2" creationId="{FE0D19BB-235A-44AB-A32F-F610D8B3FF1B}"/>
          </ac:spMkLst>
        </pc:spChg>
      </pc:sldChg>
      <pc:sldChg chg="new del">
        <pc:chgData name="hayato kawachi" userId="3d62671f137ab6e0" providerId="LiveId" clId="{C20C878D-8684-4CB5-A807-DEC940797302}" dt="2021-10-17T12:18:54.886" v="513" actId="47"/>
        <pc:sldMkLst>
          <pc:docMk/>
          <pc:sldMk cId="3680837606" sldId="324"/>
        </pc:sldMkLst>
      </pc:sldChg>
      <pc:sldChg chg="addSp new del mod">
        <pc:chgData name="hayato kawachi" userId="3d62671f137ab6e0" providerId="LiveId" clId="{C20C878D-8684-4CB5-A807-DEC940797302}" dt="2021-10-17T12:13:44.246" v="487" actId="47"/>
        <pc:sldMkLst>
          <pc:docMk/>
          <pc:sldMk cId="3766403390" sldId="324"/>
        </pc:sldMkLst>
        <pc:picChg chg="add">
          <ac:chgData name="hayato kawachi" userId="3d62671f137ab6e0" providerId="LiveId" clId="{C20C878D-8684-4CB5-A807-DEC940797302}" dt="2021-10-17T12:13:12.807" v="473" actId="22"/>
          <ac:picMkLst>
            <pc:docMk/>
            <pc:sldMk cId="3766403390" sldId="324"/>
            <ac:picMk id="3" creationId="{6702BBC9-592B-49B6-8CE0-BF57919D89FF}"/>
          </ac:picMkLst>
        </pc:picChg>
      </pc:sldChg>
      <pc:sldChg chg="modSp add mod">
        <pc:chgData name="hayato kawachi" userId="3d62671f137ab6e0" providerId="LiveId" clId="{C20C878D-8684-4CB5-A807-DEC940797302}" dt="2021-10-17T12:19:38.045" v="557" actId="20577"/>
        <pc:sldMkLst>
          <pc:docMk/>
          <pc:sldMk cId="3163722855" sldId="325"/>
        </pc:sldMkLst>
        <pc:spChg chg="mod">
          <ac:chgData name="hayato kawachi" userId="3d62671f137ab6e0" providerId="LiveId" clId="{C20C878D-8684-4CB5-A807-DEC940797302}" dt="2021-10-17T12:19:38.045" v="557" actId="20577"/>
          <ac:spMkLst>
            <pc:docMk/>
            <pc:sldMk cId="3163722855" sldId="325"/>
            <ac:spMk id="2" creationId="{FE0D19BB-235A-44AB-A32F-F610D8B3FF1B}"/>
          </ac:spMkLst>
        </pc:spChg>
      </pc:sldChg>
      <pc:sldChg chg="modSp add mod">
        <pc:chgData name="hayato kawachi" userId="3d62671f137ab6e0" providerId="LiveId" clId="{C20C878D-8684-4CB5-A807-DEC940797302}" dt="2021-10-17T12:19:52.945" v="604" actId="6549"/>
        <pc:sldMkLst>
          <pc:docMk/>
          <pc:sldMk cId="1805142134" sldId="326"/>
        </pc:sldMkLst>
        <pc:spChg chg="mod">
          <ac:chgData name="hayato kawachi" userId="3d62671f137ab6e0" providerId="LiveId" clId="{C20C878D-8684-4CB5-A807-DEC940797302}" dt="2021-10-17T12:19:52.945" v="604" actId="6549"/>
          <ac:spMkLst>
            <pc:docMk/>
            <pc:sldMk cId="1805142134" sldId="326"/>
            <ac:spMk id="2" creationId="{FE0D19BB-235A-44AB-A32F-F610D8B3FF1B}"/>
          </ac:spMkLst>
        </pc:spChg>
      </pc:sldChg>
      <pc:sldChg chg="add">
        <pc:chgData name="hayato kawachi" userId="3d62671f137ab6e0" providerId="LiveId" clId="{C20C878D-8684-4CB5-A807-DEC940797302}" dt="2021-10-17T12:21:08.276" v="609"/>
        <pc:sldMkLst>
          <pc:docMk/>
          <pc:sldMk cId="2070169754" sldId="327"/>
        </pc:sldMkLst>
      </pc:sldChg>
      <pc:sldChg chg="add">
        <pc:chgData name="hayato kawachi" userId="3d62671f137ab6e0" providerId="LiveId" clId="{C20C878D-8684-4CB5-A807-DEC940797302}" dt="2021-10-17T12:21:21.182" v="610"/>
        <pc:sldMkLst>
          <pc:docMk/>
          <pc:sldMk cId="1418843655" sldId="328"/>
        </pc:sldMkLst>
      </pc:sldChg>
      <pc:sldChg chg="addSp new del mod">
        <pc:chgData name="hayato kawachi" userId="3d62671f137ab6e0" providerId="LiveId" clId="{C20C878D-8684-4CB5-A807-DEC940797302}" dt="2021-10-17T12:36:33.631" v="626" actId="47"/>
        <pc:sldMkLst>
          <pc:docMk/>
          <pc:sldMk cId="927543368" sldId="329"/>
        </pc:sldMkLst>
        <pc:picChg chg="add">
          <ac:chgData name="hayato kawachi" userId="3d62671f137ab6e0" providerId="LiveId" clId="{C20C878D-8684-4CB5-A807-DEC940797302}" dt="2021-10-17T12:23:19.978" v="621" actId="22"/>
          <ac:picMkLst>
            <pc:docMk/>
            <pc:sldMk cId="927543368" sldId="329"/>
            <ac:picMk id="3" creationId="{9DB2C1B9-ABC9-4931-976C-F2280BC78787}"/>
          </ac:picMkLst>
        </pc:picChg>
      </pc:sldChg>
      <pc:sldChg chg="addSp new del mod">
        <pc:chgData name="hayato kawachi" userId="3d62671f137ab6e0" providerId="LiveId" clId="{C20C878D-8684-4CB5-A807-DEC940797302}" dt="2021-10-17T15:18:46.934" v="1081" actId="47"/>
        <pc:sldMkLst>
          <pc:docMk/>
          <pc:sldMk cId="2436850093" sldId="329"/>
        </pc:sldMkLst>
        <pc:picChg chg="add">
          <ac:chgData name="hayato kawachi" userId="3d62671f137ab6e0" providerId="LiveId" clId="{C20C878D-8684-4CB5-A807-DEC940797302}" dt="2021-10-17T15:18:09.027" v="1062" actId="22"/>
          <ac:picMkLst>
            <pc:docMk/>
            <pc:sldMk cId="2436850093" sldId="329"/>
            <ac:picMk id="3" creationId="{D4AEDF70-2E2D-45FB-8E4F-C5688749CD32}"/>
          </ac:picMkLst>
        </pc:picChg>
      </pc:sldChg>
      <pc:sldChg chg="addSp new del mod">
        <pc:chgData name="hayato kawachi" userId="3d62671f137ab6e0" providerId="LiveId" clId="{C20C878D-8684-4CB5-A807-DEC940797302}" dt="2021-10-17T12:49:12.297" v="719" actId="47"/>
        <pc:sldMkLst>
          <pc:docMk/>
          <pc:sldMk cId="2672304238" sldId="329"/>
        </pc:sldMkLst>
        <pc:picChg chg="add">
          <ac:chgData name="hayato kawachi" userId="3d62671f137ab6e0" providerId="LiveId" clId="{C20C878D-8684-4CB5-A807-DEC940797302}" dt="2021-10-17T12:48:36.230" v="695" actId="22"/>
          <ac:picMkLst>
            <pc:docMk/>
            <pc:sldMk cId="2672304238" sldId="329"/>
            <ac:picMk id="3" creationId="{699C2981-D191-4847-BBDE-AF3F52EE99C9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FD5A52-B650-FD45-AB0E-A2B129A663C0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FF1DF6-6C41-6F4D-B0A1-75AAF9DD140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087839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3249613" y="504825"/>
            <a:ext cx="3367087" cy="2525713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1FF1DF6-6C41-6F4D-B0A1-75AAF9DD140E}" type="slidenum">
              <a:rPr kumimoji="1" lang="ja-JP" altLang="en-US" smtClean="0"/>
              <a:pPr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609969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1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7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8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0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1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831139" y="323852"/>
            <a:ext cx="2430462" cy="691197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539750" y="323852"/>
            <a:ext cx="7138988" cy="691197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4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9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9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73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88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03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18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48" indent="0">
              <a:buNone/>
              <a:defRPr sz="2000" b="1"/>
            </a:lvl2pPr>
            <a:lvl3pPr marL="914295" indent="0">
              <a:buNone/>
              <a:defRPr sz="1800" b="1"/>
            </a:lvl3pPr>
            <a:lvl4pPr marL="1371443" indent="0">
              <a:buNone/>
              <a:defRPr sz="1600" b="1"/>
            </a:lvl4pPr>
            <a:lvl5pPr marL="1828592" indent="0">
              <a:buNone/>
              <a:defRPr sz="1600" b="1"/>
            </a:lvl5pPr>
            <a:lvl6pPr marL="2285739" indent="0">
              <a:buNone/>
              <a:defRPr sz="1600" b="1"/>
            </a:lvl6pPr>
            <a:lvl7pPr marL="2742887" indent="0">
              <a:buNone/>
              <a:defRPr sz="1600" b="1"/>
            </a:lvl7pPr>
            <a:lvl8pPr marL="3200034" indent="0">
              <a:buNone/>
              <a:defRPr sz="1600" b="1"/>
            </a:lvl8pPr>
            <a:lvl9pPr marL="3657182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48" indent="0">
              <a:buNone/>
              <a:defRPr sz="2000" b="1"/>
            </a:lvl2pPr>
            <a:lvl3pPr marL="914295" indent="0">
              <a:buNone/>
              <a:defRPr sz="1800" b="1"/>
            </a:lvl3pPr>
            <a:lvl4pPr marL="1371443" indent="0">
              <a:buNone/>
              <a:defRPr sz="1600" b="1"/>
            </a:lvl4pPr>
            <a:lvl5pPr marL="1828592" indent="0">
              <a:buNone/>
              <a:defRPr sz="1600" b="1"/>
            </a:lvl5pPr>
            <a:lvl6pPr marL="2285739" indent="0">
              <a:buNone/>
              <a:defRPr sz="1600" b="1"/>
            </a:lvl6pPr>
            <a:lvl7pPr marL="2742887" indent="0">
              <a:buNone/>
              <a:defRPr sz="1600" b="1"/>
            </a:lvl7pPr>
            <a:lvl8pPr marL="3200034" indent="0">
              <a:buNone/>
              <a:defRPr sz="1600" b="1"/>
            </a:lvl8pPr>
            <a:lvl9pPr marL="3657182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3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1" y="273051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3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48" indent="0">
              <a:buNone/>
              <a:defRPr sz="1200"/>
            </a:lvl2pPr>
            <a:lvl3pPr marL="914295" indent="0">
              <a:buNone/>
              <a:defRPr sz="1000"/>
            </a:lvl3pPr>
            <a:lvl4pPr marL="1371443" indent="0">
              <a:buNone/>
              <a:defRPr sz="900"/>
            </a:lvl4pPr>
            <a:lvl5pPr marL="1828592" indent="0">
              <a:buNone/>
              <a:defRPr sz="900"/>
            </a:lvl5pPr>
            <a:lvl6pPr marL="2285739" indent="0">
              <a:buNone/>
              <a:defRPr sz="900"/>
            </a:lvl6pPr>
            <a:lvl7pPr marL="2742887" indent="0">
              <a:buNone/>
              <a:defRPr sz="900"/>
            </a:lvl7pPr>
            <a:lvl8pPr marL="3200034" indent="0">
              <a:buNone/>
              <a:defRPr sz="900"/>
            </a:lvl8pPr>
            <a:lvl9pPr marL="3657182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48" indent="0">
              <a:buNone/>
              <a:defRPr sz="2800"/>
            </a:lvl2pPr>
            <a:lvl3pPr marL="914295" indent="0">
              <a:buNone/>
              <a:defRPr sz="2400"/>
            </a:lvl3pPr>
            <a:lvl4pPr marL="1371443" indent="0">
              <a:buNone/>
              <a:defRPr sz="2000"/>
            </a:lvl4pPr>
            <a:lvl5pPr marL="1828592" indent="0">
              <a:buNone/>
              <a:defRPr sz="2000"/>
            </a:lvl5pPr>
            <a:lvl6pPr marL="2285739" indent="0">
              <a:buNone/>
              <a:defRPr sz="2000"/>
            </a:lvl6pPr>
            <a:lvl7pPr marL="2742887" indent="0">
              <a:buNone/>
              <a:defRPr sz="2000"/>
            </a:lvl7pPr>
            <a:lvl8pPr marL="3200034" indent="0">
              <a:buNone/>
              <a:defRPr sz="2000"/>
            </a:lvl8pPr>
            <a:lvl9pPr marL="3657182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40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48" indent="0">
              <a:buNone/>
              <a:defRPr sz="1200"/>
            </a:lvl2pPr>
            <a:lvl3pPr marL="914295" indent="0">
              <a:buNone/>
              <a:defRPr sz="1000"/>
            </a:lvl3pPr>
            <a:lvl4pPr marL="1371443" indent="0">
              <a:buNone/>
              <a:defRPr sz="900"/>
            </a:lvl4pPr>
            <a:lvl5pPr marL="1828592" indent="0">
              <a:buNone/>
              <a:defRPr sz="900"/>
            </a:lvl5pPr>
            <a:lvl6pPr marL="2285739" indent="0">
              <a:buNone/>
              <a:defRPr sz="900"/>
            </a:lvl6pPr>
            <a:lvl7pPr marL="2742887" indent="0">
              <a:buNone/>
              <a:defRPr sz="900"/>
            </a:lvl7pPr>
            <a:lvl8pPr marL="3200034" indent="0">
              <a:buNone/>
              <a:defRPr sz="900"/>
            </a:lvl8pPr>
            <a:lvl9pPr marL="3657182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1" y="274638"/>
            <a:ext cx="8229600" cy="1143000"/>
          </a:xfrm>
          <a:prstGeom prst="rect">
            <a:avLst/>
          </a:prstGeom>
        </p:spPr>
        <p:txBody>
          <a:bodyPr vert="horz" lIns="91430" tIns="45714" rIns="91430" bIns="45714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1" y="1600200"/>
            <a:ext cx="8229600" cy="4525963"/>
          </a:xfrm>
          <a:prstGeom prst="rect">
            <a:avLst/>
          </a:prstGeom>
        </p:spPr>
        <p:txBody>
          <a:bodyPr vert="horz" lIns="91430" tIns="45714" rIns="91430" bIns="45714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1" y="6356351"/>
            <a:ext cx="2133600" cy="365125"/>
          </a:xfrm>
          <a:prstGeom prst="rect">
            <a:avLst/>
          </a:prstGeom>
        </p:spPr>
        <p:txBody>
          <a:bodyPr vert="horz" lIns="91430" tIns="45714" rIns="91430" bIns="45714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E89DFC-F631-4F3E-9693-9D8C06026DC1}" type="datetimeFigureOut">
              <a:rPr kumimoji="1" lang="ja-JP" altLang="en-US" smtClean="0"/>
              <a:pPr/>
              <a:t>2022/5/30</a:t>
            </a:fld>
            <a:endParaRPr kumimoji="1" lang="ja-JP" altLang="en-US" dirty="0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30" tIns="45714" rIns="91430" bIns="45714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1" y="6356351"/>
            <a:ext cx="2133600" cy="365125"/>
          </a:xfrm>
          <a:prstGeom prst="rect">
            <a:avLst/>
          </a:prstGeom>
        </p:spPr>
        <p:txBody>
          <a:bodyPr vert="horz" lIns="91430" tIns="45714" rIns="91430" bIns="45714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4ADD5C-A73E-4C8D-A778-20FCAFAF235E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95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60" indent="-342860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66" indent="-285717" algn="l" defTabSz="914295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70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17" indent="-228574" algn="l" defTabSz="914295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165" indent="-228574" algn="l" defTabSz="914295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313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460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609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756" indent="-228574" algn="l" defTabSz="914295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48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95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43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92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739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887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034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182" algn="l" defTabSz="914295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図 39">
            <a:extLst>
              <a:ext uri="{FF2B5EF4-FFF2-40B4-BE49-F238E27FC236}">
                <a16:creationId xmlns:a16="http://schemas.microsoft.com/office/drawing/2014/main" id="{917C2BE5-1ED9-4C06-A123-6B3FE957320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78810" y="592407"/>
            <a:ext cx="8114400" cy="5440978"/>
          </a:xfrm>
          <a:prstGeom prst="rect">
            <a:avLst/>
          </a:prstGeom>
        </p:spPr>
      </p:pic>
      <p:sp>
        <p:nvSpPr>
          <p:cNvPr id="3" name="テキスト ボックス 2"/>
          <p:cNvSpPr txBox="1">
            <a:spLocks noChangeArrowheads="1"/>
          </p:cNvSpPr>
          <p:nvPr/>
        </p:nvSpPr>
        <p:spPr bwMode="auto">
          <a:xfrm rot="10800000">
            <a:off x="1130064" y="1058613"/>
            <a:ext cx="525904" cy="4168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eaVert" lIns="108009" tIns="54004" rIns="108009" bIns="54004">
            <a:spAutoFit/>
          </a:bodyPr>
          <a:lstStyle/>
          <a:p>
            <a:pPr algn="ctr" eaLnBrk="1" hangingPunct="1"/>
            <a:r>
              <a:rPr lang="en-US" altLang="ja-JP" sz="2000" b="1" dirty="0">
                <a:latin typeface="Times New Roman" pitchFamily="18" charset="0"/>
                <a:cs typeface="Times New Roman" pitchFamily="18" charset="0"/>
              </a:rPr>
              <a:t>Progression-free survival (%)</a:t>
            </a:r>
            <a:endParaRPr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テキスト ボックス 4"/>
          <p:cNvSpPr txBox="1">
            <a:spLocks noChangeArrowheads="1"/>
          </p:cNvSpPr>
          <p:nvPr/>
        </p:nvSpPr>
        <p:spPr bwMode="auto">
          <a:xfrm>
            <a:off x="2201634" y="5621806"/>
            <a:ext cx="6179324" cy="41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108009" tIns="54004" rIns="108009" bIns="54004">
            <a:spAutoFit/>
          </a:bodyPr>
          <a:lstStyle/>
          <a:p>
            <a:pPr algn="ctr" eaLnBrk="1" hangingPunct="1"/>
            <a:r>
              <a:rPr lang="en-US" altLang="ja-JP" sz="2000" b="1" dirty="0">
                <a:latin typeface="Times New Roman" pitchFamily="18" charset="0"/>
                <a:cs typeface="Times New Roman" pitchFamily="18" charset="0"/>
              </a:rPr>
              <a:t>Time (months)</a:t>
            </a:r>
            <a:endParaRPr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035874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b="1" dirty="0">
                <a:latin typeface="Times New Roman" pitchFamily="18" charset="0"/>
                <a:cs typeface="Times New Roman" pitchFamily="18" charset="0"/>
              </a:rPr>
              <a:t>12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136676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b="1" dirty="0">
                <a:latin typeface="Times New Roman" pitchFamily="18" charset="0"/>
                <a:cs typeface="Times New Roman" pitchFamily="18" charset="0"/>
              </a:rPr>
              <a:t>18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6242212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b="1" dirty="0">
                <a:latin typeface="Times New Roman" pitchFamily="18" charset="0"/>
                <a:cs typeface="Times New Roman" pitchFamily="18" charset="0"/>
              </a:rPr>
              <a:t>24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7374748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b="1" dirty="0">
                <a:latin typeface="Times New Roman" pitchFamily="18" charset="0"/>
                <a:cs typeface="Times New Roman" pitchFamily="18" charset="0"/>
              </a:rPr>
              <a:t>30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8486108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b="1" dirty="0">
                <a:latin typeface="Times New Roman" pitchFamily="18" charset="0"/>
                <a:cs typeface="Times New Roman" pitchFamily="18" charset="0"/>
              </a:rPr>
              <a:t>36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テキスト ボックス 11"/>
          <p:cNvSpPr txBox="1">
            <a:spLocks noChangeArrowheads="1"/>
          </p:cNvSpPr>
          <p:nvPr/>
        </p:nvSpPr>
        <p:spPr bwMode="auto">
          <a:xfrm>
            <a:off x="1681258" y="5131417"/>
            <a:ext cx="3000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0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テキスト ボックス 10"/>
          <p:cNvSpPr txBox="1">
            <a:spLocks noChangeArrowheads="1"/>
          </p:cNvSpPr>
          <p:nvPr/>
        </p:nvSpPr>
        <p:spPr bwMode="auto">
          <a:xfrm>
            <a:off x="1567501" y="4219576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20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テキスト ボックス 9"/>
          <p:cNvSpPr txBox="1">
            <a:spLocks noChangeArrowheads="1"/>
          </p:cNvSpPr>
          <p:nvPr/>
        </p:nvSpPr>
        <p:spPr bwMode="auto">
          <a:xfrm>
            <a:off x="1568693" y="3326194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40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テキスト ボックス 8"/>
          <p:cNvSpPr txBox="1">
            <a:spLocks noChangeArrowheads="1"/>
          </p:cNvSpPr>
          <p:nvPr/>
        </p:nvSpPr>
        <p:spPr bwMode="auto">
          <a:xfrm>
            <a:off x="1574332" y="2419108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60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テキスト ボックス 7"/>
          <p:cNvSpPr txBox="1">
            <a:spLocks noChangeArrowheads="1"/>
          </p:cNvSpPr>
          <p:nvPr/>
        </p:nvSpPr>
        <p:spPr bwMode="auto">
          <a:xfrm>
            <a:off x="1565840" y="1522296"/>
            <a:ext cx="41549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80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テキスト ボックス 6"/>
          <p:cNvSpPr txBox="1">
            <a:spLocks noChangeArrowheads="1"/>
          </p:cNvSpPr>
          <p:nvPr/>
        </p:nvSpPr>
        <p:spPr bwMode="auto">
          <a:xfrm>
            <a:off x="1458917" y="625484"/>
            <a:ext cx="53091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100</a:t>
            </a:r>
            <a:endParaRPr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0" y="235738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ression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e survival in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L1 high cohort (N=143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-54430" y="5968110"/>
            <a:ext cx="17144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itchFamily="18" charset="0"/>
                <a:cs typeface="Times New Roman" pitchFamily="18" charset="0"/>
              </a:rPr>
              <a:t>Number at risk</a:t>
            </a:r>
            <a:endParaRPr kumimoji="1" lang="ja-JP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2918209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20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40</a:t>
            </a: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2907935" y="5373216"/>
            <a:ext cx="593276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b="1" dirty="0">
                <a:latin typeface="Times New Roman" pitchFamily="18" charset="0"/>
                <a:cs typeface="Times New Roman" pitchFamily="18" charset="0"/>
              </a:rPr>
              <a:t>6</a:t>
            </a:r>
            <a:endParaRPr kumimoji="1" lang="ja-JP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4052509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10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23</a:t>
            </a: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5148174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5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18</a:t>
            </a: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6250491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0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12</a:t>
            </a: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7391383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0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8</a:t>
            </a: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8507880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0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6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E10074C8-9A6C-44D2-B375-7758BE6319F6}"/>
              </a:ext>
            </a:extLst>
          </p:cNvPr>
          <p:cNvSpPr txBox="1"/>
          <p:nvPr/>
        </p:nvSpPr>
        <p:spPr>
          <a:xfrm>
            <a:off x="1798728" y="6224487"/>
            <a:ext cx="5715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 37</a:t>
            </a:r>
          </a:p>
          <a:p>
            <a:pPr algn="ct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106</a:t>
            </a:r>
          </a:p>
        </p:txBody>
      </p: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1FB50F88-B6D0-4B32-83D0-D60F6E12E6F7}"/>
              </a:ext>
            </a:extLst>
          </p:cNvPr>
          <p:cNvSpPr/>
          <p:nvPr/>
        </p:nvSpPr>
        <p:spPr>
          <a:xfrm>
            <a:off x="-54430" y="6224487"/>
            <a:ext cx="2017684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ICI/Chemo</a:t>
            </a:r>
          </a:p>
          <a:p>
            <a:pPr algn="r"/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Pembrolizumab</a:t>
            </a:r>
          </a:p>
        </p:txBody>
      </p: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EAF5553A-ED76-47DE-B321-5506EC8AE13B}"/>
              </a:ext>
            </a:extLst>
          </p:cNvPr>
          <p:cNvGrpSpPr/>
          <p:nvPr/>
        </p:nvGrpSpPr>
        <p:grpSpPr>
          <a:xfrm>
            <a:off x="3807744" y="908720"/>
            <a:ext cx="4939432" cy="584775"/>
            <a:chOff x="6207859" y="831019"/>
            <a:chExt cx="3980764" cy="584775"/>
          </a:xfrm>
        </p:grpSpPr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29F2463A-75AA-48A3-A5BF-2C3594115A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14972" y="831019"/>
              <a:ext cx="3673651" cy="584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altLang="ja-JP" sz="1600" b="1" dirty="0">
                  <a:latin typeface="Times New Roman" panose="02020603050405020304" pitchFamily="18" charset="0"/>
                  <a:cs typeface="Times New Roman" pitchFamily="18" charset="0"/>
                </a:rPr>
                <a:t>ICI/Chemo group (N=37); PFS = 11.1 months</a:t>
              </a:r>
            </a:p>
            <a:p>
              <a:r>
                <a:rPr lang="en-US" altLang="ja-JP" sz="1600" b="1" dirty="0">
                  <a:latin typeface="Times New Roman" panose="02020603050405020304" pitchFamily="18" charset="0"/>
                  <a:cs typeface="Times New Roman" pitchFamily="18" charset="0"/>
                </a:rPr>
                <a:t>Pembrolizumab group (N=106); PFS = 3.1 months</a:t>
              </a:r>
            </a:p>
          </p:txBody>
        </p: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8B1EAB94-E1B5-443F-B7F8-73D457E2E4D5}"/>
                </a:ext>
              </a:extLst>
            </p:cNvPr>
            <p:cNvCxnSpPr/>
            <p:nvPr/>
          </p:nvCxnSpPr>
          <p:spPr bwMode="auto">
            <a:xfrm rot="10800000">
              <a:off x="6207859" y="1010662"/>
              <a:ext cx="286254" cy="0"/>
            </a:xfrm>
            <a:prstGeom prst="line">
              <a:avLst/>
            </a:prstGeom>
            <a:ln w="317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EC0740AC-32B0-4A4F-BBFE-BD3CACDE0263}"/>
                </a:ext>
              </a:extLst>
            </p:cNvPr>
            <p:cNvCxnSpPr/>
            <p:nvPr/>
          </p:nvCxnSpPr>
          <p:spPr bwMode="auto">
            <a:xfrm rot="10800000">
              <a:off x="6207859" y="1258996"/>
              <a:ext cx="286254" cy="0"/>
            </a:xfrm>
            <a:prstGeom prst="line">
              <a:avLst/>
            </a:prstGeom>
            <a:ln w="31750" cmpd="sng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9" name="テキスト ボックス 15">
            <a:extLst>
              <a:ext uri="{FF2B5EF4-FFF2-40B4-BE49-F238E27FC236}">
                <a16:creationId xmlns:a16="http://schemas.microsoft.com/office/drawing/2014/main" id="{1B721CC6-56D4-4BD4-9D1B-18C0972D8A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58758" y="4844827"/>
            <a:ext cx="1347948" cy="41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108009" tIns="54004" rIns="108009" bIns="54004">
            <a:spAutoFit/>
          </a:bodyPr>
          <a:lstStyle/>
          <a:p>
            <a:pPr eaLnBrk="1" hangingPunct="1"/>
            <a:r>
              <a:rPr lang="en-US" altLang="ja-JP" sz="2000" b="1" dirty="0">
                <a:latin typeface="Times New Roman" pitchFamily="18" charset="0"/>
                <a:cs typeface="Times New Roman" pitchFamily="18" charset="0"/>
              </a:rPr>
              <a:t>P = 0.0049</a:t>
            </a:r>
            <a:endParaRPr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42565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55</TotalTime>
  <Words>85</Words>
  <Application>Microsoft Office PowerPoint</Application>
  <PresentationFormat>画面に合わせる (4:3)</PresentationFormat>
  <Paragraphs>3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daichi</dc:creator>
  <cp:lastModifiedBy>hayato kawachi</cp:lastModifiedBy>
  <cp:revision>114</cp:revision>
  <dcterms:created xsi:type="dcterms:W3CDTF">2014-03-25T07:38:37Z</dcterms:created>
  <dcterms:modified xsi:type="dcterms:W3CDTF">2022-05-30T13:11:08Z</dcterms:modified>
</cp:coreProperties>
</file>